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1" d="100"/>
          <a:sy n="151" d="100"/>
        </p:scale>
        <p:origin x="654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C1BD3705-653B-4DD1-94D0-B1412E4052A7}"/>
    <pc:docChg chg="undo custSel addSld modSld">
      <pc:chgData name="Tekle Pauzaite" userId="06f7e524-8501-4f81-9b2a-484f6f2c7061" providerId="ADAL" clId="{C1BD3705-653B-4DD1-94D0-B1412E4052A7}" dt="2024-04-22T09:51:35.514" v="517" actId="732"/>
      <pc:docMkLst>
        <pc:docMk/>
      </pc:docMkLst>
      <pc:sldChg chg="addSp delSp modSp add">
        <pc:chgData name="Tekle Pauzaite" userId="06f7e524-8501-4f81-9b2a-484f6f2c7061" providerId="ADAL" clId="{C1BD3705-653B-4DD1-94D0-B1412E4052A7}" dt="2024-04-22T06:38:20.696" v="308" actId="478"/>
        <pc:sldMkLst>
          <pc:docMk/>
          <pc:sldMk cId="1375384799" sldId="256"/>
        </pc:sldMkLst>
        <pc:spChg chg="del">
          <ac:chgData name="Tekle Pauzaite" userId="06f7e524-8501-4f81-9b2a-484f6f2c7061" providerId="ADAL" clId="{C1BD3705-653B-4DD1-94D0-B1412E4052A7}" dt="2024-03-26T10:59:36.985" v="1"/>
          <ac:spMkLst>
            <pc:docMk/>
            <pc:sldMk cId="1375384799" sldId="256"/>
            <ac:spMk id="2" creationId="{84ADFD55-62F6-49D9-BE7A-D0ABF64F3958}"/>
          </ac:spMkLst>
        </pc:spChg>
        <pc:spChg chg="del">
          <ac:chgData name="Tekle Pauzaite" userId="06f7e524-8501-4f81-9b2a-484f6f2c7061" providerId="ADAL" clId="{C1BD3705-653B-4DD1-94D0-B1412E4052A7}" dt="2024-03-26T10:59:36.985" v="1"/>
          <ac:spMkLst>
            <pc:docMk/>
            <pc:sldMk cId="1375384799" sldId="256"/>
            <ac:spMk id="3" creationId="{B995848E-97C4-4264-9A89-EC80E623A471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4" creationId="{4FE39157-93AD-4BFB-9632-5D917BC19DFB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5" creationId="{862428B3-3918-4D0C-8C4B-AE625E290D80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6" creationId="{B61107B6-D617-4B76-A89C-ED734A4690EB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7" creationId="{D19214BE-302F-4B83-A0A8-7D9D24F597AB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13" creationId="{E6CD7CA9-BD26-46CF-A39C-DFE751822080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14" creationId="{631EB6E1-9749-4188-8C98-011A91E57063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15" creationId="{00D8E106-7B96-4758-BF9E-C141182A9A86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16" creationId="{B0CE6290-8E02-4780-B683-F994C1567386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17" creationId="{88C761B1-9400-4DD5-8283-4DE8182535EA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18" creationId="{A5FED2B1-B73E-4E84-86A3-6333E791E904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19" creationId="{6D96D7D5-8A0F-4136-B9AE-E30C0BABABDB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0" creationId="{845F8399-2286-43AF-A63B-C60BC8B05FF0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1" creationId="{96E0C9EB-8356-48F2-BA99-200CC8A4B38C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2" creationId="{0060370F-2A63-489A-A9AD-1459BEB6B8C1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3" creationId="{4157AA59-4D9D-4EDF-BCEC-5B1CC3DEE2C3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4" creationId="{FA72A3F2-1432-4D4A-9CED-45F5CAEE78FF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5" creationId="{8C152B8D-F11A-42A1-86F2-617C1A29C69F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6" creationId="{B9359109-23D4-4F2F-A78E-A0581DB8C91C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7" creationId="{8FCAF62C-942B-4FAB-BF31-455DAD53A3E3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8" creationId="{4027B1E7-6254-4F85-BD63-BA69B83F74B4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29" creationId="{A35DB014-318A-497C-A3C9-B05D1517B614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30" creationId="{1F81306B-867D-4A63-9C0F-7246E95921BE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31" creationId="{975F89C1-82DB-44A3-9066-73D275EDC0CB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32" creationId="{24CBF96F-BC2F-43FF-A92F-15775F7A906B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42" creationId="{85E60937-EB6B-4ABF-AB26-CA6439121A5C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44" creationId="{4AC9A2F0-F617-48BE-BD3B-06F594DB10A9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45" creationId="{34DFAAFD-9030-4B71-ACC2-734B600195CE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46" creationId="{DFEA812F-9FD4-4F69-B924-212DEBFAF040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47" creationId="{53553BD8-D167-4672-B56E-26F4CAC43C3C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48" creationId="{CE8BEC3A-C3CE-44CE-BF0E-B34E3355C7FF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49" creationId="{42A980F3-135E-4373-BB23-EACD117F550F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50" creationId="{12944DB5-E838-4A30-8346-82CF34C8F785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51" creationId="{22E61C65-F02C-44BF-9313-1BBC327A1DA3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52" creationId="{22DAC5E7-050C-4AAE-9134-280115D204C7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53" creationId="{DFE65270-2754-44F9-B122-40DB9AA966BB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54" creationId="{C45A82DB-3352-4173-915D-E0D2708C0C52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55" creationId="{51F1C127-CF62-4E65-A16B-7C7CA2B31B39}"/>
          </ac:spMkLst>
        </pc:spChg>
        <pc:spChg chg="add del">
          <ac:chgData name="Tekle Pauzaite" userId="06f7e524-8501-4f81-9b2a-484f6f2c7061" providerId="ADAL" clId="{C1BD3705-653B-4DD1-94D0-B1412E4052A7}" dt="2024-03-26T11:16:10.282" v="197" actId="478"/>
          <ac:spMkLst>
            <pc:docMk/>
            <pc:sldMk cId="1375384799" sldId="256"/>
            <ac:spMk id="56" creationId="{E18A2367-B571-45A3-BF2C-0674B317989C}"/>
          </ac:spMkLst>
        </pc:spChg>
        <pc:spChg chg="add mod">
          <ac:chgData name="Tekle Pauzaite" userId="06f7e524-8501-4f81-9b2a-484f6f2c7061" providerId="ADAL" clId="{C1BD3705-653B-4DD1-94D0-B1412E4052A7}" dt="2024-03-26T11:07:20.782" v="39" actId="208"/>
          <ac:spMkLst>
            <pc:docMk/>
            <pc:sldMk cId="1375384799" sldId="256"/>
            <ac:spMk id="67" creationId="{43AB1CD9-47AE-406B-9296-30552DA49F66}"/>
          </ac:spMkLst>
        </pc:spChg>
        <pc:spChg chg="add mod">
          <ac:chgData name="Tekle Pauzaite" userId="06f7e524-8501-4f81-9b2a-484f6f2c7061" providerId="ADAL" clId="{C1BD3705-653B-4DD1-94D0-B1412E4052A7}" dt="2024-03-26T11:07:28.118" v="40" actId="571"/>
          <ac:spMkLst>
            <pc:docMk/>
            <pc:sldMk cId="1375384799" sldId="256"/>
            <ac:spMk id="68" creationId="{DCA13644-3E23-4768-89C7-09F87D3F4986}"/>
          </ac:spMkLst>
        </pc:spChg>
        <pc:spChg chg="add mod">
          <ac:chgData name="Tekle Pauzaite" userId="06f7e524-8501-4f81-9b2a-484f6f2c7061" providerId="ADAL" clId="{C1BD3705-653B-4DD1-94D0-B1412E4052A7}" dt="2024-03-26T11:08:02.001" v="57" actId="1076"/>
          <ac:spMkLst>
            <pc:docMk/>
            <pc:sldMk cId="1375384799" sldId="256"/>
            <ac:spMk id="70" creationId="{FB92D656-8CCD-4014-A8F1-10C651816933}"/>
          </ac:spMkLst>
        </pc:spChg>
        <pc:spChg chg="add mod">
          <ac:chgData name="Tekle Pauzaite" userId="06f7e524-8501-4f81-9b2a-484f6f2c7061" providerId="ADAL" clId="{C1BD3705-653B-4DD1-94D0-B1412E4052A7}" dt="2024-03-26T11:08:21.392" v="61" actId="571"/>
          <ac:spMkLst>
            <pc:docMk/>
            <pc:sldMk cId="1375384799" sldId="256"/>
            <ac:spMk id="72" creationId="{D8E43299-7568-475B-A111-78DD6D01AB82}"/>
          </ac:spMkLst>
        </pc:spChg>
        <pc:spChg chg="add mod">
          <ac:chgData name="Tekle Pauzaite" userId="06f7e524-8501-4f81-9b2a-484f6f2c7061" providerId="ADAL" clId="{C1BD3705-653B-4DD1-94D0-B1412E4052A7}" dt="2024-03-26T11:09:00.816" v="78" actId="1076"/>
          <ac:spMkLst>
            <pc:docMk/>
            <pc:sldMk cId="1375384799" sldId="256"/>
            <ac:spMk id="74" creationId="{4FC4C0B5-8EFD-40E6-AF02-1118C0A3A7DB}"/>
          </ac:spMkLst>
        </pc:spChg>
        <pc:spChg chg="add mod">
          <ac:chgData name="Tekle Pauzaite" userId="06f7e524-8501-4f81-9b2a-484f6f2c7061" providerId="ADAL" clId="{C1BD3705-653B-4DD1-94D0-B1412E4052A7}" dt="2024-03-26T11:09:23.257" v="79" actId="571"/>
          <ac:spMkLst>
            <pc:docMk/>
            <pc:sldMk cId="1375384799" sldId="256"/>
            <ac:spMk id="75" creationId="{04DB523B-7A8B-4AD2-A949-1A3E5ADF84E1}"/>
          </ac:spMkLst>
        </pc:spChg>
        <pc:spChg chg="add mod">
          <ac:chgData name="Tekle Pauzaite" userId="06f7e524-8501-4f81-9b2a-484f6f2c7061" providerId="ADAL" clId="{C1BD3705-653B-4DD1-94D0-B1412E4052A7}" dt="2024-03-26T11:09:27.960" v="80" actId="571"/>
          <ac:spMkLst>
            <pc:docMk/>
            <pc:sldMk cId="1375384799" sldId="256"/>
            <ac:spMk id="76" creationId="{148BE3CF-3752-4A9C-AB4A-1241ED38CDB8}"/>
          </ac:spMkLst>
        </pc:spChg>
        <pc:spChg chg="add mod">
          <ac:chgData name="Tekle Pauzaite" userId="06f7e524-8501-4f81-9b2a-484f6f2c7061" providerId="ADAL" clId="{C1BD3705-653B-4DD1-94D0-B1412E4052A7}" dt="2024-03-26T11:09:32.216" v="81" actId="571"/>
          <ac:spMkLst>
            <pc:docMk/>
            <pc:sldMk cId="1375384799" sldId="256"/>
            <ac:spMk id="77" creationId="{867F461A-7BE9-4205-968E-F92E1A0DB39A}"/>
          </ac:spMkLst>
        </pc:spChg>
        <pc:spChg chg="add mod">
          <ac:chgData name="Tekle Pauzaite" userId="06f7e524-8501-4f81-9b2a-484f6f2c7061" providerId="ADAL" clId="{C1BD3705-653B-4DD1-94D0-B1412E4052A7}" dt="2024-03-26T11:09:36.729" v="82" actId="571"/>
          <ac:spMkLst>
            <pc:docMk/>
            <pc:sldMk cId="1375384799" sldId="256"/>
            <ac:spMk id="78" creationId="{0A3AFFA3-0539-4720-89AA-1B40AA95C3D0}"/>
          </ac:spMkLst>
        </pc:spChg>
        <pc:spChg chg="add mod">
          <ac:chgData name="Tekle Pauzaite" userId="06f7e524-8501-4f81-9b2a-484f6f2c7061" providerId="ADAL" clId="{C1BD3705-653B-4DD1-94D0-B1412E4052A7}" dt="2024-03-26T11:09:40.569" v="83" actId="571"/>
          <ac:spMkLst>
            <pc:docMk/>
            <pc:sldMk cId="1375384799" sldId="256"/>
            <ac:spMk id="79" creationId="{B92D58A7-523F-4AEB-BF38-A6EA4F94595C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80" creationId="{F2284F21-8181-4B5E-AC5B-FAAFF701445E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81" creationId="{B1DB9727-9594-43BF-82C8-9109C6D5854D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82" creationId="{0971B044-12C4-45C2-BC96-35C861E63646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83" creationId="{23A419FF-C2EF-4A10-93DA-A83E7FB1033C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89" creationId="{74B30BED-8DEF-4027-BD1F-8BA3B19092AF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0" creationId="{37B6963D-D480-4753-8F6D-C5BCA14206B4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1" creationId="{78719130-08F2-4C5D-9134-9D10CC5846FD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2" creationId="{E7B15725-70BF-4CC6-918E-6CB17EF636A4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3" creationId="{8200F617-545E-4C3D-A944-F18E96072FBE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4" creationId="{9519CD8A-92FA-4608-86DD-F04E7A8866A2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5" creationId="{A56FA746-F330-4C88-98D4-D7B6D6D3EEA5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6" creationId="{E63526C9-E33A-4DC7-8882-D18844163E43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7" creationId="{038ADDE0-C1AC-4330-BD4D-D85ACFAE72D5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8" creationId="{BCBFA29A-7CE1-4542-84B9-93F3FA109A2F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99" creationId="{51AA4F94-D9BC-43C3-97A5-983173B3F7EC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0" creationId="{CF9194F0-E11C-466B-AE36-8F4210FB26BA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1" creationId="{214697D7-D3D0-48C6-BB15-ADBF438832E7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2" creationId="{D44E0C68-C7CC-47CA-8B7B-13184A052F13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3" creationId="{B5752894-B9E4-4B5A-826F-2EA21D5BD03F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4" creationId="{B21B6B74-A8DB-4C5F-A99C-2823852E6345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5" creationId="{0FF9B9E3-6DAC-4798-AD0B-ABA57466381A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6" creationId="{51AEBD9F-D71E-43EA-BF46-183C33A6A537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7" creationId="{4408689B-1BC2-4981-8144-CE5F761B5C34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08" creationId="{772A484A-E5DD-4501-96C0-8EC92D9CC33D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17" creationId="{91621CCB-5F10-44F7-BA19-021365E466FE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19" creationId="{B0902AC5-7998-4AB5-8B05-E88E3995501C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0" creationId="{5D3B9CCD-4DC8-4CA4-B30C-09617D00BA89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1" creationId="{4947F567-95CF-4166-9800-66433DF39286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2" creationId="{38888D1F-E954-46C7-8EEE-61E393D825D9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3" creationId="{47774DC3-B3CC-4C10-BCE2-38F119881599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4" creationId="{B0B3B0C6-8D17-43C9-8370-39646FBB183A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5" creationId="{FFD700A1-636D-4009-8D22-EF347B7F59DF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6" creationId="{97E0ED9F-CC77-4465-9616-4DB655A7832D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7" creationId="{B81C9F85-3ECC-4D21-8CEE-3F9E595622C1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8" creationId="{231F6167-C567-4702-8BEF-AE7B0B154889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29" creationId="{69E38FC3-0D38-4E94-9104-88F72ADF999F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30" creationId="{EBD8D22C-70CF-4DA0-99EE-9B7E8D53C5BB}"/>
          </ac:spMkLst>
        </pc:spChg>
        <pc:spChg chg="add del">
          <ac:chgData name="Tekle Pauzaite" userId="06f7e524-8501-4f81-9b2a-484f6f2c7061" providerId="ADAL" clId="{C1BD3705-653B-4DD1-94D0-B1412E4052A7}" dt="2024-04-09T07:32:03.042" v="280" actId="478"/>
          <ac:spMkLst>
            <pc:docMk/>
            <pc:sldMk cId="1375384799" sldId="256"/>
            <ac:spMk id="131" creationId="{945EBD40-7047-47D3-82A3-E25870BB8FA8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40" creationId="{C4ADFC7D-2834-4919-8260-A7EF34C6FF79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41" creationId="{AC141A5E-0F5B-4F40-91E1-0D949DB398F5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42" creationId="{B95CB1CF-426B-4CC6-BE8B-6460ABC49E05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43" creationId="{5E103DD3-A1C7-454C-BB57-AEF57C9F79B6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49" creationId="{072AAA76-62E2-4EB9-9ABD-9C28617CA084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0" creationId="{B3B503EE-041D-49CB-97B6-8ACD6219B9DC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1" creationId="{3DF1347E-7E27-4C14-B9CA-7D055BB251E8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2" creationId="{7364229A-AA1F-4F0E-B950-A61F27989FD0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3" creationId="{B088E73D-0F45-4D0D-AD40-3B508427B1D4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4" creationId="{C48F73BA-359F-443A-B3EB-295E588E77E4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5" creationId="{E424114B-E789-42CB-A36A-EC383EC5CDA3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6" creationId="{1C1151EB-9E03-4989-99E5-660AA4D610F5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7" creationId="{DBCAFC74-0CF8-4824-A9DC-9B290F53B99D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8" creationId="{EFD2B93F-55C6-4088-992B-82E52992AD1A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59" creationId="{2C8F7047-3D19-438E-B42E-BB7BECED2BD7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0" creationId="{16DA10C0-1206-4A23-A095-121DAAED0F1D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1" creationId="{A66BFC8A-E196-4611-9855-5178D0282AD8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2" creationId="{66B5711E-FCD3-4E1D-85C4-B8C43330A1FB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3" creationId="{12BDC93C-4D03-4CB8-9AEA-5FC03A01CE5D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4" creationId="{894859D8-0C57-43CF-B2A5-063707D87699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5" creationId="{F283B7C9-330F-4DEC-A710-636C9A16BACA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6" creationId="{AC044788-12FE-4D58-9CA8-7A911EBB6C93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7" creationId="{BD8157EB-F132-494F-AC60-96C26240842A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68" creationId="{6A210BC2-B499-47C7-87FF-7773C1E9ADA4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78" creationId="{21DCE798-4250-4978-B36C-B7B8C92A45E9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79" creationId="{B3176A0D-516F-4308-8936-C5AAE1DFA0B4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0" creationId="{1E720490-7BDE-499A-82E5-95A4F420508D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1" creationId="{822620AD-66C6-486C-B6ED-588A72317CC7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2" creationId="{6B56E0F3-4A2F-40DA-A36F-17DCCC1E864D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3" creationId="{190ABE5B-FAD4-4CAD-B18B-79A286A1863B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4" creationId="{5717EC86-1D6F-4DBD-92C2-92DCF45166D4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5" creationId="{EEDE3C41-CAEC-4716-843D-7556D0084BF5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6" creationId="{C14753A9-B7C8-4EE1-BCEF-9C8DD07586B9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7" creationId="{D98AA011-0EA7-4E7E-A04B-610F3B9E6BF5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8" creationId="{AE44D6F2-136E-4DA5-9E33-CF29339E4F88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89" creationId="{F56E8496-F68B-41D2-984D-08457401C32F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90" creationId="{6D3A7714-2ECB-4BEB-B1D9-51854DD23BB8}"/>
          </ac:spMkLst>
        </pc:spChg>
        <pc:spChg chg="add">
          <ac:chgData name="Tekle Pauzaite" userId="06f7e524-8501-4f81-9b2a-484f6f2c7061" providerId="ADAL" clId="{C1BD3705-653B-4DD1-94D0-B1412E4052A7}" dt="2024-04-09T07:32:03.468" v="281"/>
          <ac:spMkLst>
            <pc:docMk/>
            <pc:sldMk cId="1375384799" sldId="256"/>
            <ac:spMk id="191" creationId="{398EF5AF-3E11-48F2-B25F-F5EEAFB83C4D}"/>
          </ac:spMkLst>
        </pc:sp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8" creationId="{AB4FDE51-F7E7-4EDD-91FD-1D2791BF6393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9" creationId="{AE4E7FB0-6E55-47F9-B264-B8EAEAD3F0E6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10" creationId="{728D9F89-0CAC-4317-A29C-41782711E32F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11" creationId="{1B8A225A-6483-4281-B0DA-F61FE5C546C3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12" creationId="{F5B83069-6922-4365-B16F-13BFBB288EEC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33" creationId="{83E23389-B61C-496F-A4E3-6DF7E0399B89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34" creationId="{FCB7E82E-9F4E-467E-89B4-1999772AB50D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35" creationId="{87726BC1-D01F-464B-BA98-9CE18AD562D6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36" creationId="{60C63B6B-09E6-4D40-9A36-CEDDA13A979A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37" creationId="{1D5FDF56-7776-48BB-B19C-492B3BB0E3A0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38" creationId="{B2321D2D-B2BD-479D-A074-DF9966E56F8F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39" creationId="{CFDA19C3-B96C-4CA9-9F77-629B08A097DF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40" creationId="{A6D60007-AC2D-4AB6-9135-7798ECD6C2EC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41" creationId="{4C755C9E-F23F-4970-B250-07621B7DC000}"/>
          </ac:picMkLst>
        </pc:picChg>
        <pc:picChg chg="add del">
          <ac:chgData name="Tekle Pauzaite" userId="06f7e524-8501-4f81-9b2a-484f6f2c7061" providerId="ADAL" clId="{C1BD3705-653B-4DD1-94D0-B1412E4052A7}" dt="2024-03-26T11:16:10.282" v="197" actId="478"/>
          <ac:picMkLst>
            <pc:docMk/>
            <pc:sldMk cId="1375384799" sldId="256"/>
            <ac:picMk id="43" creationId="{F8B30ED1-9C43-4DEC-ACF5-DC8E9112281E}"/>
          </ac:picMkLst>
        </pc:picChg>
        <pc:picChg chg="add mod modCrop">
          <ac:chgData name="Tekle Pauzaite" userId="06f7e524-8501-4f81-9b2a-484f6f2c7061" providerId="ADAL" clId="{C1BD3705-653B-4DD1-94D0-B1412E4052A7}" dt="2024-03-26T11:03:54.795" v="21" actId="1076"/>
          <ac:picMkLst>
            <pc:docMk/>
            <pc:sldMk cId="1375384799" sldId="256"/>
            <ac:picMk id="65" creationId="{EC63A3DE-C896-49EE-81C5-6AB8F2CE4607}"/>
          </ac:picMkLst>
        </pc:picChg>
        <pc:picChg chg="add mod modCrop">
          <ac:chgData name="Tekle Pauzaite" userId="06f7e524-8501-4f81-9b2a-484f6f2c7061" providerId="ADAL" clId="{C1BD3705-653B-4DD1-94D0-B1412E4052A7}" dt="2024-03-26T11:07:01.808" v="36" actId="1076"/>
          <ac:picMkLst>
            <pc:docMk/>
            <pc:sldMk cId="1375384799" sldId="256"/>
            <ac:picMk id="66" creationId="{82069B33-5FD7-4644-93B2-0D3D394C034A}"/>
          </ac:picMkLst>
        </pc:picChg>
        <pc:picChg chg="add mod modCrop">
          <ac:chgData name="Tekle Pauzaite" userId="06f7e524-8501-4f81-9b2a-484f6f2c7061" providerId="ADAL" clId="{C1BD3705-653B-4DD1-94D0-B1412E4052A7}" dt="2024-03-26T11:07:52.184" v="55" actId="1076"/>
          <ac:picMkLst>
            <pc:docMk/>
            <pc:sldMk cId="1375384799" sldId="256"/>
            <ac:picMk id="69" creationId="{774840D7-AAE6-4DFC-B0A6-17A8D0C80484}"/>
          </ac:picMkLst>
        </pc:picChg>
        <pc:picChg chg="add del mod modCrop">
          <ac:chgData name="Tekle Pauzaite" userId="06f7e524-8501-4f81-9b2a-484f6f2c7061" providerId="ADAL" clId="{C1BD3705-653B-4DD1-94D0-B1412E4052A7}" dt="2024-03-26T11:08:14.704" v="60" actId="478"/>
          <ac:picMkLst>
            <pc:docMk/>
            <pc:sldMk cId="1375384799" sldId="256"/>
            <ac:picMk id="71" creationId="{140D27B8-96B1-4060-A714-B7DD731BC081}"/>
          </ac:picMkLst>
        </pc:picChg>
        <pc:picChg chg="add mod modCrop">
          <ac:chgData name="Tekle Pauzaite" userId="06f7e524-8501-4f81-9b2a-484f6f2c7061" providerId="ADAL" clId="{C1BD3705-653B-4DD1-94D0-B1412E4052A7}" dt="2024-03-26T11:08:50.560" v="76" actId="1076"/>
          <ac:picMkLst>
            <pc:docMk/>
            <pc:sldMk cId="1375384799" sldId="256"/>
            <ac:picMk id="73" creationId="{B56A10EC-BEB9-4B16-8628-2FCC15A68959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84" creationId="{C6A56134-EDD1-4A61-A735-26EB2F82F961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85" creationId="{796A0121-4A00-4757-9E00-87218F087B71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86" creationId="{A2A09236-248A-4257-BF10-59FB0B4B34CD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87" creationId="{FF1DAD86-FC22-425D-8C07-A10F9A271146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88" creationId="{6077DE37-BFD3-42D8-BA29-477C938D17BD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09" creationId="{EC3ED8A9-392A-4FF6-B2B8-175055C1BCBA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10" creationId="{13A1EA08-647E-4C65-9366-7A0BA12742A0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11" creationId="{0EF0EBB4-5274-4177-B73E-BCC754C31C23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12" creationId="{3B7C8654-B040-4178-9344-25EE34612602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13" creationId="{E508CDAF-8E95-46DD-9B89-5A037160BA76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14" creationId="{3365CFE3-9AE5-481A-986E-5FE9471E3494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15" creationId="{BA5BE294-F764-41B0-A61C-536B21552EFC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16" creationId="{FABB0504-0881-4E68-8F37-4E5B8A7BD40F}"/>
          </ac:picMkLst>
        </pc:picChg>
        <pc:picChg chg="add del">
          <ac:chgData name="Tekle Pauzaite" userId="06f7e524-8501-4f81-9b2a-484f6f2c7061" providerId="ADAL" clId="{C1BD3705-653B-4DD1-94D0-B1412E4052A7}" dt="2024-04-09T07:32:03.042" v="280" actId="478"/>
          <ac:picMkLst>
            <pc:docMk/>
            <pc:sldMk cId="1375384799" sldId="256"/>
            <ac:picMk id="118" creationId="{5CD68A6F-5E71-44D4-ADC9-99442B29729C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44" creationId="{888DB642-57D0-404E-BAE1-259956297B7E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45" creationId="{D3AC7F2C-4AB5-45C1-84B0-120F4920DE6F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46" creationId="{A28376B7-F34B-4031-AE95-93F0CB63C25C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47" creationId="{4F0DB584-6BC1-40AF-BDE6-E97C18AE9E1D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48" creationId="{6CB85BC2-F8A3-41DA-9E7F-F6D55E2DFD4D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69" creationId="{9B487CDC-9BA4-49D7-9F91-C086E4966378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70" creationId="{898F7230-E3D6-4A2B-BDC9-051F1CB34608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71" creationId="{09B56CE7-5DEF-4DC5-82F8-C39B77EA41A3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72" creationId="{9DB47E35-93D2-44B9-8779-3623434200F8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73" creationId="{AF10C6A0-10D3-4D20-8805-16FB519E9E76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74" creationId="{2B798099-C71E-4B1C-B1D1-AC5FA1D2F32B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75" creationId="{649ED578-400D-4FC9-9F24-E833AD7BE630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176" creationId="{12FCE359-EEB4-419C-9FE4-D91BE9331025}"/>
          </ac:picMkLst>
        </pc:picChg>
        <pc:picChg chg="add del">
          <ac:chgData name="Tekle Pauzaite" userId="06f7e524-8501-4f81-9b2a-484f6f2c7061" providerId="ADAL" clId="{C1BD3705-653B-4DD1-94D0-B1412E4052A7}" dt="2024-04-22T06:38:20.696" v="308" actId="478"/>
          <ac:picMkLst>
            <pc:docMk/>
            <pc:sldMk cId="1375384799" sldId="256"/>
            <ac:picMk id="177" creationId="{8164C2B2-E90D-4A86-92EC-1C50798F5849}"/>
          </ac:picMkLst>
        </pc:picChg>
        <pc:picChg chg="add">
          <ac:chgData name="Tekle Pauzaite" userId="06f7e524-8501-4f81-9b2a-484f6f2c7061" providerId="ADAL" clId="{C1BD3705-653B-4DD1-94D0-B1412E4052A7}" dt="2024-04-09T07:32:03.468" v="281"/>
          <ac:picMkLst>
            <pc:docMk/>
            <pc:sldMk cId="1375384799" sldId="256"/>
            <ac:picMk id="200" creationId="{B54F7F15-8FD4-4167-9C9D-E0FA305845FB}"/>
          </ac:picMkLst>
        </pc:picChg>
        <pc:cxnChg chg="add del">
          <ac:chgData name="Tekle Pauzaite" userId="06f7e524-8501-4f81-9b2a-484f6f2c7061" providerId="ADAL" clId="{C1BD3705-653B-4DD1-94D0-B1412E4052A7}" dt="2024-03-26T11:16:10.282" v="197" actId="478"/>
          <ac:cxnSpMkLst>
            <pc:docMk/>
            <pc:sldMk cId="1375384799" sldId="256"/>
            <ac:cxnSpMk id="57" creationId="{3B1CA303-EB2D-447B-AE2B-A0BC6A4D9B94}"/>
          </ac:cxnSpMkLst>
        </pc:cxnChg>
        <pc:cxnChg chg="add del">
          <ac:chgData name="Tekle Pauzaite" userId="06f7e524-8501-4f81-9b2a-484f6f2c7061" providerId="ADAL" clId="{C1BD3705-653B-4DD1-94D0-B1412E4052A7}" dt="2024-03-26T11:16:10.282" v="197" actId="478"/>
          <ac:cxnSpMkLst>
            <pc:docMk/>
            <pc:sldMk cId="1375384799" sldId="256"/>
            <ac:cxnSpMk id="58" creationId="{E2CC7268-811B-4577-8C35-74756F0A8522}"/>
          </ac:cxnSpMkLst>
        </pc:cxnChg>
        <pc:cxnChg chg="add del">
          <ac:chgData name="Tekle Pauzaite" userId="06f7e524-8501-4f81-9b2a-484f6f2c7061" providerId="ADAL" clId="{C1BD3705-653B-4DD1-94D0-B1412E4052A7}" dt="2024-03-26T11:16:10.282" v="197" actId="478"/>
          <ac:cxnSpMkLst>
            <pc:docMk/>
            <pc:sldMk cId="1375384799" sldId="256"/>
            <ac:cxnSpMk id="59" creationId="{759F8BB0-9E4D-49A4-8773-A30078B5D778}"/>
          </ac:cxnSpMkLst>
        </pc:cxnChg>
        <pc:cxnChg chg="add del">
          <ac:chgData name="Tekle Pauzaite" userId="06f7e524-8501-4f81-9b2a-484f6f2c7061" providerId="ADAL" clId="{C1BD3705-653B-4DD1-94D0-B1412E4052A7}" dt="2024-03-26T11:16:10.282" v="197" actId="478"/>
          <ac:cxnSpMkLst>
            <pc:docMk/>
            <pc:sldMk cId="1375384799" sldId="256"/>
            <ac:cxnSpMk id="60" creationId="{C1B94A03-F83A-492E-82C4-C0BC7DBE5EB0}"/>
          </ac:cxnSpMkLst>
        </pc:cxnChg>
        <pc:cxnChg chg="add del">
          <ac:chgData name="Tekle Pauzaite" userId="06f7e524-8501-4f81-9b2a-484f6f2c7061" providerId="ADAL" clId="{C1BD3705-653B-4DD1-94D0-B1412E4052A7}" dt="2024-03-26T11:16:10.282" v="197" actId="478"/>
          <ac:cxnSpMkLst>
            <pc:docMk/>
            <pc:sldMk cId="1375384799" sldId="256"/>
            <ac:cxnSpMk id="61" creationId="{1DDC993E-22A2-4EE1-BFF4-07C43C474A76}"/>
          </ac:cxnSpMkLst>
        </pc:cxnChg>
        <pc:cxnChg chg="add del">
          <ac:chgData name="Tekle Pauzaite" userId="06f7e524-8501-4f81-9b2a-484f6f2c7061" providerId="ADAL" clId="{C1BD3705-653B-4DD1-94D0-B1412E4052A7}" dt="2024-03-26T11:16:10.282" v="197" actId="478"/>
          <ac:cxnSpMkLst>
            <pc:docMk/>
            <pc:sldMk cId="1375384799" sldId="256"/>
            <ac:cxnSpMk id="62" creationId="{7787A4B7-9D09-4CEE-8EE3-76032CA668B6}"/>
          </ac:cxnSpMkLst>
        </pc:cxnChg>
        <pc:cxnChg chg="add del">
          <ac:chgData name="Tekle Pauzaite" userId="06f7e524-8501-4f81-9b2a-484f6f2c7061" providerId="ADAL" clId="{C1BD3705-653B-4DD1-94D0-B1412E4052A7}" dt="2024-03-26T11:16:10.282" v="197" actId="478"/>
          <ac:cxnSpMkLst>
            <pc:docMk/>
            <pc:sldMk cId="1375384799" sldId="256"/>
            <ac:cxnSpMk id="63" creationId="{229BD026-A033-45AE-867C-897D0225EFAA}"/>
          </ac:cxnSpMkLst>
        </pc:cxnChg>
        <pc:cxnChg chg="add del">
          <ac:chgData name="Tekle Pauzaite" userId="06f7e524-8501-4f81-9b2a-484f6f2c7061" providerId="ADAL" clId="{C1BD3705-653B-4DD1-94D0-B1412E4052A7}" dt="2024-03-26T11:16:10.282" v="197" actId="478"/>
          <ac:cxnSpMkLst>
            <pc:docMk/>
            <pc:sldMk cId="1375384799" sldId="256"/>
            <ac:cxnSpMk id="64" creationId="{C4EEF267-6453-4186-99E9-874310660C91}"/>
          </ac:cxnSpMkLst>
        </pc:cxnChg>
        <pc:cxnChg chg="add del">
          <ac:chgData name="Tekle Pauzaite" userId="06f7e524-8501-4f81-9b2a-484f6f2c7061" providerId="ADAL" clId="{C1BD3705-653B-4DD1-94D0-B1412E4052A7}" dt="2024-04-09T07:32:03.042" v="280" actId="478"/>
          <ac:cxnSpMkLst>
            <pc:docMk/>
            <pc:sldMk cId="1375384799" sldId="256"/>
            <ac:cxnSpMk id="132" creationId="{53996FA0-2F1C-406F-B737-89EB7D10BD21}"/>
          </ac:cxnSpMkLst>
        </pc:cxnChg>
        <pc:cxnChg chg="add del">
          <ac:chgData name="Tekle Pauzaite" userId="06f7e524-8501-4f81-9b2a-484f6f2c7061" providerId="ADAL" clId="{C1BD3705-653B-4DD1-94D0-B1412E4052A7}" dt="2024-04-09T07:32:03.042" v="280" actId="478"/>
          <ac:cxnSpMkLst>
            <pc:docMk/>
            <pc:sldMk cId="1375384799" sldId="256"/>
            <ac:cxnSpMk id="133" creationId="{AF1CAAC8-AB7D-4FE9-9BC1-CD7CA67DA799}"/>
          </ac:cxnSpMkLst>
        </pc:cxnChg>
        <pc:cxnChg chg="add del">
          <ac:chgData name="Tekle Pauzaite" userId="06f7e524-8501-4f81-9b2a-484f6f2c7061" providerId="ADAL" clId="{C1BD3705-653B-4DD1-94D0-B1412E4052A7}" dt="2024-04-09T07:32:03.042" v="280" actId="478"/>
          <ac:cxnSpMkLst>
            <pc:docMk/>
            <pc:sldMk cId="1375384799" sldId="256"/>
            <ac:cxnSpMk id="134" creationId="{66687182-4FA8-4C13-BAAB-DA6207624443}"/>
          </ac:cxnSpMkLst>
        </pc:cxnChg>
        <pc:cxnChg chg="add del">
          <ac:chgData name="Tekle Pauzaite" userId="06f7e524-8501-4f81-9b2a-484f6f2c7061" providerId="ADAL" clId="{C1BD3705-653B-4DD1-94D0-B1412E4052A7}" dt="2024-04-09T07:32:03.042" v="280" actId="478"/>
          <ac:cxnSpMkLst>
            <pc:docMk/>
            <pc:sldMk cId="1375384799" sldId="256"/>
            <ac:cxnSpMk id="135" creationId="{65F46FA7-5567-4925-A644-BA67D20B3746}"/>
          </ac:cxnSpMkLst>
        </pc:cxnChg>
        <pc:cxnChg chg="add del">
          <ac:chgData name="Tekle Pauzaite" userId="06f7e524-8501-4f81-9b2a-484f6f2c7061" providerId="ADAL" clId="{C1BD3705-653B-4DD1-94D0-B1412E4052A7}" dt="2024-04-09T07:32:03.042" v="280" actId="478"/>
          <ac:cxnSpMkLst>
            <pc:docMk/>
            <pc:sldMk cId="1375384799" sldId="256"/>
            <ac:cxnSpMk id="136" creationId="{1187F9FD-8E61-4A19-8B2D-C87D17470449}"/>
          </ac:cxnSpMkLst>
        </pc:cxnChg>
        <pc:cxnChg chg="add del">
          <ac:chgData name="Tekle Pauzaite" userId="06f7e524-8501-4f81-9b2a-484f6f2c7061" providerId="ADAL" clId="{C1BD3705-653B-4DD1-94D0-B1412E4052A7}" dt="2024-04-09T07:32:03.042" v="280" actId="478"/>
          <ac:cxnSpMkLst>
            <pc:docMk/>
            <pc:sldMk cId="1375384799" sldId="256"/>
            <ac:cxnSpMk id="137" creationId="{D21A7810-FD22-4747-8F61-E8B9CF3E338C}"/>
          </ac:cxnSpMkLst>
        </pc:cxnChg>
        <pc:cxnChg chg="add del">
          <ac:chgData name="Tekle Pauzaite" userId="06f7e524-8501-4f81-9b2a-484f6f2c7061" providerId="ADAL" clId="{C1BD3705-653B-4DD1-94D0-B1412E4052A7}" dt="2024-04-09T07:32:03.042" v="280" actId="478"/>
          <ac:cxnSpMkLst>
            <pc:docMk/>
            <pc:sldMk cId="1375384799" sldId="256"/>
            <ac:cxnSpMk id="138" creationId="{233ACE1A-5BB3-4402-B79D-EB5426DD70AB}"/>
          </ac:cxnSpMkLst>
        </pc:cxnChg>
        <pc:cxnChg chg="add del">
          <ac:chgData name="Tekle Pauzaite" userId="06f7e524-8501-4f81-9b2a-484f6f2c7061" providerId="ADAL" clId="{C1BD3705-653B-4DD1-94D0-B1412E4052A7}" dt="2024-04-09T07:32:03.042" v="280" actId="478"/>
          <ac:cxnSpMkLst>
            <pc:docMk/>
            <pc:sldMk cId="1375384799" sldId="256"/>
            <ac:cxnSpMk id="139" creationId="{F33D8E95-774F-4F47-9EC9-824E6FA39CFB}"/>
          </ac:cxnSpMkLst>
        </pc:cxnChg>
        <pc:cxnChg chg="add">
          <ac:chgData name="Tekle Pauzaite" userId="06f7e524-8501-4f81-9b2a-484f6f2c7061" providerId="ADAL" clId="{C1BD3705-653B-4DD1-94D0-B1412E4052A7}" dt="2024-04-09T07:32:03.468" v="281"/>
          <ac:cxnSpMkLst>
            <pc:docMk/>
            <pc:sldMk cId="1375384799" sldId="256"/>
            <ac:cxnSpMk id="192" creationId="{A3DCF7B2-1906-47CE-AE9C-567814A1DE5B}"/>
          </ac:cxnSpMkLst>
        </pc:cxnChg>
        <pc:cxnChg chg="add">
          <ac:chgData name="Tekle Pauzaite" userId="06f7e524-8501-4f81-9b2a-484f6f2c7061" providerId="ADAL" clId="{C1BD3705-653B-4DD1-94D0-B1412E4052A7}" dt="2024-04-09T07:32:03.468" v="281"/>
          <ac:cxnSpMkLst>
            <pc:docMk/>
            <pc:sldMk cId="1375384799" sldId="256"/>
            <ac:cxnSpMk id="193" creationId="{EBF9EB4B-CC50-4AD5-9E46-E8C43C6A051A}"/>
          </ac:cxnSpMkLst>
        </pc:cxnChg>
        <pc:cxnChg chg="add">
          <ac:chgData name="Tekle Pauzaite" userId="06f7e524-8501-4f81-9b2a-484f6f2c7061" providerId="ADAL" clId="{C1BD3705-653B-4DD1-94D0-B1412E4052A7}" dt="2024-04-09T07:32:03.468" v="281"/>
          <ac:cxnSpMkLst>
            <pc:docMk/>
            <pc:sldMk cId="1375384799" sldId="256"/>
            <ac:cxnSpMk id="194" creationId="{A247C858-7999-4C68-9A64-82F6332AB486}"/>
          </ac:cxnSpMkLst>
        </pc:cxnChg>
        <pc:cxnChg chg="add">
          <ac:chgData name="Tekle Pauzaite" userId="06f7e524-8501-4f81-9b2a-484f6f2c7061" providerId="ADAL" clId="{C1BD3705-653B-4DD1-94D0-B1412E4052A7}" dt="2024-04-09T07:32:03.468" v="281"/>
          <ac:cxnSpMkLst>
            <pc:docMk/>
            <pc:sldMk cId="1375384799" sldId="256"/>
            <ac:cxnSpMk id="195" creationId="{DF046752-D000-4275-B345-35EE58671CBA}"/>
          </ac:cxnSpMkLst>
        </pc:cxnChg>
        <pc:cxnChg chg="add">
          <ac:chgData name="Tekle Pauzaite" userId="06f7e524-8501-4f81-9b2a-484f6f2c7061" providerId="ADAL" clId="{C1BD3705-653B-4DD1-94D0-B1412E4052A7}" dt="2024-04-09T07:32:03.468" v="281"/>
          <ac:cxnSpMkLst>
            <pc:docMk/>
            <pc:sldMk cId="1375384799" sldId="256"/>
            <ac:cxnSpMk id="196" creationId="{BDBA4900-79BC-4D90-BBEA-02065DD1CCBE}"/>
          </ac:cxnSpMkLst>
        </pc:cxnChg>
        <pc:cxnChg chg="add">
          <ac:chgData name="Tekle Pauzaite" userId="06f7e524-8501-4f81-9b2a-484f6f2c7061" providerId="ADAL" clId="{C1BD3705-653B-4DD1-94D0-B1412E4052A7}" dt="2024-04-09T07:32:03.468" v="281"/>
          <ac:cxnSpMkLst>
            <pc:docMk/>
            <pc:sldMk cId="1375384799" sldId="256"/>
            <ac:cxnSpMk id="197" creationId="{E6A4D287-D420-4AA0-A173-C49CDAE91E0E}"/>
          </ac:cxnSpMkLst>
        </pc:cxnChg>
        <pc:cxnChg chg="add">
          <ac:chgData name="Tekle Pauzaite" userId="06f7e524-8501-4f81-9b2a-484f6f2c7061" providerId="ADAL" clId="{C1BD3705-653B-4DD1-94D0-B1412E4052A7}" dt="2024-04-09T07:32:03.468" v="281"/>
          <ac:cxnSpMkLst>
            <pc:docMk/>
            <pc:sldMk cId="1375384799" sldId="256"/>
            <ac:cxnSpMk id="198" creationId="{9648FC65-2636-4A06-BF88-2816AAD92216}"/>
          </ac:cxnSpMkLst>
        </pc:cxnChg>
        <pc:cxnChg chg="add">
          <ac:chgData name="Tekle Pauzaite" userId="06f7e524-8501-4f81-9b2a-484f6f2c7061" providerId="ADAL" clId="{C1BD3705-653B-4DD1-94D0-B1412E4052A7}" dt="2024-04-09T07:32:03.468" v="281"/>
          <ac:cxnSpMkLst>
            <pc:docMk/>
            <pc:sldMk cId="1375384799" sldId="256"/>
            <ac:cxnSpMk id="199" creationId="{317D608B-0138-4D5D-B52A-CCF0E012B68D}"/>
          </ac:cxnSpMkLst>
        </pc:cxnChg>
      </pc:sldChg>
      <pc:sldChg chg="addSp delSp modSp add">
        <pc:chgData name="Tekle Pauzaite" userId="06f7e524-8501-4f81-9b2a-484f6f2c7061" providerId="ADAL" clId="{C1BD3705-653B-4DD1-94D0-B1412E4052A7}" dt="2024-04-22T06:38:17.525" v="307" actId="478"/>
        <pc:sldMkLst>
          <pc:docMk/>
          <pc:sldMk cId="3301689485" sldId="257"/>
        </pc:sldMkLst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" creationId="{161CEB12-4F6C-42A1-B0B2-6D9734DD5FA7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3" creationId="{1B2CBB05-A033-4E4D-A055-858618E48535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" creationId="{1A1F10B1-D3E0-428D-BC72-C440FB594B41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5" creationId="{337C0AF7-5034-4B92-B0D4-AAE21EB91ABC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1" creationId="{22A4C812-DC03-4B92-8384-220DBFEB1247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2" creationId="{C05552DB-12C3-4972-BE34-0BA1A66FD421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3" creationId="{4FE03F34-3B60-4FCA-AE11-9BF17748BBC2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4" creationId="{38262E25-E40D-475E-B841-52D27691B13D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5" creationId="{8D7DBD80-CAA0-4409-A67A-116CC7548BAE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6" creationId="{E93D024B-56C6-4679-B8AF-BBF73431E687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7" creationId="{ACD90725-9B39-4599-A406-7332D9B33DC4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8" creationId="{4572D800-84F9-42E2-9343-25AC255985CE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19" creationId="{310278B0-BE78-41EB-91BD-F4E70A691951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0" creationId="{FA8A03BD-2F1C-4BC6-A860-3F2616D160FC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1" creationId="{5941E593-2994-4A9E-B8FB-932BB85CA306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2" creationId="{2627FD2E-FE67-4D09-9AD4-9EB25E036146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3" creationId="{EC22EC61-FEF8-427A-82C9-266917BED520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4" creationId="{A83C1F6E-AEBF-4878-8149-AD85EA6C83AF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5" creationId="{DA0893AB-7D15-4767-8C4C-190701C5EE21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6" creationId="{43239C51-0748-4BB5-86B8-06B9C1A12EAF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7" creationId="{80228F91-ED8E-468D-82E2-5E68A72C6CDE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8" creationId="{9E1005F3-0A28-4A06-B01F-B3AB12B12930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29" creationId="{3AEC9977-FB03-4135-AB2D-6445FBFC8B97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30" creationId="{6F7E9874-D2E4-4FB1-821E-48F88BE197F9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0" creationId="{926AAC00-F9AE-461A-8B20-3B252C18DE51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2" creationId="{3ACE5156-8EDC-4077-9DD7-2C466FD4C90B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3" creationId="{AA455309-61D7-421C-9F85-0760ED115057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4" creationId="{5239EB43-C972-41E4-BBF2-990A26995A0E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5" creationId="{947FEB55-80D9-428A-AB20-14A8D00D05DC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6" creationId="{6E1E2C90-2A56-490B-A9C6-1517856B852C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7" creationId="{A7C45823-D8E4-4C80-849D-270874603706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8" creationId="{8A2733D4-3427-4FC9-9A41-CBC8C471EE46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49" creationId="{882AD382-5536-4607-9E4B-8ED55BE1792B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50" creationId="{7F9B5293-C8DD-4D43-AC28-3376AC73117D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51" creationId="{DB04EDFB-4ECE-4B26-8703-C13307C7AC13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52" creationId="{18A95B57-6EB2-4903-A6EB-A235DAE03AA3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53" creationId="{EDC159FD-FC81-43BF-ACAC-8649DFB6891A}"/>
          </ac:spMkLst>
        </pc:spChg>
        <pc:spChg chg="add del">
          <ac:chgData name="Tekle Pauzaite" userId="06f7e524-8501-4f81-9b2a-484f6f2c7061" providerId="ADAL" clId="{C1BD3705-653B-4DD1-94D0-B1412E4052A7}" dt="2024-04-09T07:32:09.058" v="282" actId="478"/>
          <ac:spMkLst>
            <pc:docMk/>
            <pc:sldMk cId="3301689485" sldId="257"/>
            <ac:spMk id="54" creationId="{C225D576-6659-4734-A144-FFA6B7AE2983}"/>
          </ac:spMkLst>
        </pc:spChg>
        <pc:spChg chg="add mod">
          <ac:chgData name="Tekle Pauzaite" userId="06f7e524-8501-4f81-9b2a-484f6f2c7061" providerId="ADAL" clId="{C1BD3705-653B-4DD1-94D0-B1412E4052A7}" dt="2024-03-26T11:10:26.704" v="102" actId="1076"/>
          <ac:spMkLst>
            <pc:docMk/>
            <pc:sldMk cId="3301689485" sldId="257"/>
            <ac:spMk id="64" creationId="{F9AB6185-7E1A-442A-BCAE-9605A5111F47}"/>
          </ac:spMkLst>
        </pc:spChg>
        <pc:spChg chg="add del mod">
          <ac:chgData name="Tekle Pauzaite" userId="06f7e524-8501-4f81-9b2a-484f6f2c7061" providerId="ADAL" clId="{C1BD3705-653B-4DD1-94D0-B1412E4052A7}" dt="2024-04-22T06:38:14.431" v="306" actId="478"/>
          <ac:spMkLst>
            <pc:docMk/>
            <pc:sldMk cId="3301689485" sldId="257"/>
            <ac:spMk id="66" creationId="{70D7DDEA-CEFA-44F1-BB0C-1746900EA3BB}"/>
          </ac:spMkLst>
        </pc:spChg>
        <pc:spChg chg="add mod">
          <ac:chgData name="Tekle Pauzaite" userId="06f7e524-8501-4f81-9b2a-484f6f2c7061" providerId="ADAL" clId="{C1BD3705-653B-4DD1-94D0-B1412E4052A7}" dt="2024-03-26T11:14:23.165" v="165" actId="571"/>
          <ac:spMkLst>
            <pc:docMk/>
            <pc:sldMk cId="3301689485" sldId="257"/>
            <ac:spMk id="70" creationId="{F4ACD55D-4FF9-405D-BF0A-09CF8B475C37}"/>
          </ac:spMkLst>
        </pc:spChg>
        <pc:spChg chg="add del">
          <ac:chgData name="Tekle Pauzaite" userId="06f7e524-8501-4f81-9b2a-484f6f2c7061" providerId="ADAL" clId="{C1BD3705-653B-4DD1-94D0-B1412E4052A7}" dt="2024-03-26T11:14:27.129" v="167"/>
          <ac:spMkLst>
            <pc:docMk/>
            <pc:sldMk cId="3301689485" sldId="257"/>
            <ac:spMk id="72" creationId="{1A5D4378-4A36-43AD-B16E-2BB6A8097229}"/>
          </ac:spMkLst>
        </pc:spChg>
        <pc:spChg chg="add mod">
          <ac:chgData name="Tekle Pauzaite" userId="06f7e524-8501-4f81-9b2a-484f6f2c7061" providerId="ADAL" clId="{C1BD3705-653B-4DD1-94D0-B1412E4052A7}" dt="2024-03-26T11:14:34.888" v="169" actId="1076"/>
          <ac:spMkLst>
            <pc:docMk/>
            <pc:sldMk cId="3301689485" sldId="257"/>
            <ac:spMk id="73" creationId="{6AAE9091-9917-41A8-ACE0-0C5E2483DCD8}"/>
          </ac:spMkLst>
        </pc:spChg>
        <pc:spChg chg="add mod">
          <ac:chgData name="Tekle Pauzaite" userId="06f7e524-8501-4f81-9b2a-484f6f2c7061" providerId="ADAL" clId="{C1BD3705-653B-4DD1-94D0-B1412E4052A7}" dt="2024-03-26T11:14:39.720" v="171" actId="1076"/>
          <ac:spMkLst>
            <pc:docMk/>
            <pc:sldMk cId="3301689485" sldId="257"/>
            <ac:spMk id="74" creationId="{2AC09647-52A9-4311-817A-E4A35C7EE11A}"/>
          </ac:spMkLst>
        </pc:spChg>
        <pc:spChg chg="add mod">
          <ac:chgData name="Tekle Pauzaite" userId="06f7e524-8501-4f81-9b2a-484f6f2c7061" providerId="ADAL" clId="{C1BD3705-653B-4DD1-94D0-B1412E4052A7}" dt="2024-03-26T11:15:29.120" v="189" actId="1076"/>
          <ac:spMkLst>
            <pc:docMk/>
            <pc:sldMk cId="3301689485" sldId="257"/>
            <ac:spMk id="76" creationId="{37B28B41-3363-4217-AB7D-F59EFB9818E3}"/>
          </ac:spMkLst>
        </pc:spChg>
        <pc:spChg chg="add mod">
          <ac:chgData name="Tekle Pauzaite" userId="06f7e524-8501-4f81-9b2a-484f6f2c7061" providerId="ADAL" clId="{C1BD3705-653B-4DD1-94D0-B1412E4052A7}" dt="2024-03-26T11:15:37.049" v="190" actId="571"/>
          <ac:spMkLst>
            <pc:docMk/>
            <pc:sldMk cId="3301689485" sldId="257"/>
            <ac:spMk id="77" creationId="{59BDB607-1735-4AC8-A459-3EE3D9E7CF39}"/>
          </ac:spMkLst>
        </pc:spChg>
        <pc:spChg chg="add del mod">
          <ac:chgData name="Tekle Pauzaite" userId="06f7e524-8501-4f81-9b2a-484f6f2c7061" providerId="ADAL" clId="{C1BD3705-653B-4DD1-94D0-B1412E4052A7}" dt="2024-04-22T06:38:14.431" v="306" actId="478"/>
          <ac:spMkLst>
            <pc:docMk/>
            <pc:sldMk cId="3301689485" sldId="257"/>
            <ac:spMk id="78" creationId="{AAE3DACB-F3D4-400C-8F00-FD1FE2EB6EB0}"/>
          </ac:spMkLst>
        </pc:spChg>
        <pc:spChg chg="add mod">
          <ac:chgData name="Tekle Pauzaite" userId="06f7e524-8501-4f81-9b2a-484f6f2c7061" providerId="ADAL" clId="{C1BD3705-653B-4DD1-94D0-B1412E4052A7}" dt="2024-03-26T11:15:46.456" v="192" actId="571"/>
          <ac:spMkLst>
            <pc:docMk/>
            <pc:sldMk cId="3301689485" sldId="257"/>
            <ac:spMk id="79" creationId="{18520CFF-922B-466C-8E81-529FAA2AD4BB}"/>
          </ac:spMkLst>
        </pc:spChg>
        <pc:spChg chg="add mod">
          <ac:chgData name="Tekle Pauzaite" userId="06f7e524-8501-4f81-9b2a-484f6f2c7061" providerId="ADAL" clId="{C1BD3705-653B-4DD1-94D0-B1412E4052A7}" dt="2024-03-26T11:15:50.368" v="193" actId="571"/>
          <ac:spMkLst>
            <pc:docMk/>
            <pc:sldMk cId="3301689485" sldId="257"/>
            <ac:spMk id="80" creationId="{23CB231D-6C43-4EE2-A4E9-E0925CEF70D7}"/>
          </ac:spMkLst>
        </pc:spChg>
        <pc:spChg chg="add mod">
          <ac:chgData name="Tekle Pauzaite" userId="06f7e524-8501-4f81-9b2a-484f6f2c7061" providerId="ADAL" clId="{C1BD3705-653B-4DD1-94D0-B1412E4052A7}" dt="2024-03-26T11:15:53.552" v="194" actId="571"/>
          <ac:spMkLst>
            <pc:docMk/>
            <pc:sldMk cId="3301689485" sldId="257"/>
            <ac:spMk id="81" creationId="{3424E654-9BA6-4E41-A0DF-AA65177B1CD9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82" creationId="{48F9076E-7BF9-4BAF-A0B3-8D2C939FB124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83" creationId="{F826DD06-DEDB-4E90-BD87-E96E5AF3CC35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84" creationId="{01485CA5-7A2E-4820-97D8-3D0424484AAE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85" creationId="{5046D389-75AC-4AFC-8B54-388E8A693264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1" creationId="{3516C47B-0421-461A-8F40-1617B5D37DE1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2" creationId="{0881924D-166D-474D-A9DE-06F1AFABDAA6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3" creationId="{18550F9B-ACC5-49C6-8D13-FF91DA7A7E44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4" creationId="{DC9542B8-D49C-4F0D-AAB5-15CFFF9B31D5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5" creationId="{933C792C-43C2-4487-98F1-51872A573A20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6" creationId="{4ED4E43E-DDF3-4229-8897-40B2500D6648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7" creationId="{8C9D10BC-96E0-403F-B17F-CD3B7DEB2ADB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8" creationId="{90D0209A-FAD9-42ED-89F7-9AA44A5E65DB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99" creationId="{E39D0038-EAE2-42CC-A7D4-B04CBD1D5985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0" creationId="{C77DD705-27E3-4CDC-A9EB-72C87DE5847D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1" creationId="{9CBE2C06-0448-4456-8DF9-947F706E0975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2" creationId="{90DD59D6-635D-48A7-89F6-434B092C3AFF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3" creationId="{1A23E72C-10D3-48CD-9E4A-7DB00FEC16FC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4" creationId="{A34CB28F-6FBC-479D-9E06-F140CB434452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5" creationId="{2C86F285-82E8-4378-AE8B-131797BEE3AD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6" creationId="{3E6118D8-6D9B-4A83-B2D9-C519DA64964B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7" creationId="{40BF3C74-E1CF-4538-B9C5-C886CF92A9B1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8" creationId="{4C52BD81-B8B4-4FF4-BD4F-85CD3FBA9C4E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09" creationId="{216DFB39-77E4-49E4-B546-DE63B3E1191C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10" creationId="{C0019A46-9386-48D5-AA9F-FB335DE2073A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0" creationId="{CF4BC126-1360-49CC-86BD-07603E36E988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1" creationId="{59450703-5C1F-4821-8446-454B03CD134D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2" creationId="{B5F18012-C19B-4F08-B588-E19197C07D0E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3" creationId="{FFB9C8AB-FE97-4217-B9F3-EB54014DFCE9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4" creationId="{D6247133-271F-41E2-A657-7EEBB157E335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5" creationId="{010ABA12-B555-4B57-90E3-F79B735D587D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6" creationId="{599C82CF-128B-4C31-B1B2-6F403413FED2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7" creationId="{80D2FEE7-5F25-4CFF-9697-F38E1E3688D2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8" creationId="{0764564E-3EFE-4760-8F6A-172A26CC575D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29" creationId="{7A525693-5151-4E45-ACD8-54A565D22719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30" creationId="{6599DB9C-6FD0-434A-B156-2C8B411B7CFA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31" creationId="{634139EF-A7A4-4ABB-B9CF-57BCEF8C2131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32" creationId="{FC38612F-525A-4CA9-9DE5-B3B9F73D2B9C}"/>
          </ac:spMkLst>
        </pc:spChg>
        <pc:spChg chg="add">
          <ac:chgData name="Tekle Pauzaite" userId="06f7e524-8501-4f81-9b2a-484f6f2c7061" providerId="ADAL" clId="{C1BD3705-653B-4DD1-94D0-B1412E4052A7}" dt="2024-04-09T07:32:09.431" v="283"/>
          <ac:spMkLst>
            <pc:docMk/>
            <pc:sldMk cId="3301689485" sldId="257"/>
            <ac:spMk id="133" creationId="{246BD86B-D583-455D-86DC-4B9752905FB8}"/>
          </ac:spMkLst>
        </pc:sp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6" creationId="{8CFE463E-7B67-4FFC-A159-3FE68425842C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7" creationId="{970CFC95-AB0C-455E-B189-EA9119BDE4AD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8" creationId="{12ECA655-107B-4BFF-B1C7-91D5552F950C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9" creationId="{D39FED7C-BBED-4559-BD80-F2B98A6D8DDB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10" creationId="{FCA223F1-2F83-486E-8DD2-6A6B685C3CE4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31" creationId="{5FFAF66C-6C41-4DEF-8BFE-77045DE09DDF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32" creationId="{C2B8E89F-3899-478F-9C88-0CBF4EA0198E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33" creationId="{6825C847-E717-4E0B-9136-848F5A128756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34" creationId="{936F9EB5-768D-4BB7-B38A-75CA5AC0E5FF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35" creationId="{6C2C1067-BF20-4F48-9D92-86B77B464666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36" creationId="{1B756F68-2A28-4F06-B962-22E0651A15DF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37" creationId="{EE8CD548-0109-455B-84FD-47CB5752D9CC}"/>
          </ac:picMkLst>
        </pc:picChg>
        <pc:picChg chg="add del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38" creationId="{6D25A786-5151-4B98-AE0E-82AFBF2B01E3}"/>
          </ac:picMkLst>
        </pc:picChg>
        <pc:picChg chg="add del">
          <ac:chgData name="Tekle Pauzaite" userId="06f7e524-8501-4f81-9b2a-484f6f2c7061" providerId="ADAL" clId="{C1BD3705-653B-4DD1-94D0-B1412E4052A7}" dt="2024-03-26T11:12:57.083" v="145" actId="478"/>
          <ac:picMkLst>
            <pc:docMk/>
            <pc:sldMk cId="3301689485" sldId="257"/>
            <ac:picMk id="39" creationId="{2310A143-4D7C-4680-8FE9-103ADE56E6E1}"/>
          </ac:picMkLst>
        </pc:picChg>
        <pc:picChg chg="add del mod">
          <ac:chgData name="Tekle Pauzaite" userId="06f7e524-8501-4f81-9b2a-484f6f2c7061" providerId="ADAL" clId="{C1BD3705-653B-4DD1-94D0-B1412E4052A7}" dt="2024-04-09T07:32:09.058" v="282" actId="478"/>
          <ac:picMkLst>
            <pc:docMk/>
            <pc:sldMk cId="3301689485" sldId="257"/>
            <ac:picMk id="41" creationId="{1EB28C4F-84D8-465C-A9F1-65C9D4F7B77C}"/>
          </ac:picMkLst>
        </pc:picChg>
        <pc:picChg chg="add mod modCrop">
          <ac:chgData name="Tekle Pauzaite" userId="06f7e524-8501-4f81-9b2a-484f6f2c7061" providerId="ADAL" clId="{C1BD3705-653B-4DD1-94D0-B1412E4052A7}" dt="2024-03-26T11:10:14.024" v="100" actId="1076"/>
          <ac:picMkLst>
            <pc:docMk/>
            <pc:sldMk cId="3301689485" sldId="257"/>
            <ac:picMk id="63" creationId="{D76E7BF6-331A-4F6D-8BC0-41C1BE3B0311}"/>
          </ac:picMkLst>
        </pc:picChg>
        <pc:picChg chg="add del mod modCrop">
          <ac:chgData name="Tekle Pauzaite" userId="06f7e524-8501-4f81-9b2a-484f6f2c7061" providerId="ADAL" clId="{C1BD3705-653B-4DD1-94D0-B1412E4052A7}" dt="2024-04-22T06:38:13.010" v="305" actId="478"/>
          <ac:picMkLst>
            <pc:docMk/>
            <pc:sldMk cId="3301689485" sldId="257"/>
            <ac:picMk id="65" creationId="{A7F24291-0B92-4114-805E-B0686673EB4C}"/>
          </ac:picMkLst>
        </pc:picChg>
        <pc:picChg chg="add del mod">
          <ac:chgData name="Tekle Pauzaite" userId="06f7e524-8501-4f81-9b2a-484f6f2c7061" providerId="ADAL" clId="{C1BD3705-653B-4DD1-94D0-B1412E4052A7}" dt="2024-03-26T11:13:12.394" v="148" actId="478"/>
          <ac:picMkLst>
            <pc:docMk/>
            <pc:sldMk cId="3301689485" sldId="257"/>
            <ac:picMk id="67" creationId="{C7A17F66-0E3A-4A70-BD05-2E620D0425A4}"/>
          </ac:picMkLst>
        </pc:picChg>
        <pc:picChg chg="add mod modCrop">
          <ac:chgData name="Tekle Pauzaite" userId="06f7e524-8501-4f81-9b2a-484f6f2c7061" providerId="ADAL" clId="{C1BD3705-653B-4DD1-94D0-B1412E4052A7}" dt="2024-03-26T11:14:08.720" v="163" actId="1076"/>
          <ac:picMkLst>
            <pc:docMk/>
            <pc:sldMk cId="3301689485" sldId="257"/>
            <ac:picMk id="68" creationId="{B4DF6402-2FB6-4E51-9AA9-DE52CCF11A10}"/>
          </ac:picMkLst>
        </pc:picChg>
        <pc:picChg chg="add mod">
          <ac:chgData name="Tekle Pauzaite" userId="06f7e524-8501-4f81-9b2a-484f6f2c7061" providerId="ADAL" clId="{C1BD3705-653B-4DD1-94D0-B1412E4052A7}" dt="2024-03-26T11:14:23.165" v="165" actId="571"/>
          <ac:picMkLst>
            <pc:docMk/>
            <pc:sldMk cId="3301689485" sldId="257"/>
            <ac:picMk id="69" creationId="{AA3F0175-A114-4B04-AEC9-3F190B62D906}"/>
          </ac:picMkLst>
        </pc:picChg>
        <pc:picChg chg="add del">
          <ac:chgData name="Tekle Pauzaite" userId="06f7e524-8501-4f81-9b2a-484f6f2c7061" providerId="ADAL" clId="{C1BD3705-653B-4DD1-94D0-B1412E4052A7}" dt="2024-03-26T11:14:27.129" v="167"/>
          <ac:picMkLst>
            <pc:docMk/>
            <pc:sldMk cId="3301689485" sldId="257"/>
            <ac:picMk id="71" creationId="{0629358E-0B2A-41D4-872D-873C44BF674E}"/>
          </ac:picMkLst>
        </pc:picChg>
        <pc:picChg chg="add mod modCrop">
          <ac:chgData name="Tekle Pauzaite" userId="06f7e524-8501-4f81-9b2a-484f6f2c7061" providerId="ADAL" clId="{C1BD3705-653B-4DD1-94D0-B1412E4052A7}" dt="2024-03-26T11:15:17.568" v="187" actId="1076"/>
          <ac:picMkLst>
            <pc:docMk/>
            <pc:sldMk cId="3301689485" sldId="257"/>
            <ac:picMk id="75" creationId="{70F545F1-78F3-48D9-A5AC-06ECA86DA775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86" creationId="{C6727787-CDA7-49BC-A450-0D14D0ECA976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87" creationId="{B248C119-43A3-4ECF-A60B-AFED2D20B917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88" creationId="{93120806-EFBE-4524-AB2B-92C9E2C47FF4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89" creationId="{FD5189FD-1EDF-479E-8571-407D1AB3D97D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90" creationId="{22927125-6494-435F-B963-592A39826772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11" creationId="{3036B627-54ED-4F88-A5C4-BEC4F776626A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12" creationId="{250CF8CD-98F4-41E2-8DF7-9F3D80C310FD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13" creationId="{3B09733D-8D81-4542-BABF-0387BC77055A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14" creationId="{BA0E4723-2C39-48FD-AE1B-C116318D6DA6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15" creationId="{EF78A4AF-EB77-4BDC-A634-2F99B6050958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16" creationId="{1CFFE722-13F7-49B2-91BD-9248D05D2816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17" creationId="{C648420E-1D83-4AB7-8FAA-B24020F0425B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18" creationId="{45AA9CC6-A6FF-432A-BE1C-E99266A3D3D7}"/>
          </ac:picMkLst>
        </pc:picChg>
        <pc:picChg chg="add del">
          <ac:chgData name="Tekle Pauzaite" userId="06f7e524-8501-4f81-9b2a-484f6f2c7061" providerId="ADAL" clId="{C1BD3705-653B-4DD1-94D0-B1412E4052A7}" dt="2024-04-22T06:38:17.525" v="307" actId="478"/>
          <ac:picMkLst>
            <pc:docMk/>
            <pc:sldMk cId="3301689485" sldId="257"/>
            <ac:picMk id="119" creationId="{B7C441C7-3AD0-45CF-8470-259C0CA9AA38}"/>
          </ac:picMkLst>
        </pc:picChg>
        <pc:picChg chg="add">
          <ac:chgData name="Tekle Pauzaite" userId="06f7e524-8501-4f81-9b2a-484f6f2c7061" providerId="ADAL" clId="{C1BD3705-653B-4DD1-94D0-B1412E4052A7}" dt="2024-04-09T07:32:09.431" v="283"/>
          <ac:picMkLst>
            <pc:docMk/>
            <pc:sldMk cId="3301689485" sldId="257"/>
            <ac:picMk id="142" creationId="{7FC31F11-BF71-496F-AB3A-E18D4F6B051E}"/>
          </ac:picMkLst>
        </pc:picChg>
        <pc:cxnChg chg="add del">
          <ac:chgData name="Tekle Pauzaite" userId="06f7e524-8501-4f81-9b2a-484f6f2c7061" providerId="ADAL" clId="{C1BD3705-653B-4DD1-94D0-B1412E4052A7}" dt="2024-04-09T07:32:09.058" v="282" actId="478"/>
          <ac:cxnSpMkLst>
            <pc:docMk/>
            <pc:sldMk cId="3301689485" sldId="257"/>
            <ac:cxnSpMk id="55" creationId="{24421567-E092-45A9-A021-D6AC21B449A2}"/>
          </ac:cxnSpMkLst>
        </pc:cxnChg>
        <pc:cxnChg chg="add del">
          <ac:chgData name="Tekle Pauzaite" userId="06f7e524-8501-4f81-9b2a-484f6f2c7061" providerId="ADAL" clId="{C1BD3705-653B-4DD1-94D0-B1412E4052A7}" dt="2024-04-09T07:32:09.058" v="282" actId="478"/>
          <ac:cxnSpMkLst>
            <pc:docMk/>
            <pc:sldMk cId="3301689485" sldId="257"/>
            <ac:cxnSpMk id="56" creationId="{A8F7C231-A4CA-455F-9A91-199A05AC5F51}"/>
          </ac:cxnSpMkLst>
        </pc:cxnChg>
        <pc:cxnChg chg="add del">
          <ac:chgData name="Tekle Pauzaite" userId="06f7e524-8501-4f81-9b2a-484f6f2c7061" providerId="ADAL" clId="{C1BD3705-653B-4DD1-94D0-B1412E4052A7}" dt="2024-04-09T07:32:09.058" v="282" actId="478"/>
          <ac:cxnSpMkLst>
            <pc:docMk/>
            <pc:sldMk cId="3301689485" sldId="257"/>
            <ac:cxnSpMk id="57" creationId="{16A14031-A2D9-4854-A577-196B390633E5}"/>
          </ac:cxnSpMkLst>
        </pc:cxnChg>
        <pc:cxnChg chg="add del">
          <ac:chgData name="Tekle Pauzaite" userId="06f7e524-8501-4f81-9b2a-484f6f2c7061" providerId="ADAL" clId="{C1BD3705-653B-4DD1-94D0-B1412E4052A7}" dt="2024-04-09T07:32:09.058" v="282" actId="478"/>
          <ac:cxnSpMkLst>
            <pc:docMk/>
            <pc:sldMk cId="3301689485" sldId="257"/>
            <ac:cxnSpMk id="58" creationId="{104764F8-EE3E-4080-A2BF-A898102217F7}"/>
          </ac:cxnSpMkLst>
        </pc:cxnChg>
        <pc:cxnChg chg="add del">
          <ac:chgData name="Tekle Pauzaite" userId="06f7e524-8501-4f81-9b2a-484f6f2c7061" providerId="ADAL" clId="{C1BD3705-653B-4DD1-94D0-B1412E4052A7}" dt="2024-04-09T07:32:09.058" v="282" actId="478"/>
          <ac:cxnSpMkLst>
            <pc:docMk/>
            <pc:sldMk cId="3301689485" sldId="257"/>
            <ac:cxnSpMk id="59" creationId="{906E660C-FC87-4870-B5EE-1255ACC42CAA}"/>
          </ac:cxnSpMkLst>
        </pc:cxnChg>
        <pc:cxnChg chg="add del">
          <ac:chgData name="Tekle Pauzaite" userId="06f7e524-8501-4f81-9b2a-484f6f2c7061" providerId="ADAL" clId="{C1BD3705-653B-4DD1-94D0-B1412E4052A7}" dt="2024-04-09T07:32:09.058" v="282" actId="478"/>
          <ac:cxnSpMkLst>
            <pc:docMk/>
            <pc:sldMk cId="3301689485" sldId="257"/>
            <ac:cxnSpMk id="60" creationId="{BE7053FB-6B3A-4E92-A609-112F03B69CA5}"/>
          </ac:cxnSpMkLst>
        </pc:cxnChg>
        <pc:cxnChg chg="add del">
          <ac:chgData name="Tekle Pauzaite" userId="06f7e524-8501-4f81-9b2a-484f6f2c7061" providerId="ADAL" clId="{C1BD3705-653B-4DD1-94D0-B1412E4052A7}" dt="2024-04-09T07:32:09.058" v="282" actId="478"/>
          <ac:cxnSpMkLst>
            <pc:docMk/>
            <pc:sldMk cId="3301689485" sldId="257"/>
            <ac:cxnSpMk id="61" creationId="{C111E141-EF1C-446F-BA09-3490F40BA4D6}"/>
          </ac:cxnSpMkLst>
        </pc:cxnChg>
        <pc:cxnChg chg="add del">
          <ac:chgData name="Tekle Pauzaite" userId="06f7e524-8501-4f81-9b2a-484f6f2c7061" providerId="ADAL" clId="{C1BD3705-653B-4DD1-94D0-B1412E4052A7}" dt="2024-04-09T07:32:09.058" v="282" actId="478"/>
          <ac:cxnSpMkLst>
            <pc:docMk/>
            <pc:sldMk cId="3301689485" sldId="257"/>
            <ac:cxnSpMk id="62" creationId="{2FAB5662-67D3-4BCF-B2D1-3E4E9AF1292B}"/>
          </ac:cxnSpMkLst>
        </pc:cxnChg>
        <pc:cxnChg chg="add">
          <ac:chgData name="Tekle Pauzaite" userId="06f7e524-8501-4f81-9b2a-484f6f2c7061" providerId="ADAL" clId="{C1BD3705-653B-4DD1-94D0-B1412E4052A7}" dt="2024-04-09T07:32:09.431" v="283"/>
          <ac:cxnSpMkLst>
            <pc:docMk/>
            <pc:sldMk cId="3301689485" sldId="257"/>
            <ac:cxnSpMk id="134" creationId="{8B2171EF-00C1-48C8-B804-8E633B428755}"/>
          </ac:cxnSpMkLst>
        </pc:cxnChg>
        <pc:cxnChg chg="add">
          <ac:chgData name="Tekle Pauzaite" userId="06f7e524-8501-4f81-9b2a-484f6f2c7061" providerId="ADAL" clId="{C1BD3705-653B-4DD1-94D0-B1412E4052A7}" dt="2024-04-09T07:32:09.431" v="283"/>
          <ac:cxnSpMkLst>
            <pc:docMk/>
            <pc:sldMk cId="3301689485" sldId="257"/>
            <ac:cxnSpMk id="135" creationId="{089FC1C4-D21C-4682-93E8-A93E4F625FC2}"/>
          </ac:cxnSpMkLst>
        </pc:cxnChg>
        <pc:cxnChg chg="add">
          <ac:chgData name="Tekle Pauzaite" userId="06f7e524-8501-4f81-9b2a-484f6f2c7061" providerId="ADAL" clId="{C1BD3705-653B-4DD1-94D0-B1412E4052A7}" dt="2024-04-09T07:32:09.431" v="283"/>
          <ac:cxnSpMkLst>
            <pc:docMk/>
            <pc:sldMk cId="3301689485" sldId="257"/>
            <ac:cxnSpMk id="136" creationId="{067B62F2-3844-4E82-BFAA-3AAB2092203E}"/>
          </ac:cxnSpMkLst>
        </pc:cxnChg>
        <pc:cxnChg chg="add">
          <ac:chgData name="Tekle Pauzaite" userId="06f7e524-8501-4f81-9b2a-484f6f2c7061" providerId="ADAL" clId="{C1BD3705-653B-4DD1-94D0-B1412E4052A7}" dt="2024-04-09T07:32:09.431" v="283"/>
          <ac:cxnSpMkLst>
            <pc:docMk/>
            <pc:sldMk cId="3301689485" sldId="257"/>
            <ac:cxnSpMk id="137" creationId="{19C8ED8C-A802-48A9-B976-85A1B3CFD1EA}"/>
          </ac:cxnSpMkLst>
        </pc:cxnChg>
        <pc:cxnChg chg="add">
          <ac:chgData name="Tekle Pauzaite" userId="06f7e524-8501-4f81-9b2a-484f6f2c7061" providerId="ADAL" clId="{C1BD3705-653B-4DD1-94D0-B1412E4052A7}" dt="2024-04-09T07:32:09.431" v="283"/>
          <ac:cxnSpMkLst>
            <pc:docMk/>
            <pc:sldMk cId="3301689485" sldId="257"/>
            <ac:cxnSpMk id="138" creationId="{82660CED-A8C6-4098-AFE0-A28FE2340BC8}"/>
          </ac:cxnSpMkLst>
        </pc:cxnChg>
        <pc:cxnChg chg="add">
          <ac:chgData name="Tekle Pauzaite" userId="06f7e524-8501-4f81-9b2a-484f6f2c7061" providerId="ADAL" clId="{C1BD3705-653B-4DD1-94D0-B1412E4052A7}" dt="2024-04-09T07:32:09.431" v="283"/>
          <ac:cxnSpMkLst>
            <pc:docMk/>
            <pc:sldMk cId="3301689485" sldId="257"/>
            <ac:cxnSpMk id="139" creationId="{127A3E89-5867-4738-948C-CC03AB72FDB0}"/>
          </ac:cxnSpMkLst>
        </pc:cxnChg>
        <pc:cxnChg chg="add">
          <ac:chgData name="Tekle Pauzaite" userId="06f7e524-8501-4f81-9b2a-484f6f2c7061" providerId="ADAL" clId="{C1BD3705-653B-4DD1-94D0-B1412E4052A7}" dt="2024-04-09T07:32:09.431" v="283"/>
          <ac:cxnSpMkLst>
            <pc:docMk/>
            <pc:sldMk cId="3301689485" sldId="257"/>
            <ac:cxnSpMk id="140" creationId="{C5A8A7FC-7E94-45AB-8B35-0E0B542B227D}"/>
          </ac:cxnSpMkLst>
        </pc:cxnChg>
        <pc:cxnChg chg="add">
          <ac:chgData name="Tekle Pauzaite" userId="06f7e524-8501-4f81-9b2a-484f6f2c7061" providerId="ADAL" clId="{C1BD3705-653B-4DD1-94D0-B1412E4052A7}" dt="2024-04-09T07:32:09.431" v="283"/>
          <ac:cxnSpMkLst>
            <pc:docMk/>
            <pc:sldMk cId="3301689485" sldId="257"/>
            <ac:cxnSpMk id="141" creationId="{54BACFAB-3226-4A01-BE8C-4044B35FB93D}"/>
          </ac:cxnSpMkLst>
        </pc:cxnChg>
      </pc:sldChg>
      <pc:sldChg chg="addSp delSp modSp add">
        <pc:chgData name="Tekle Pauzaite" userId="06f7e524-8501-4f81-9b2a-484f6f2c7061" providerId="ADAL" clId="{C1BD3705-653B-4DD1-94D0-B1412E4052A7}" dt="2024-04-22T06:38:23.024" v="309" actId="478"/>
        <pc:sldMkLst>
          <pc:docMk/>
          <pc:sldMk cId="1166010794" sldId="258"/>
        </pc:sldMkLst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" creationId="{1D702BFA-F166-4714-ABEC-EFE2FC7C1464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3" creationId="{F6B90713-8B67-4632-BDB6-8FBC08EAE064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" creationId="{8B92E05A-0A09-4F81-8422-6F3EABE7A9C4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5" creationId="{3F3EB164-7CFE-40A3-9115-40FB0B1FBC2B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1" creationId="{7680B88E-5BD2-4B0C-AFBF-C9B254004DA9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2" creationId="{80C01C51-EAAF-493B-93FB-B38A341E7E11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3" creationId="{292E7550-3F1B-4E2E-A81B-DCE348D5CFE4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4" creationId="{11173F15-3EE2-4513-AA35-DEA96FB356C5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5" creationId="{E84B0A68-18E2-41D3-A2AB-2E250A2A66D7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6" creationId="{E7D677F2-E254-4AD0-B010-B82FE4C373CD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7" creationId="{80A7732F-819E-485F-9E18-B2CB44861ADC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8" creationId="{194D7780-4171-4D08-ABA1-3B38A97C09F3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19" creationId="{F6132982-5AF0-427F-ADEB-C81CB39A97A5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0" creationId="{0D1838F0-1A9A-4F25-8119-1B23FD723089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1" creationId="{6C54BF4E-AD8B-4DA7-80F1-D0909F31CE7A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2" creationId="{A80D6B04-0FCF-4E42-B0AF-5FB4FAA7D97B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3" creationId="{7FFF5249-07AE-415D-86AE-2648DEC430DD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4" creationId="{73CFA7E0-C07D-4623-835F-5A07BB47B186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5" creationId="{CA5DB8C3-2B1F-4295-90C7-EBE21F1930CC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6" creationId="{7E223C5E-F2D1-4EA3-9E21-EDD46F2D73B8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7" creationId="{64EF584B-5B94-4C41-AE11-8D3D17407CA7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8" creationId="{670C55C1-9CF1-4919-922F-B3B0CD0FCBF5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29" creationId="{30408CB3-A4DA-4700-9C95-3C60ADA7AFF6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30" creationId="{8C0E412B-8E72-4F04-B75E-23D2760E9E44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39" creationId="{C26324E3-C80A-49D9-B79A-76945543EBAE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1" creationId="{642DDCA8-F4C2-44AB-B185-FEBEE41D31ED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2" creationId="{58CA9781-0995-49FA-AA28-60968B2A4A84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3" creationId="{079B8B32-E23E-4E62-9A45-C5745E8E6877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4" creationId="{8ACD8AAC-6E39-4583-863B-8FBDCA78C91D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5" creationId="{5637E916-2BDA-4218-9DAD-6724A8DE7F23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6" creationId="{8A07051C-0178-419F-9287-488819737B45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7" creationId="{0F0A2C9C-2168-4B4E-B1D1-7B5AB451655A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8" creationId="{81FF59E9-B49C-48AE-A046-D5B477D010F0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49" creationId="{1A87A84E-A234-49D5-9A4B-D761654FC227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50" creationId="{68C223C1-88EC-4627-A890-383B1DCB9EEC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51" creationId="{CB30811C-C9A0-421D-AAD0-336E0E2971FA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52" creationId="{FB5695EA-8C15-4742-8B72-41AB5786DE5D}"/>
          </ac:spMkLst>
        </pc:spChg>
        <pc:spChg chg="add del">
          <ac:chgData name="Tekle Pauzaite" userId="06f7e524-8501-4f81-9b2a-484f6f2c7061" providerId="ADAL" clId="{C1BD3705-653B-4DD1-94D0-B1412E4052A7}" dt="2024-04-09T07:32:14.049" v="284" actId="478"/>
          <ac:spMkLst>
            <pc:docMk/>
            <pc:sldMk cId="1166010794" sldId="258"/>
            <ac:spMk id="53" creationId="{B57E1E58-4B46-42EB-9250-AFC94C326F0B}"/>
          </ac:spMkLst>
        </pc:spChg>
        <pc:spChg chg="add mod">
          <ac:chgData name="Tekle Pauzaite" userId="06f7e524-8501-4f81-9b2a-484f6f2c7061" providerId="ADAL" clId="{C1BD3705-653B-4DD1-94D0-B1412E4052A7}" dt="2024-03-26T11:16:50.312" v="215" actId="1076"/>
          <ac:spMkLst>
            <pc:docMk/>
            <pc:sldMk cId="1166010794" sldId="258"/>
            <ac:spMk id="63" creationId="{8D160325-BB2C-4560-87C6-08EBF4EF3555}"/>
          </ac:spMkLst>
        </pc:spChg>
        <pc:spChg chg="add mod">
          <ac:chgData name="Tekle Pauzaite" userId="06f7e524-8501-4f81-9b2a-484f6f2c7061" providerId="ADAL" clId="{C1BD3705-653B-4DD1-94D0-B1412E4052A7}" dt="2024-03-26T11:19:04.272" v="276" actId="1076"/>
          <ac:spMkLst>
            <pc:docMk/>
            <pc:sldMk cId="1166010794" sldId="258"/>
            <ac:spMk id="65" creationId="{DA32AF73-5BF4-456B-A0A4-A60CC3A3FBF7}"/>
          </ac:spMkLst>
        </pc:spChg>
        <pc:spChg chg="add mod">
          <ac:chgData name="Tekle Pauzaite" userId="06f7e524-8501-4f81-9b2a-484f6f2c7061" providerId="ADAL" clId="{C1BD3705-653B-4DD1-94D0-B1412E4052A7}" dt="2024-03-26T11:18:59.512" v="275" actId="1076"/>
          <ac:spMkLst>
            <pc:docMk/>
            <pc:sldMk cId="1166010794" sldId="258"/>
            <ac:spMk id="67" creationId="{77BF5882-C2D4-4A71-A568-470587656CA1}"/>
          </ac:spMkLst>
        </pc:spChg>
        <pc:spChg chg="add mod">
          <ac:chgData name="Tekle Pauzaite" userId="06f7e524-8501-4f81-9b2a-484f6f2c7061" providerId="ADAL" clId="{C1BD3705-653B-4DD1-94D0-B1412E4052A7}" dt="2024-03-26T11:18:59.512" v="275" actId="1076"/>
          <ac:spMkLst>
            <pc:docMk/>
            <pc:sldMk cId="1166010794" sldId="258"/>
            <ac:spMk id="69" creationId="{981C9096-FF6D-4812-AEAF-B6C5B088DE7F}"/>
          </ac:spMkLst>
        </pc:spChg>
        <pc:spChg chg="add mod">
          <ac:chgData name="Tekle Pauzaite" userId="06f7e524-8501-4f81-9b2a-484f6f2c7061" providerId="ADAL" clId="{C1BD3705-653B-4DD1-94D0-B1412E4052A7}" dt="2024-03-26T11:18:46.249" v="271" actId="571"/>
          <ac:spMkLst>
            <pc:docMk/>
            <pc:sldMk cId="1166010794" sldId="258"/>
            <ac:spMk id="70" creationId="{09C8AE47-28B4-4C32-B6E4-17D2661D8267}"/>
          </ac:spMkLst>
        </pc:spChg>
        <pc:spChg chg="add mod">
          <ac:chgData name="Tekle Pauzaite" userId="06f7e524-8501-4f81-9b2a-484f6f2c7061" providerId="ADAL" clId="{C1BD3705-653B-4DD1-94D0-B1412E4052A7}" dt="2024-03-26T11:19:04.272" v="276" actId="1076"/>
          <ac:spMkLst>
            <pc:docMk/>
            <pc:sldMk cId="1166010794" sldId="258"/>
            <ac:spMk id="71" creationId="{ACEAC6CD-B5BA-40BB-97FC-1423D0039675}"/>
          </ac:spMkLst>
        </pc:spChg>
        <pc:spChg chg="add mod">
          <ac:chgData name="Tekle Pauzaite" userId="06f7e524-8501-4f81-9b2a-484f6f2c7061" providerId="ADAL" clId="{C1BD3705-653B-4DD1-94D0-B1412E4052A7}" dt="2024-03-26T11:18:59.512" v="275" actId="1076"/>
          <ac:spMkLst>
            <pc:docMk/>
            <pc:sldMk cId="1166010794" sldId="258"/>
            <ac:spMk id="72" creationId="{E3922D4D-C940-4B56-B37F-100354D0984E}"/>
          </ac:spMkLst>
        </pc:spChg>
        <pc:spChg chg="add mod">
          <ac:chgData name="Tekle Pauzaite" userId="06f7e524-8501-4f81-9b2a-484f6f2c7061" providerId="ADAL" clId="{C1BD3705-653B-4DD1-94D0-B1412E4052A7}" dt="2024-03-26T11:18:59.512" v="275" actId="1076"/>
          <ac:spMkLst>
            <pc:docMk/>
            <pc:sldMk cId="1166010794" sldId="258"/>
            <ac:spMk id="73" creationId="{8B6BB798-A8E3-4910-A32F-E5DB308B3D98}"/>
          </ac:spMkLst>
        </pc:spChg>
        <pc:spChg chg="add mod ord">
          <ac:chgData name="Tekle Pauzaite" userId="06f7e524-8501-4f81-9b2a-484f6f2c7061" providerId="ADAL" clId="{C1BD3705-653B-4DD1-94D0-B1412E4052A7}" dt="2024-04-09T07:32:53.487" v="304" actId="1076"/>
          <ac:spMkLst>
            <pc:docMk/>
            <pc:sldMk cId="1166010794" sldId="258"/>
            <ac:spMk id="74" creationId="{C08CE126-42A0-4ED0-ACE5-CD808E75F928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75" creationId="{B56E14C9-3031-4A38-9E84-8D08A242F1A7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76" creationId="{BE164F25-962B-4B10-A4D7-37B1FEE4A537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77" creationId="{8B2552F6-7AB2-4EDB-8D05-8795B08C0B7D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78" creationId="{38C261A1-0446-4610-8CA9-7260EC9A3D49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84" creationId="{F03039E8-2472-4A07-AC03-DB9C4AB74FB4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85" creationId="{580D1CFC-5D7B-409D-A321-02282A514D34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86" creationId="{CF198AC3-5325-40BF-A311-72DBE81C8D15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87" creationId="{415D0E7C-DFFA-4BFA-876D-867DD63F9209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88" creationId="{CADB99FA-D106-488B-AC33-2E54FB4F1D73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89" creationId="{699A403B-CB93-4E9C-AE6E-105355AB51B7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0" creationId="{33C476CD-ED59-424F-928D-03929211A372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1" creationId="{9B23736D-198D-492F-8FEA-A7906FB27F9C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2" creationId="{0792C273-62AE-4652-AD4C-D1A795D47B67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3" creationId="{EF60AAB0-04B6-4FE2-8934-05184E69EB72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4" creationId="{CEA0A861-E2D8-4A2A-9F54-94F1A71CAAA9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5" creationId="{3D5E58E2-E1D5-47C1-A83A-D11EDE76A8DA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6" creationId="{CC5DF823-D77A-478E-BABE-CC5413518CE1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7" creationId="{CE0BBE8A-602C-4168-A738-5AF9453DA325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8" creationId="{8A766986-798B-4EB2-AA96-35F5B7BCF7FC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99" creationId="{480BEA31-207A-4EB0-B014-BEDB12076A74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00" creationId="{7ED2E2DA-ADAD-4674-A613-162964C2E238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01" creationId="{A71FA21A-854E-4441-B8D3-4F573D0664E0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02" creationId="{3CF68BC5-3A10-46E2-B76E-3893232FF911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03" creationId="{429559D9-F4C6-4928-B88C-4CF7C0AB7BCF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13" creationId="{92EBED7A-88D6-47BC-9CEF-278CD771FFB1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14" creationId="{844FDF42-B0A0-48F6-A612-CB4413A5BB3F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15" creationId="{854A6EEA-0F7F-4AC3-8CDD-A3683E318704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16" creationId="{5829B1AC-20A7-41F9-9AD6-C2298C081EC7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17" creationId="{755B265D-DD06-460B-A1AD-37956567D7DE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18" creationId="{7F52A76D-B502-4CD9-AA38-5458BDBEFBCF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19" creationId="{F71AB922-6813-4A17-89D9-5221E27C2282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20" creationId="{E3B6757B-6062-4A27-B85D-35E65EB12A9A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21" creationId="{5A075719-6B53-4EA0-9E75-30DA542BDFD4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22" creationId="{4DA78E7A-A919-4C50-8B4E-61B8A0BDBE7F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23" creationId="{06991150-2A85-4658-8F2E-B8EE6C956071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24" creationId="{6FFF8633-A77A-4BB4-B95F-A29C270496A7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25" creationId="{50516D77-FDA3-467C-8C47-BD0BBD6A94B8}"/>
          </ac:spMkLst>
        </pc:spChg>
        <pc:spChg chg="add">
          <ac:chgData name="Tekle Pauzaite" userId="06f7e524-8501-4f81-9b2a-484f6f2c7061" providerId="ADAL" clId="{C1BD3705-653B-4DD1-94D0-B1412E4052A7}" dt="2024-04-09T07:32:14.424" v="285"/>
          <ac:spMkLst>
            <pc:docMk/>
            <pc:sldMk cId="1166010794" sldId="258"/>
            <ac:spMk id="126" creationId="{B9A1385C-E7EA-4D72-B6C9-016D6C85751A}"/>
          </ac:spMkLst>
        </pc:spChg>
        <pc:spChg chg="add mod">
          <ac:chgData name="Tekle Pauzaite" userId="06f7e524-8501-4f81-9b2a-484f6f2c7061" providerId="ADAL" clId="{C1BD3705-653B-4DD1-94D0-B1412E4052A7}" dt="2024-04-09T07:32:45.244" v="301" actId="571"/>
          <ac:spMkLst>
            <pc:docMk/>
            <pc:sldMk cId="1166010794" sldId="258"/>
            <ac:spMk id="137" creationId="{EE7931CA-E2AE-4FCB-AE0E-2C7337063594}"/>
          </ac:spMkLst>
        </pc:sp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6" creationId="{FFB8BCBC-055E-4034-90F7-4E110C29FE7E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7" creationId="{2AE8A212-DBF0-44F7-AA75-DA711CD7FEDC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8" creationId="{F84C2E27-8154-43C0-8946-7475E65E5A39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9" creationId="{7DB953FB-9BB1-485B-9660-A1CAD7E7240A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10" creationId="{7FB2A3BA-4098-4786-89B2-5979CC765E7C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31" creationId="{58C1F57E-AB54-42C3-854D-52B6AD30D067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32" creationId="{548CFD8D-48B0-4814-B52A-E74D53D37416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33" creationId="{4A4789A8-E077-494D-B31C-7D9862B6880B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34" creationId="{D5B9267A-851F-4482-92CB-B9CD66821129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35" creationId="{5F7F8F94-4506-47F8-BA80-51B83EC22536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36" creationId="{674F21DD-79D0-4C81-845C-F7AF6F940FA1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37" creationId="{FA0ACD7B-7780-47D3-935B-DCEB89B0C160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38" creationId="{FCA37A0E-19CA-4404-B8C1-294500D942BD}"/>
          </ac:picMkLst>
        </pc:picChg>
        <pc:picChg chg="add del">
          <ac:chgData name="Tekle Pauzaite" userId="06f7e524-8501-4f81-9b2a-484f6f2c7061" providerId="ADAL" clId="{C1BD3705-653B-4DD1-94D0-B1412E4052A7}" dt="2024-04-09T07:32:14.049" v="284" actId="478"/>
          <ac:picMkLst>
            <pc:docMk/>
            <pc:sldMk cId="1166010794" sldId="258"/>
            <ac:picMk id="40" creationId="{E517719B-F1EE-4F6C-AC6F-868D7D4094B2}"/>
          </ac:picMkLst>
        </pc:picChg>
        <pc:picChg chg="add mod modCrop">
          <ac:chgData name="Tekle Pauzaite" userId="06f7e524-8501-4f81-9b2a-484f6f2c7061" providerId="ADAL" clId="{C1BD3705-653B-4DD1-94D0-B1412E4052A7}" dt="2024-03-26T11:16:36.648" v="213" actId="1076"/>
          <ac:picMkLst>
            <pc:docMk/>
            <pc:sldMk cId="1166010794" sldId="258"/>
            <ac:picMk id="62" creationId="{2410C96C-A2BC-4818-BEF7-F275E224F9FC}"/>
          </ac:picMkLst>
        </pc:picChg>
        <pc:picChg chg="add mod modCrop">
          <ac:chgData name="Tekle Pauzaite" userId="06f7e524-8501-4f81-9b2a-484f6f2c7061" providerId="ADAL" clId="{C1BD3705-653B-4DD1-94D0-B1412E4052A7}" dt="2024-03-26T11:19:04.272" v="276" actId="1076"/>
          <ac:picMkLst>
            <pc:docMk/>
            <pc:sldMk cId="1166010794" sldId="258"/>
            <ac:picMk id="64" creationId="{89C90F31-EB23-431A-8DF9-F48F5770FDBA}"/>
          </ac:picMkLst>
        </pc:picChg>
        <pc:picChg chg="add mod modCrop">
          <ac:chgData name="Tekle Pauzaite" userId="06f7e524-8501-4f81-9b2a-484f6f2c7061" providerId="ADAL" clId="{C1BD3705-653B-4DD1-94D0-B1412E4052A7}" dt="2024-03-26T11:18:59.512" v="275" actId="1076"/>
          <ac:picMkLst>
            <pc:docMk/>
            <pc:sldMk cId="1166010794" sldId="258"/>
            <ac:picMk id="66" creationId="{D27ACD38-F5E7-4563-A5DA-040AC821DC7C}"/>
          </ac:picMkLst>
        </pc:picChg>
        <pc:picChg chg="add mod modCrop">
          <ac:chgData name="Tekle Pauzaite" userId="06f7e524-8501-4f81-9b2a-484f6f2c7061" providerId="ADAL" clId="{C1BD3705-653B-4DD1-94D0-B1412E4052A7}" dt="2024-03-26T11:18:59.512" v="275" actId="1076"/>
          <ac:picMkLst>
            <pc:docMk/>
            <pc:sldMk cId="1166010794" sldId="258"/>
            <ac:picMk id="68" creationId="{A0C01521-EF6E-42BB-B1F4-F709E0AC52B8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79" creationId="{DB2D0FB5-B1ED-4AA3-81E6-828EF2477D5B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80" creationId="{CFDC41FA-B794-4692-A2B0-FA71FB77E141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81" creationId="{161A413A-2B7E-4B27-A68B-E7E8AE603D02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82" creationId="{0AA27646-6D02-43E5-BBF7-CCE0C70451AC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83" creationId="{6C56510F-3C90-4B0E-9BA7-E74F2401D37A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04" creationId="{4ECEABDE-3DA4-472B-BE71-59AB7F6620CC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05" creationId="{12A7B60A-4557-44BC-A736-6444205826DE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06" creationId="{8C86D1C5-53DC-4964-B943-E78473829989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07" creationId="{748287DE-15C6-4CA5-8071-C168E82A75A0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08" creationId="{CFFC9700-8201-41FB-AD12-AD49F010F286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09" creationId="{E03FAE88-CB43-4561-9E00-20CC5A46C09C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10" creationId="{7B489C6A-B006-4F6B-9B77-72ED09D0A441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11" creationId="{1CD0C855-3797-444B-BE37-2D2895B347B9}"/>
          </ac:picMkLst>
        </pc:picChg>
        <pc:picChg chg="add del">
          <ac:chgData name="Tekle Pauzaite" userId="06f7e524-8501-4f81-9b2a-484f6f2c7061" providerId="ADAL" clId="{C1BD3705-653B-4DD1-94D0-B1412E4052A7}" dt="2024-04-22T06:38:23.024" v="309" actId="478"/>
          <ac:picMkLst>
            <pc:docMk/>
            <pc:sldMk cId="1166010794" sldId="258"/>
            <ac:picMk id="112" creationId="{DF1E5AE8-FA47-428C-A71B-419AA2C24AB6}"/>
          </ac:picMkLst>
        </pc:picChg>
        <pc:picChg chg="add">
          <ac:chgData name="Tekle Pauzaite" userId="06f7e524-8501-4f81-9b2a-484f6f2c7061" providerId="ADAL" clId="{C1BD3705-653B-4DD1-94D0-B1412E4052A7}" dt="2024-04-09T07:32:14.424" v="285"/>
          <ac:picMkLst>
            <pc:docMk/>
            <pc:sldMk cId="1166010794" sldId="258"/>
            <ac:picMk id="135" creationId="{3047C37D-C00E-4CF1-9923-3F74E38FE2FC}"/>
          </ac:picMkLst>
        </pc:picChg>
        <pc:picChg chg="add mod modCrop">
          <ac:chgData name="Tekle Pauzaite" userId="06f7e524-8501-4f81-9b2a-484f6f2c7061" providerId="ADAL" clId="{C1BD3705-653B-4DD1-94D0-B1412E4052A7}" dt="2024-04-09T07:32:41.631" v="300" actId="1076"/>
          <ac:picMkLst>
            <pc:docMk/>
            <pc:sldMk cId="1166010794" sldId="258"/>
            <ac:picMk id="136" creationId="{2C5A8715-2CA1-4843-AED4-FD708EAF11E4}"/>
          </ac:picMkLst>
        </pc:picChg>
        <pc:cxnChg chg="add del">
          <ac:chgData name="Tekle Pauzaite" userId="06f7e524-8501-4f81-9b2a-484f6f2c7061" providerId="ADAL" clId="{C1BD3705-653B-4DD1-94D0-B1412E4052A7}" dt="2024-04-09T07:32:14.049" v="284" actId="478"/>
          <ac:cxnSpMkLst>
            <pc:docMk/>
            <pc:sldMk cId="1166010794" sldId="258"/>
            <ac:cxnSpMk id="54" creationId="{1DC22DB4-E0E2-422B-82A1-70B96386A660}"/>
          </ac:cxnSpMkLst>
        </pc:cxnChg>
        <pc:cxnChg chg="add del">
          <ac:chgData name="Tekle Pauzaite" userId="06f7e524-8501-4f81-9b2a-484f6f2c7061" providerId="ADAL" clId="{C1BD3705-653B-4DD1-94D0-B1412E4052A7}" dt="2024-04-09T07:32:14.049" v="284" actId="478"/>
          <ac:cxnSpMkLst>
            <pc:docMk/>
            <pc:sldMk cId="1166010794" sldId="258"/>
            <ac:cxnSpMk id="55" creationId="{99251FBD-84A6-4216-ABA0-A3561CCD5F35}"/>
          </ac:cxnSpMkLst>
        </pc:cxnChg>
        <pc:cxnChg chg="add del">
          <ac:chgData name="Tekle Pauzaite" userId="06f7e524-8501-4f81-9b2a-484f6f2c7061" providerId="ADAL" clId="{C1BD3705-653B-4DD1-94D0-B1412E4052A7}" dt="2024-04-09T07:32:14.049" v="284" actId="478"/>
          <ac:cxnSpMkLst>
            <pc:docMk/>
            <pc:sldMk cId="1166010794" sldId="258"/>
            <ac:cxnSpMk id="56" creationId="{E22AA392-6506-425D-99CD-3E023196828D}"/>
          </ac:cxnSpMkLst>
        </pc:cxnChg>
        <pc:cxnChg chg="add del">
          <ac:chgData name="Tekle Pauzaite" userId="06f7e524-8501-4f81-9b2a-484f6f2c7061" providerId="ADAL" clId="{C1BD3705-653B-4DD1-94D0-B1412E4052A7}" dt="2024-04-09T07:32:14.049" v="284" actId="478"/>
          <ac:cxnSpMkLst>
            <pc:docMk/>
            <pc:sldMk cId="1166010794" sldId="258"/>
            <ac:cxnSpMk id="57" creationId="{38C85779-8BEA-4FD4-ABB0-0B4981270057}"/>
          </ac:cxnSpMkLst>
        </pc:cxnChg>
        <pc:cxnChg chg="add del">
          <ac:chgData name="Tekle Pauzaite" userId="06f7e524-8501-4f81-9b2a-484f6f2c7061" providerId="ADAL" clId="{C1BD3705-653B-4DD1-94D0-B1412E4052A7}" dt="2024-04-09T07:32:14.049" v="284" actId="478"/>
          <ac:cxnSpMkLst>
            <pc:docMk/>
            <pc:sldMk cId="1166010794" sldId="258"/>
            <ac:cxnSpMk id="58" creationId="{C441DB2B-BDCE-4C29-8C7F-2A4D80072F92}"/>
          </ac:cxnSpMkLst>
        </pc:cxnChg>
        <pc:cxnChg chg="add del">
          <ac:chgData name="Tekle Pauzaite" userId="06f7e524-8501-4f81-9b2a-484f6f2c7061" providerId="ADAL" clId="{C1BD3705-653B-4DD1-94D0-B1412E4052A7}" dt="2024-04-09T07:32:14.049" v="284" actId="478"/>
          <ac:cxnSpMkLst>
            <pc:docMk/>
            <pc:sldMk cId="1166010794" sldId="258"/>
            <ac:cxnSpMk id="59" creationId="{D9218E0C-160E-4E8F-89A6-9E4781BCDFA0}"/>
          </ac:cxnSpMkLst>
        </pc:cxnChg>
        <pc:cxnChg chg="add del">
          <ac:chgData name="Tekle Pauzaite" userId="06f7e524-8501-4f81-9b2a-484f6f2c7061" providerId="ADAL" clId="{C1BD3705-653B-4DD1-94D0-B1412E4052A7}" dt="2024-04-09T07:32:14.049" v="284" actId="478"/>
          <ac:cxnSpMkLst>
            <pc:docMk/>
            <pc:sldMk cId="1166010794" sldId="258"/>
            <ac:cxnSpMk id="60" creationId="{8D926E18-4088-4EBD-ACA0-001E64537F83}"/>
          </ac:cxnSpMkLst>
        </pc:cxnChg>
        <pc:cxnChg chg="add del">
          <ac:chgData name="Tekle Pauzaite" userId="06f7e524-8501-4f81-9b2a-484f6f2c7061" providerId="ADAL" clId="{C1BD3705-653B-4DD1-94D0-B1412E4052A7}" dt="2024-04-09T07:32:14.049" v="284" actId="478"/>
          <ac:cxnSpMkLst>
            <pc:docMk/>
            <pc:sldMk cId="1166010794" sldId="258"/>
            <ac:cxnSpMk id="61" creationId="{FA30DAB8-32C8-46F9-BCD7-E89DC209A396}"/>
          </ac:cxnSpMkLst>
        </pc:cxnChg>
        <pc:cxnChg chg="add">
          <ac:chgData name="Tekle Pauzaite" userId="06f7e524-8501-4f81-9b2a-484f6f2c7061" providerId="ADAL" clId="{C1BD3705-653B-4DD1-94D0-B1412E4052A7}" dt="2024-04-09T07:32:14.424" v="285"/>
          <ac:cxnSpMkLst>
            <pc:docMk/>
            <pc:sldMk cId="1166010794" sldId="258"/>
            <ac:cxnSpMk id="127" creationId="{DF42FFF2-665A-4029-B3B4-8BAEC784FC4F}"/>
          </ac:cxnSpMkLst>
        </pc:cxnChg>
        <pc:cxnChg chg="add">
          <ac:chgData name="Tekle Pauzaite" userId="06f7e524-8501-4f81-9b2a-484f6f2c7061" providerId="ADAL" clId="{C1BD3705-653B-4DD1-94D0-B1412E4052A7}" dt="2024-04-09T07:32:14.424" v="285"/>
          <ac:cxnSpMkLst>
            <pc:docMk/>
            <pc:sldMk cId="1166010794" sldId="258"/>
            <ac:cxnSpMk id="128" creationId="{5550F1D2-E603-498B-933D-7624A604EFBF}"/>
          </ac:cxnSpMkLst>
        </pc:cxnChg>
        <pc:cxnChg chg="add">
          <ac:chgData name="Tekle Pauzaite" userId="06f7e524-8501-4f81-9b2a-484f6f2c7061" providerId="ADAL" clId="{C1BD3705-653B-4DD1-94D0-B1412E4052A7}" dt="2024-04-09T07:32:14.424" v="285"/>
          <ac:cxnSpMkLst>
            <pc:docMk/>
            <pc:sldMk cId="1166010794" sldId="258"/>
            <ac:cxnSpMk id="129" creationId="{0D7A1B0C-CB0B-483A-9ED4-C0891E17674F}"/>
          </ac:cxnSpMkLst>
        </pc:cxnChg>
        <pc:cxnChg chg="add">
          <ac:chgData name="Tekle Pauzaite" userId="06f7e524-8501-4f81-9b2a-484f6f2c7061" providerId="ADAL" clId="{C1BD3705-653B-4DD1-94D0-B1412E4052A7}" dt="2024-04-09T07:32:14.424" v="285"/>
          <ac:cxnSpMkLst>
            <pc:docMk/>
            <pc:sldMk cId="1166010794" sldId="258"/>
            <ac:cxnSpMk id="130" creationId="{996F58D4-690B-4231-82E1-F5DF9688D991}"/>
          </ac:cxnSpMkLst>
        </pc:cxnChg>
        <pc:cxnChg chg="add">
          <ac:chgData name="Tekle Pauzaite" userId="06f7e524-8501-4f81-9b2a-484f6f2c7061" providerId="ADAL" clId="{C1BD3705-653B-4DD1-94D0-B1412E4052A7}" dt="2024-04-09T07:32:14.424" v="285"/>
          <ac:cxnSpMkLst>
            <pc:docMk/>
            <pc:sldMk cId="1166010794" sldId="258"/>
            <ac:cxnSpMk id="131" creationId="{7819BCE1-1C52-4D08-B81A-FA5A1B21DBD7}"/>
          </ac:cxnSpMkLst>
        </pc:cxnChg>
        <pc:cxnChg chg="add">
          <ac:chgData name="Tekle Pauzaite" userId="06f7e524-8501-4f81-9b2a-484f6f2c7061" providerId="ADAL" clId="{C1BD3705-653B-4DD1-94D0-B1412E4052A7}" dt="2024-04-09T07:32:14.424" v="285"/>
          <ac:cxnSpMkLst>
            <pc:docMk/>
            <pc:sldMk cId="1166010794" sldId="258"/>
            <ac:cxnSpMk id="132" creationId="{B3AE4649-AB0D-4E0B-9E6C-770F1152F3A1}"/>
          </ac:cxnSpMkLst>
        </pc:cxnChg>
        <pc:cxnChg chg="add">
          <ac:chgData name="Tekle Pauzaite" userId="06f7e524-8501-4f81-9b2a-484f6f2c7061" providerId="ADAL" clId="{C1BD3705-653B-4DD1-94D0-B1412E4052A7}" dt="2024-04-09T07:32:14.424" v="285"/>
          <ac:cxnSpMkLst>
            <pc:docMk/>
            <pc:sldMk cId="1166010794" sldId="258"/>
            <ac:cxnSpMk id="133" creationId="{8E903628-446E-4894-AFE4-725EFBBB7B6B}"/>
          </ac:cxnSpMkLst>
        </pc:cxnChg>
        <pc:cxnChg chg="add">
          <ac:chgData name="Tekle Pauzaite" userId="06f7e524-8501-4f81-9b2a-484f6f2c7061" providerId="ADAL" clId="{C1BD3705-653B-4DD1-94D0-B1412E4052A7}" dt="2024-04-09T07:32:14.424" v="285"/>
          <ac:cxnSpMkLst>
            <pc:docMk/>
            <pc:sldMk cId="1166010794" sldId="258"/>
            <ac:cxnSpMk id="134" creationId="{F0B4AF61-9A85-4A38-B24F-49207A25AD0C}"/>
          </ac:cxnSpMkLst>
        </pc:cxnChg>
      </pc:sldChg>
      <pc:sldChg chg="addSp delSp modSp add">
        <pc:chgData name="Tekle Pauzaite" userId="06f7e524-8501-4f81-9b2a-484f6f2c7061" providerId="ADAL" clId="{C1BD3705-653B-4DD1-94D0-B1412E4052A7}" dt="2024-04-22T09:51:35.514" v="517" actId="732"/>
        <pc:sldMkLst>
          <pc:docMk/>
          <pc:sldMk cId="2914147878" sldId="259"/>
        </pc:sldMkLst>
        <pc:spChg chg="add mod">
          <ac:chgData name="Tekle Pauzaite" userId="06f7e524-8501-4f81-9b2a-484f6f2c7061" providerId="ADAL" clId="{C1BD3705-653B-4DD1-94D0-B1412E4052A7}" dt="2024-04-22T07:18:42.733" v="365" actId="1037"/>
          <ac:spMkLst>
            <pc:docMk/>
            <pc:sldMk cId="2914147878" sldId="259"/>
            <ac:spMk id="2" creationId="{8734FC90-8854-47D4-BE93-3F5E9FEC13AE}"/>
          </ac:spMkLst>
        </pc:spChg>
        <pc:spChg chg="add del mod">
          <ac:chgData name="Tekle Pauzaite" userId="06f7e524-8501-4f81-9b2a-484f6f2c7061" providerId="ADAL" clId="{C1BD3705-653B-4DD1-94D0-B1412E4052A7}" dt="2024-04-22T07:22:56.962" v="446" actId="478"/>
          <ac:spMkLst>
            <pc:docMk/>
            <pc:sldMk cId="2914147878" sldId="259"/>
            <ac:spMk id="3" creationId="{288838CE-E8FB-4407-9B79-A9E6F5F2E056}"/>
          </ac:spMkLst>
        </pc:spChg>
        <pc:spChg chg="add mod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4" creationId="{93BD820B-8E68-493C-B76E-23113552F65C}"/>
          </ac:spMkLst>
        </pc:spChg>
        <pc:spChg chg="add del mod">
          <ac:chgData name="Tekle Pauzaite" userId="06f7e524-8501-4f81-9b2a-484f6f2c7061" providerId="ADAL" clId="{C1BD3705-653B-4DD1-94D0-B1412E4052A7}" dt="2024-04-22T07:23:33.124" v="503" actId="478"/>
          <ac:spMkLst>
            <pc:docMk/>
            <pc:sldMk cId="2914147878" sldId="259"/>
            <ac:spMk id="5" creationId="{6870EC3F-C8ED-46C8-9BA1-C391757B23E6}"/>
          </ac:spMkLst>
        </pc:spChg>
        <pc:spChg chg="add mod">
          <ac:chgData name="Tekle Pauzaite" userId="06f7e524-8501-4f81-9b2a-484f6f2c7061" providerId="ADAL" clId="{C1BD3705-653B-4DD1-94D0-B1412E4052A7}" dt="2024-04-22T07:18:42.733" v="365" actId="1037"/>
          <ac:spMkLst>
            <pc:docMk/>
            <pc:sldMk cId="2914147878" sldId="259"/>
            <ac:spMk id="11" creationId="{61E137A7-FD28-426F-8D30-8DF5C480DEEB}"/>
          </ac:spMkLst>
        </pc:spChg>
        <pc:spChg chg="add mod">
          <ac:chgData name="Tekle Pauzaite" userId="06f7e524-8501-4f81-9b2a-484f6f2c7061" providerId="ADAL" clId="{C1BD3705-653B-4DD1-94D0-B1412E4052A7}" dt="2024-04-22T07:24:49.013" v="511" actId="1076"/>
          <ac:spMkLst>
            <pc:docMk/>
            <pc:sldMk cId="2914147878" sldId="259"/>
            <ac:spMk id="12" creationId="{8E05C580-299D-46A7-8C39-96D8F8D44CD3}"/>
          </ac:spMkLst>
        </pc:spChg>
        <pc:spChg chg="add mod">
          <ac:chgData name="Tekle Pauzaite" userId="06f7e524-8501-4f81-9b2a-484f6f2c7061" providerId="ADAL" clId="{C1BD3705-653B-4DD1-94D0-B1412E4052A7}" dt="2024-04-22T07:24:49.013" v="511" actId="1076"/>
          <ac:spMkLst>
            <pc:docMk/>
            <pc:sldMk cId="2914147878" sldId="259"/>
            <ac:spMk id="13" creationId="{FD54BF46-CD46-4941-96E0-F4BCA428DC55}"/>
          </ac:spMkLst>
        </pc:spChg>
        <pc:spChg chg="add mod">
          <ac:chgData name="Tekle Pauzaite" userId="06f7e524-8501-4f81-9b2a-484f6f2c7061" providerId="ADAL" clId="{C1BD3705-653B-4DD1-94D0-B1412E4052A7}" dt="2024-04-22T07:24:49.013" v="511" actId="1076"/>
          <ac:spMkLst>
            <pc:docMk/>
            <pc:sldMk cId="2914147878" sldId="259"/>
            <ac:spMk id="14" creationId="{F7C3226C-EA00-4500-9D61-F3985A09F35B}"/>
          </ac:spMkLst>
        </pc:spChg>
        <pc:spChg chg="add mod">
          <ac:chgData name="Tekle Pauzaite" userId="06f7e524-8501-4f81-9b2a-484f6f2c7061" providerId="ADAL" clId="{C1BD3705-653B-4DD1-94D0-B1412E4052A7}" dt="2024-04-22T07:24:49.013" v="511" actId="1076"/>
          <ac:spMkLst>
            <pc:docMk/>
            <pc:sldMk cId="2914147878" sldId="259"/>
            <ac:spMk id="15" creationId="{EB59DAE1-1D54-4E96-A82F-61809B6D4121}"/>
          </ac:spMkLst>
        </pc:spChg>
        <pc:spChg chg="add mod">
          <ac:chgData name="Tekle Pauzaite" userId="06f7e524-8501-4f81-9b2a-484f6f2c7061" providerId="ADAL" clId="{C1BD3705-653B-4DD1-94D0-B1412E4052A7}" dt="2024-04-22T07:18:42.733" v="365" actId="1037"/>
          <ac:spMkLst>
            <pc:docMk/>
            <pc:sldMk cId="2914147878" sldId="259"/>
            <ac:spMk id="16" creationId="{9C26A100-B94F-4708-AAEA-161506753476}"/>
          </ac:spMkLst>
        </pc:spChg>
        <pc:spChg chg="add mod">
          <ac:chgData name="Tekle Pauzaite" userId="06f7e524-8501-4f81-9b2a-484f6f2c7061" providerId="ADAL" clId="{C1BD3705-653B-4DD1-94D0-B1412E4052A7}" dt="2024-04-22T07:18:42.733" v="365" actId="1037"/>
          <ac:spMkLst>
            <pc:docMk/>
            <pc:sldMk cId="2914147878" sldId="259"/>
            <ac:spMk id="17" creationId="{DEF8A444-5C0F-4DFF-91D2-4677D283D036}"/>
          </ac:spMkLst>
        </pc:spChg>
        <pc:spChg chg="add mod">
          <ac:chgData name="Tekle Pauzaite" userId="06f7e524-8501-4f81-9b2a-484f6f2c7061" providerId="ADAL" clId="{C1BD3705-653B-4DD1-94D0-B1412E4052A7}" dt="2024-04-22T07:18:42.733" v="365" actId="1037"/>
          <ac:spMkLst>
            <pc:docMk/>
            <pc:sldMk cId="2914147878" sldId="259"/>
            <ac:spMk id="18" creationId="{42F2A8E5-2ABE-44A9-8074-A9195D7BA379}"/>
          </ac:spMkLst>
        </pc:spChg>
        <pc:spChg chg="add mod">
          <ac:chgData name="Tekle Pauzaite" userId="06f7e524-8501-4f81-9b2a-484f6f2c7061" providerId="ADAL" clId="{C1BD3705-653B-4DD1-94D0-B1412E4052A7}" dt="2024-04-22T07:18:42.733" v="365" actId="1037"/>
          <ac:spMkLst>
            <pc:docMk/>
            <pc:sldMk cId="2914147878" sldId="259"/>
            <ac:spMk id="19" creationId="{7B8ECAC4-BD7D-420C-AE1E-4DABBF763196}"/>
          </ac:spMkLst>
        </pc:spChg>
        <pc:spChg chg="add mod">
          <ac:chgData name="Tekle Pauzaite" userId="06f7e524-8501-4f81-9b2a-484f6f2c7061" providerId="ADAL" clId="{C1BD3705-653B-4DD1-94D0-B1412E4052A7}" dt="2024-04-22T07:24:49.013" v="511" actId="1076"/>
          <ac:spMkLst>
            <pc:docMk/>
            <pc:sldMk cId="2914147878" sldId="259"/>
            <ac:spMk id="20" creationId="{5035A396-C261-4557-A863-63F5AD87907A}"/>
          </ac:spMkLst>
        </pc:spChg>
        <pc:spChg chg="add mod">
          <ac:chgData name="Tekle Pauzaite" userId="06f7e524-8501-4f81-9b2a-484f6f2c7061" providerId="ADAL" clId="{C1BD3705-653B-4DD1-94D0-B1412E4052A7}" dt="2024-04-22T07:18:42.733" v="365" actId="1037"/>
          <ac:spMkLst>
            <pc:docMk/>
            <pc:sldMk cId="2914147878" sldId="259"/>
            <ac:spMk id="21" creationId="{F4747989-D866-4BA6-B6D1-40785493644D}"/>
          </ac:spMkLst>
        </pc:spChg>
        <pc:spChg chg="add mod">
          <ac:chgData name="Tekle Pauzaite" userId="06f7e524-8501-4f81-9b2a-484f6f2c7061" providerId="ADAL" clId="{C1BD3705-653B-4DD1-94D0-B1412E4052A7}" dt="2024-04-22T07:24:49.013" v="511" actId="1076"/>
          <ac:spMkLst>
            <pc:docMk/>
            <pc:sldMk cId="2914147878" sldId="259"/>
            <ac:spMk id="22" creationId="{C5B0212C-DD01-4337-B48D-BD76B4B8C877}"/>
          </ac:spMkLst>
        </pc:spChg>
        <pc:spChg chg="add mod">
          <ac:chgData name="Tekle Pauzaite" userId="06f7e524-8501-4f81-9b2a-484f6f2c7061" providerId="ADAL" clId="{C1BD3705-653B-4DD1-94D0-B1412E4052A7}" dt="2024-04-22T07:24:49.013" v="511" actId="1076"/>
          <ac:spMkLst>
            <pc:docMk/>
            <pc:sldMk cId="2914147878" sldId="259"/>
            <ac:spMk id="23" creationId="{E2316EBE-00EB-4573-A2EE-9248C3C39A66}"/>
          </ac:spMkLst>
        </pc:spChg>
        <pc:spChg chg="add del mod">
          <ac:chgData name="Tekle Pauzaite" userId="06f7e524-8501-4f81-9b2a-484f6f2c7061" providerId="ADAL" clId="{C1BD3705-653B-4DD1-94D0-B1412E4052A7}" dt="2024-04-22T07:22:56.962" v="446" actId="478"/>
          <ac:spMkLst>
            <pc:docMk/>
            <pc:sldMk cId="2914147878" sldId="259"/>
            <ac:spMk id="24" creationId="{CB446922-1B1D-46B6-8C6B-0812EB7EC93C}"/>
          </ac:spMkLst>
        </pc:spChg>
        <pc:spChg chg="add del mod">
          <ac:chgData name="Tekle Pauzaite" userId="06f7e524-8501-4f81-9b2a-484f6f2c7061" providerId="ADAL" clId="{C1BD3705-653B-4DD1-94D0-B1412E4052A7}" dt="2024-04-22T07:22:56.962" v="446" actId="478"/>
          <ac:spMkLst>
            <pc:docMk/>
            <pc:sldMk cId="2914147878" sldId="259"/>
            <ac:spMk id="25" creationId="{E5F5853A-9F00-4825-9B3A-94173E814ABA}"/>
          </ac:spMkLst>
        </pc:spChg>
        <pc:spChg chg="add del mod">
          <ac:chgData name="Tekle Pauzaite" userId="06f7e524-8501-4f81-9b2a-484f6f2c7061" providerId="ADAL" clId="{C1BD3705-653B-4DD1-94D0-B1412E4052A7}" dt="2024-04-22T07:22:56.962" v="446" actId="478"/>
          <ac:spMkLst>
            <pc:docMk/>
            <pc:sldMk cId="2914147878" sldId="259"/>
            <ac:spMk id="26" creationId="{C83E73D7-E640-4AD7-AD94-6EFB52FDF0C5}"/>
          </ac:spMkLst>
        </pc:spChg>
        <pc:spChg chg="add del mod">
          <ac:chgData name="Tekle Pauzaite" userId="06f7e524-8501-4f81-9b2a-484f6f2c7061" providerId="ADAL" clId="{C1BD3705-653B-4DD1-94D0-B1412E4052A7}" dt="2024-04-22T07:22:56.962" v="446" actId="478"/>
          <ac:spMkLst>
            <pc:docMk/>
            <pc:sldMk cId="2914147878" sldId="259"/>
            <ac:spMk id="27" creationId="{CC3994CE-AA94-4C0E-A106-3337B3201DAD}"/>
          </ac:spMkLst>
        </pc:spChg>
        <pc:spChg chg="add del mod">
          <ac:chgData name="Tekle Pauzaite" userId="06f7e524-8501-4f81-9b2a-484f6f2c7061" providerId="ADAL" clId="{C1BD3705-653B-4DD1-94D0-B1412E4052A7}" dt="2024-04-22T07:22:56.962" v="446" actId="478"/>
          <ac:spMkLst>
            <pc:docMk/>
            <pc:sldMk cId="2914147878" sldId="259"/>
            <ac:spMk id="28" creationId="{31661F82-7223-436D-A0F0-555A92D89BC3}"/>
          </ac:spMkLst>
        </pc:spChg>
        <pc:spChg chg="add del mod">
          <ac:chgData name="Tekle Pauzaite" userId="06f7e524-8501-4f81-9b2a-484f6f2c7061" providerId="ADAL" clId="{C1BD3705-653B-4DD1-94D0-B1412E4052A7}" dt="2024-04-22T07:22:56.962" v="446" actId="478"/>
          <ac:spMkLst>
            <pc:docMk/>
            <pc:sldMk cId="2914147878" sldId="259"/>
            <ac:spMk id="29" creationId="{E7DB6AD7-5775-4A27-B07E-75A2E82F9167}"/>
          </ac:spMkLst>
        </pc:spChg>
        <pc:spChg chg="add mod">
          <ac:chgData name="Tekle Pauzaite" userId="06f7e524-8501-4f81-9b2a-484f6f2c7061" providerId="ADAL" clId="{C1BD3705-653B-4DD1-94D0-B1412E4052A7}" dt="2024-04-22T07:25:20.814" v="515" actId="554"/>
          <ac:spMkLst>
            <pc:docMk/>
            <pc:sldMk cId="2914147878" sldId="259"/>
            <ac:spMk id="30" creationId="{9D56151C-CD60-4710-9D54-09248EE6E06D}"/>
          </ac:spMkLst>
        </pc:spChg>
        <pc:spChg chg="add mod">
          <ac:chgData name="Tekle Pauzaite" userId="06f7e524-8501-4f81-9b2a-484f6f2c7061" providerId="ADAL" clId="{C1BD3705-653B-4DD1-94D0-B1412E4052A7}" dt="2024-04-22T07:18:23.459" v="322" actId="1076"/>
          <ac:spMkLst>
            <pc:docMk/>
            <pc:sldMk cId="2914147878" sldId="259"/>
            <ac:spMk id="39" creationId="{EF461547-E94D-4BF7-ABCB-D101891791F8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40" creationId="{4DB3DE37-555C-42D6-AE6B-11FCC90112B9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41" creationId="{793725C8-0AAC-470B-B27F-E86F4D1E3BB5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42" creationId="{1962D5E0-B414-4151-BC0F-DB059FE755E2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43" creationId="{20206A82-8AB1-47B0-A401-19DCC915E7C9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44" creationId="{19F0D4C1-1FCA-4236-AE7A-C33071B3C82B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45" creationId="{718024B8-D194-4F1B-92AB-878D8AB42F79}"/>
          </ac:spMkLst>
        </pc:spChg>
        <pc:spChg chg="add del mod">
          <ac:chgData name="Tekle Pauzaite" userId="06f7e524-8501-4f81-9b2a-484f6f2c7061" providerId="ADAL" clId="{C1BD3705-653B-4DD1-94D0-B1412E4052A7}" dt="2024-04-22T07:23:33.124" v="503" actId="478"/>
          <ac:spMkLst>
            <pc:docMk/>
            <pc:sldMk cId="2914147878" sldId="259"/>
            <ac:spMk id="46" creationId="{32F779B3-C9D5-4EF6-856E-C531FEB6B31C}"/>
          </ac:spMkLst>
        </pc:spChg>
        <pc:spChg chg="add del mod">
          <ac:chgData name="Tekle Pauzaite" userId="06f7e524-8501-4f81-9b2a-484f6f2c7061" providerId="ADAL" clId="{C1BD3705-653B-4DD1-94D0-B1412E4052A7}" dt="2024-04-22T07:23:33.124" v="503" actId="478"/>
          <ac:spMkLst>
            <pc:docMk/>
            <pc:sldMk cId="2914147878" sldId="259"/>
            <ac:spMk id="47" creationId="{BD15F38E-35C5-46AC-8220-9868CAD05A37}"/>
          </ac:spMkLst>
        </pc:spChg>
        <pc:spChg chg="add del mod">
          <ac:chgData name="Tekle Pauzaite" userId="06f7e524-8501-4f81-9b2a-484f6f2c7061" providerId="ADAL" clId="{C1BD3705-653B-4DD1-94D0-B1412E4052A7}" dt="2024-04-22T07:23:33.124" v="503" actId="478"/>
          <ac:spMkLst>
            <pc:docMk/>
            <pc:sldMk cId="2914147878" sldId="259"/>
            <ac:spMk id="48" creationId="{C62DC79D-4652-4CFF-9411-46AE6E70B3C9}"/>
          </ac:spMkLst>
        </pc:spChg>
        <pc:spChg chg="add del mod">
          <ac:chgData name="Tekle Pauzaite" userId="06f7e524-8501-4f81-9b2a-484f6f2c7061" providerId="ADAL" clId="{C1BD3705-653B-4DD1-94D0-B1412E4052A7}" dt="2024-04-22T07:23:33.124" v="503" actId="478"/>
          <ac:spMkLst>
            <pc:docMk/>
            <pc:sldMk cId="2914147878" sldId="259"/>
            <ac:spMk id="49" creationId="{70ADA700-F26B-41AA-80E0-CEDA4C014D62}"/>
          </ac:spMkLst>
        </pc:spChg>
        <pc:spChg chg="add del mod">
          <ac:chgData name="Tekle Pauzaite" userId="06f7e524-8501-4f81-9b2a-484f6f2c7061" providerId="ADAL" clId="{C1BD3705-653B-4DD1-94D0-B1412E4052A7}" dt="2024-04-22T07:23:33.124" v="503" actId="478"/>
          <ac:spMkLst>
            <pc:docMk/>
            <pc:sldMk cId="2914147878" sldId="259"/>
            <ac:spMk id="50" creationId="{0C499B74-F5D3-4E81-8396-171B3E620FD7}"/>
          </ac:spMkLst>
        </pc:spChg>
        <pc:spChg chg="add del mod">
          <ac:chgData name="Tekle Pauzaite" userId="06f7e524-8501-4f81-9b2a-484f6f2c7061" providerId="ADAL" clId="{C1BD3705-653B-4DD1-94D0-B1412E4052A7}" dt="2024-04-22T07:23:33.124" v="503" actId="478"/>
          <ac:spMkLst>
            <pc:docMk/>
            <pc:sldMk cId="2914147878" sldId="259"/>
            <ac:spMk id="51" creationId="{4B20E483-AF4B-41A2-980C-DAEEEA2AD311}"/>
          </ac:spMkLst>
        </pc:spChg>
        <pc:spChg chg="add mod">
          <ac:chgData name="Tekle Pauzaite" userId="06f7e524-8501-4f81-9b2a-484f6f2c7061" providerId="ADAL" clId="{C1BD3705-653B-4DD1-94D0-B1412E4052A7}" dt="2024-04-22T07:24:49.013" v="511" actId="1076"/>
          <ac:spMkLst>
            <pc:docMk/>
            <pc:sldMk cId="2914147878" sldId="259"/>
            <ac:spMk id="52" creationId="{66935BCD-2413-4A20-869F-8E6F45A984DC}"/>
          </ac:spMkLst>
        </pc:spChg>
        <pc:spChg chg="add mod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62" creationId="{CEC6835D-868A-42BE-A63A-BC75442293F5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63" creationId="{0206356E-3197-4487-8009-2F1C252C219C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64" creationId="{39D0107C-A578-48C1-83A1-CCDE47B45640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65" creationId="{E0B724B5-35B0-481E-8105-392B8963732A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66" creationId="{913B8CFD-8EF8-4558-B0B9-854C726D9D28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67" creationId="{698923BC-6BD0-44CD-B118-27CAE91BD95C}"/>
          </ac:spMkLst>
        </pc:spChg>
        <pc:spChg chg="add mod topLvl">
          <ac:chgData name="Tekle Pauzaite" userId="06f7e524-8501-4f81-9b2a-484f6f2c7061" providerId="ADAL" clId="{C1BD3705-653B-4DD1-94D0-B1412E4052A7}" dt="2024-04-22T07:23:38.363" v="504" actId="164"/>
          <ac:spMkLst>
            <pc:docMk/>
            <pc:sldMk cId="2914147878" sldId="259"/>
            <ac:spMk id="68" creationId="{09DB8CDD-9C69-41EE-94C3-81A5F7C4A416}"/>
          </ac:spMkLst>
        </pc:spChg>
        <pc:grpChg chg="add del mod">
          <ac:chgData name="Tekle Pauzaite" userId="06f7e524-8501-4f81-9b2a-484f6f2c7061" providerId="ADAL" clId="{C1BD3705-653B-4DD1-94D0-B1412E4052A7}" dt="2024-04-22T07:22:30.894" v="428" actId="165"/>
          <ac:grpSpMkLst>
            <pc:docMk/>
            <pc:sldMk cId="2914147878" sldId="259"/>
            <ac:grpSpMk id="70" creationId="{4DC5AF10-16C9-49C3-823A-B724DC6F121A}"/>
          </ac:grpSpMkLst>
        </pc:grpChg>
        <pc:grpChg chg="add del mod">
          <ac:chgData name="Tekle Pauzaite" userId="06f7e524-8501-4f81-9b2a-484f6f2c7061" providerId="ADAL" clId="{C1BD3705-653B-4DD1-94D0-B1412E4052A7}" dt="2024-04-22T07:22:23.269" v="426" actId="165"/>
          <ac:grpSpMkLst>
            <pc:docMk/>
            <pc:sldMk cId="2914147878" sldId="259"/>
            <ac:grpSpMk id="71" creationId="{BB5296EF-8D2F-4905-806B-1A9264D32ABF}"/>
          </ac:grpSpMkLst>
        </pc:grpChg>
        <pc:grpChg chg="add mod">
          <ac:chgData name="Tekle Pauzaite" userId="06f7e524-8501-4f81-9b2a-484f6f2c7061" providerId="ADAL" clId="{C1BD3705-653B-4DD1-94D0-B1412E4052A7}" dt="2024-04-22T07:25:26.044" v="516" actId="554"/>
          <ac:grpSpMkLst>
            <pc:docMk/>
            <pc:sldMk cId="2914147878" sldId="259"/>
            <ac:grpSpMk id="72" creationId="{F8618A66-573F-455A-8D06-2B6DB5F846D8}"/>
          </ac:grpSpMkLst>
        </pc:grpChg>
        <pc:grpChg chg="add mod">
          <ac:chgData name="Tekle Pauzaite" userId="06f7e524-8501-4f81-9b2a-484f6f2c7061" providerId="ADAL" clId="{C1BD3705-653B-4DD1-94D0-B1412E4052A7}" dt="2024-04-22T07:25:26.044" v="516" actId="554"/>
          <ac:grpSpMkLst>
            <pc:docMk/>
            <pc:sldMk cId="2914147878" sldId="259"/>
            <ac:grpSpMk id="73" creationId="{273E6418-4505-4195-BE7F-CAE8A6355D09}"/>
          </ac:grpSpMkLst>
        </pc:grpChg>
        <pc:grpChg chg="add mod">
          <ac:chgData name="Tekle Pauzaite" userId="06f7e524-8501-4f81-9b2a-484f6f2c7061" providerId="ADAL" clId="{C1BD3705-653B-4DD1-94D0-B1412E4052A7}" dt="2024-04-22T07:25:26.044" v="516" actId="554"/>
          <ac:grpSpMkLst>
            <pc:docMk/>
            <pc:sldMk cId="2914147878" sldId="259"/>
            <ac:grpSpMk id="90" creationId="{3DDED18B-F741-4B24-9CB4-20FA5A0429D9}"/>
          </ac:grpSpMkLst>
        </pc:grpChg>
        <pc:picChg chg="add mod modCrop">
          <ac:chgData name="Tekle Pauzaite" userId="06f7e524-8501-4f81-9b2a-484f6f2c7061" providerId="ADAL" clId="{C1BD3705-653B-4DD1-94D0-B1412E4052A7}" dt="2024-04-22T09:51:35.514" v="517" actId="732"/>
          <ac:picMkLst>
            <pc:docMk/>
            <pc:sldMk cId="2914147878" sldId="259"/>
            <ac:picMk id="6" creationId="{37ED018B-AAC5-4F88-8FF6-C08A2502F69C}"/>
          </ac:picMkLst>
        </pc:picChg>
        <pc:picChg chg="add mod modCrop">
          <ac:chgData name="Tekle Pauzaite" userId="06f7e524-8501-4f81-9b2a-484f6f2c7061" providerId="ADAL" clId="{C1BD3705-653B-4DD1-94D0-B1412E4052A7}" dt="2024-04-22T07:25:20.814" v="515" actId="554"/>
          <ac:picMkLst>
            <pc:docMk/>
            <pc:sldMk cId="2914147878" sldId="259"/>
            <ac:picMk id="7" creationId="{AB309136-C1B6-47C8-BF73-41E197839252}"/>
          </ac:picMkLst>
        </pc:picChg>
        <pc:picChg chg="add mod">
          <ac:chgData name="Tekle Pauzaite" userId="06f7e524-8501-4f81-9b2a-484f6f2c7061" providerId="ADAL" clId="{C1BD3705-653B-4DD1-94D0-B1412E4052A7}" dt="2024-04-22T07:25:20.814" v="515" actId="554"/>
          <ac:picMkLst>
            <pc:docMk/>
            <pc:sldMk cId="2914147878" sldId="259"/>
            <ac:picMk id="8" creationId="{9FED2DBF-2310-4192-ACAB-B981D411943C}"/>
          </ac:picMkLst>
        </pc:picChg>
        <pc:picChg chg="add mod">
          <ac:chgData name="Tekle Pauzaite" userId="06f7e524-8501-4f81-9b2a-484f6f2c7061" providerId="ADAL" clId="{C1BD3705-653B-4DD1-94D0-B1412E4052A7}" dt="2024-04-22T07:25:20.814" v="515" actId="554"/>
          <ac:picMkLst>
            <pc:docMk/>
            <pc:sldMk cId="2914147878" sldId="259"/>
            <ac:picMk id="9" creationId="{ADD099F0-8F0F-4C06-8024-A1A232020D00}"/>
          </ac:picMkLst>
        </pc:picChg>
        <pc:picChg chg="add mod">
          <ac:chgData name="Tekle Pauzaite" userId="06f7e524-8501-4f81-9b2a-484f6f2c7061" providerId="ADAL" clId="{C1BD3705-653B-4DD1-94D0-B1412E4052A7}" dt="2024-04-22T07:25:20.814" v="515" actId="554"/>
          <ac:picMkLst>
            <pc:docMk/>
            <pc:sldMk cId="2914147878" sldId="259"/>
            <ac:picMk id="10" creationId="{3980784D-D855-4399-AF96-9B54779D70DE}"/>
          </ac:picMkLst>
        </pc:picChg>
        <pc:picChg chg="add mod modCrop">
          <ac:chgData name="Tekle Pauzaite" userId="06f7e524-8501-4f81-9b2a-484f6f2c7061" providerId="ADAL" clId="{C1BD3705-653B-4DD1-94D0-B1412E4052A7}" dt="2024-04-22T07:19:05.556" v="367" actId="732"/>
          <ac:picMkLst>
            <pc:docMk/>
            <pc:sldMk cId="2914147878" sldId="259"/>
            <ac:picMk id="31" creationId="{56369981-9738-411A-9A7F-64342FCABE10}"/>
          </ac:picMkLst>
        </pc:picChg>
        <pc:picChg chg="add mod modCrop">
          <ac:chgData name="Tekle Pauzaite" userId="06f7e524-8501-4f81-9b2a-484f6f2c7061" providerId="ADAL" clId="{C1BD3705-653B-4DD1-94D0-B1412E4052A7}" dt="2024-04-22T07:19:12.306" v="368" actId="732"/>
          <ac:picMkLst>
            <pc:docMk/>
            <pc:sldMk cId="2914147878" sldId="259"/>
            <ac:picMk id="32" creationId="{96B01267-D704-427F-B0B6-F4DB5E5ECDF4}"/>
          </ac:picMkLst>
        </pc:picChg>
        <pc:picChg chg="add mod modCrop">
          <ac:chgData name="Tekle Pauzaite" userId="06f7e524-8501-4f81-9b2a-484f6f2c7061" providerId="ADAL" clId="{C1BD3705-653B-4DD1-94D0-B1412E4052A7}" dt="2024-04-22T07:19:24.332" v="370" actId="14100"/>
          <ac:picMkLst>
            <pc:docMk/>
            <pc:sldMk cId="2914147878" sldId="259"/>
            <ac:picMk id="33" creationId="{31FDFDB3-C1BE-494F-A429-D25D3C98C697}"/>
          </ac:picMkLst>
        </pc:picChg>
        <pc:picChg chg="add mod modCrop">
          <ac:chgData name="Tekle Pauzaite" userId="06f7e524-8501-4f81-9b2a-484f6f2c7061" providerId="ADAL" clId="{C1BD3705-653B-4DD1-94D0-B1412E4052A7}" dt="2024-04-22T07:19:00.490" v="366" actId="732"/>
          <ac:picMkLst>
            <pc:docMk/>
            <pc:sldMk cId="2914147878" sldId="259"/>
            <ac:picMk id="34" creationId="{C108F59D-5721-431C-87CD-35416080BA54}"/>
          </ac:picMkLst>
        </pc:picChg>
        <pc:picChg chg="add mod modCrop">
          <ac:chgData name="Tekle Pauzaite" userId="06f7e524-8501-4f81-9b2a-484f6f2c7061" providerId="ADAL" clId="{C1BD3705-653B-4DD1-94D0-B1412E4052A7}" dt="2024-04-22T07:24:49.013" v="511" actId="1076"/>
          <ac:picMkLst>
            <pc:docMk/>
            <pc:sldMk cId="2914147878" sldId="259"/>
            <ac:picMk id="35" creationId="{B592D25E-7363-4862-AE6A-DC2D307A667F}"/>
          </ac:picMkLst>
        </pc:picChg>
        <pc:picChg chg="add mod modCrop">
          <ac:chgData name="Tekle Pauzaite" userId="06f7e524-8501-4f81-9b2a-484f6f2c7061" providerId="ADAL" clId="{C1BD3705-653B-4DD1-94D0-B1412E4052A7}" dt="2024-04-22T07:24:49.013" v="511" actId="1076"/>
          <ac:picMkLst>
            <pc:docMk/>
            <pc:sldMk cId="2914147878" sldId="259"/>
            <ac:picMk id="36" creationId="{7F67C647-5F0E-449B-8567-4FA2890DE48E}"/>
          </ac:picMkLst>
        </pc:picChg>
        <pc:picChg chg="add mod modCrop">
          <ac:chgData name="Tekle Pauzaite" userId="06f7e524-8501-4f81-9b2a-484f6f2c7061" providerId="ADAL" clId="{C1BD3705-653B-4DD1-94D0-B1412E4052A7}" dt="2024-04-22T07:24:49.013" v="511" actId="1076"/>
          <ac:picMkLst>
            <pc:docMk/>
            <pc:sldMk cId="2914147878" sldId="259"/>
            <ac:picMk id="37" creationId="{6219C77B-CBE6-41D0-938B-E592C9D186DF}"/>
          </ac:picMkLst>
        </pc:picChg>
        <pc:picChg chg="add mod modCrop">
          <ac:chgData name="Tekle Pauzaite" userId="06f7e524-8501-4f81-9b2a-484f6f2c7061" providerId="ADAL" clId="{C1BD3705-653B-4DD1-94D0-B1412E4052A7}" dt="2024-04-22T07:24:49.013" v="511" actId="1076"/>
          <ac:picMkLst>
            <pc:docMk/>
            <pc:sldMk cId="2914147878" sldId="259"/>
            <ac:picMk id="38" creationId="{3FFB8692-E38F-4999-9D6D-DA80A5BD71FC}"/>
          </ac:picMkLst>
        </pc:picChg>
        <pc:picChg chg="add mod modCrop">
          <ac:chgData name="Tekle Pauzaite" userId="06f7e524-8501-4f81-9b2a-484f6f2c7061" providerId="ADAL" clId="{C1BD3705-653B-4DD1-94D0-B1412E4052A7}" dt="2024-04-22T07:24:49.013" v="511" actId="1076"/>
          <ac:picMkLst>
            <pc:docMk/>
            <pc:sldMk cId="2914147878" sldId="259"/>
            <ac:picMk id="61" creationId="{529378DC-3F95-4B3B-90E8-AB2D180F5092}"/>
          </ac:picMkLst>
        </pc:picChg>
        <pc:cxnChg chg="add del mod">
          <ac:chgData name="Tekle Pauzaite" userId="06f7e524-8501-4f81-9b2a-484f6f2c7061" providerId="ADAL" clId="{C1BD3705-653B-4DD1-94D0-B1412E4052A7}" dt="2024-04-22T07:22:56.962" v="446" actId="478"/>
          <ac:cxnSpMkLst>
            <pc:docMk/>
            <pc:sldMk cId="2914147878" sldId="259"/>
            <ac:cxnSpMk id="53" creationId="{59B436B7-03D1-47DB-8A91-D907B8534A6A}"/>
          </ac:cxnSpMkLst>
        </pc:cxnChg>
        <pc:cxnChg chg="add mod">
          <ac:chgData name="Tekle Pauzaite" userId="06f7e524-8501-4f81-9b2a-484f6f2c7061" providerId="ADAL" clId="{C1BD3705-653B-4DD1-94D0-B1412E4052A7}" dt="2024-04-22T07:23:38.363" v="504" actId="164"/>
          <ac:cxnSpMkLst>
            <pc:docMk/>
            <pc:sldMk cId="2914147878" sldId="259"/>
            <ac:cxnSpMk id="54" creationId="{9970DCC4-87E1-4D41-BC4B-414C2B56882D}"/>
          </ac:cxnSpMkLst>
        </pc:cxnChg>
        <pc:cxnChg chg="add del mod">
          <ac:chgData name="Tekle Pauzaite" userId="06f7e524-8501-4f81-9b2a-484f6f2c7061" providerId="ADAL" clId="{C1BD3705-653B-4DD1-94D0-B1412E4052A7}" dt="2024-04-22T07:23:33.124" v="503" actId="478"/>
          <ac:cxnSpMkLst>
            <pc:docMk/>
            <pc:sldMk cId="2914147878" sldId="259"/>
            <ac:cxnSpMk id="55" creationId="{817DD1AC-B234-4E89-854B-74A31051A4AA}"/>
          </ac:cxnSpMkLst>
        </pc:cxnChg>
        <pc:cxnChg chg="add mod">
          <ac:chgData name="Tekle Pauzaite" userId="06f7e524-8501-4f81-9b2a-484f6f2c7061" providerId="ADAL" clId="{C1BD3705-653B-4DD1-94D0-B1412E4052A7}" dt="2024-04-22T07:18:42.733" v="365" actId="1037"/>
          <ac:cxnSpMkLst>
            <pc:docMk/>
            <pc:sldMk cId="2914147878" sldId="259"/>
            <ac:cxnSpMk id="56" creationId="{9C3068D5-9446-4720-8606-87C28057D877}"/>
          </ac:cxnSpMkLst>
        </pc:cxnChg>
        <pc:cxnChg chg="add mod">
          <ac:chgData name="Tekle Pauzaite" userId="06f7e524-8501-4f81-9b2a-484f6f2c7061" providerId="ADAL" clId="{C1BD3705-653B-4DD1-94D0-B1412E4052A7}" dt="2024-04-22T07:18:42.733" v="365" actId="1037"/>
          <ac:cxnSpMkLst>
            <pc:docMk/>
            <pc:sldMk cId="2914147878" sldId="259"/>
            <ac:cxnSpMk id="57" creationId="{4A120936-23DA-4714-BCDB-CA196BB59356}"/>
          </ac:cxnSpMkLst>
        </pc:cxnChg>
        <pc:cxnChg chg="add mod">
          <ac:chgData name="Tekle Pauzaite" userId="06f7e524-8501-4f81-9b2a-484f6f2c7061" providerId="ADAL" clId="{C1BD3705-653B-4DD1-94D0-B1412E4052A7}" dt="2024-04-22T07:18:42.733" v="365" actId="1037"/>
          <ac:cxnSpMkLst>
            <pc:docMk/>
            <pc:sldMk cId="2914147878" sldId="259"/>
            <ac:cxnSpMk id="58" creationId="{C3C5D38D-90B0-494F-8F9C-707FF1E5C8C5}"/>
          </ac:cxnSpMkLst>
        </pc:cxnChg>
        <pc:cxnChg chg="add mod">
          <ac:chgData name="Tekle Pauzaite" userId="06f7e524-8501-4f81-9b2a-484f6f2c7061" providerId="ADAL" clId="{C1BD3705-653B-4DD1-94D0-B1412E4052A7}" dt="2024-04-22T07:18:42.733" v="365" actId="1037"/>
          <ac:cxnSpMkLst>
            <pc:docMk/>
            <pc:sldMk cId="2914147878" sldId="259"/>
            <ac:cxnSpMk id="59" creationId="{6534BBB5-9459-4326-95B9-6A4645207B4D}"/>
          </ac:cxnSpMkLst>
        </pc:cxnChg>
        <pc:cxnChg chg="add mod">
          <ac:chgData name="Tekle Pauzaite" userId="06f7e524-8501-4f81-9b2a-484f6f2c7061" providerId="ADAL" clId="{C1BD3705-653B-4DD1-94D0-B1412E4052A7}" dt="2024-04-22T07:18:42.733" v="365" actId="1037"/>
          <ac:cxnSpMkLst>
            <pc:docMk/>
            <pc:sldMk cId="2914147878" sldId="259"/>
            <ac:cxnSpMk id="60" creationId="{E7ADF66F-8A0D-4F4A-B2A3-3FE38C52E779}"/>
          </ac:cxnSpMkLst>
        </pc:cxnChg>
        <pc:cxnChg chg="add mod">
          <ac:chgData name="Tekle Pauzaite" userId="06f7e524-8501-4f81-9b2a-484f6f2c7061" providerId="ADAL" clId="{C1BD3705-653B-4DD1-94D0-B1412E4052A7}" dt="2024-04-22T07:23:38.363" v="504" actId="164"/>
          <ac:cxnSpMkLst>
            <pc:docMk/>
            <pc:sldMk cId="2914147878" sldId="259"/>
            <ac:cxnSpMk id="69" creationId="{370A5F7E-12A6-49CC-A77A-EC651FFF2688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7F1D9-5222-40E8-AE70-CDDEB65B273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1A66C58-E644-40E7-9561-B4A0E26ED73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0FD7C6-3D93-425C-8D83-277F993F6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16035A0-886F-4822-A335-88E65E9601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CC8088E-05F2-48CA-843D-C023514DB3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0636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EC2664-4BAB-4AB2-9A78-0D86431645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394868A-3CCF-4B4A-8CA5-A237A89EC5B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25963F-FD8D-4FF4-8836-8A632C87ADA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6530EDB-6758-4AFA-AD67-B7A1B22BC6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3B71721-09F6-4EEA-9F56-AC93A71D05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217371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AF91120-F665-4028-992D-EAF3F70D8AF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EEBCAD-E925-4754-B679-FDC68B031B9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12183AC-469B-4D39-BFC7-B868F96702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9264FA-5EA2-41E2-85C1-9909B424FB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12F29D-0808-4EAF-B254-5FE7F0F70B1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96919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50AF40-0E1E-4026-ABCA-2861D0BAE82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F80D05-5525-4EAA-9021-8C66FBC674C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8B9DCD-06D8-443A-AFE4-7FDFB77C7D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AA0CBE-1987-4D0C-928F-BF56332182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F28C8B3-9066-48DC-9434-1CE7CEC5F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587674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6CAA7-7A16-4CDE-8E35-4C9920FE1C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3221D7C-49CB-428D-A668-E6FF0298D0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3513E16-8722-4FCD-B8D8-435780B130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54D8B-89AA-4F22-8C7D-1554C26513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42C0A66-37B9-4E2B-91F3-B07C430FA9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934232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EC53B7-20B8-45AB-9CA4-D9762C88B4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CFEBE3-CAE1-4F56-9B0E-70170DC50F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C9C214-37C0-48A5-9A88-0CD9F537B3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3D2FB1-9E43-48FA-973E-E8C9FE1FAF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4B6E5C-A007-4511-88FD-775C6D541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EEA305-79E4-479A-B6B7-401187549E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9148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38C19B-7D5E-41BA-9960-451551EB2F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5C5D0F0-A072-4FA9-9E3A-3C69AC15322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2E9343-A824-414E-860A-F90CEAB4C5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866C20C-5276-49ED-8366-7515C095CF1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731C89B9-FA9E-489D-B6D7-99257DAB5C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C6D59B1A-CE3E-417A-A53B-10F1178339B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A6D346-5009-4EB3-BEC0-6A37B64806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3881F85-D920-442B-A1D7-EF4BA9458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13490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86EB0F-0DFB-4B70-8122-0C2CB65719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26275B-F32F-41FA-AD03-568287752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A4D82BD-88E8-4A43-BF5C-D4B8B9F97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A74ECF15-152D-4B98-B60C-4B27AF5AC3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31279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E8B0577-2004-46AB-9EF1-0C83840D7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756D0E1-53C9-4539-9B13-CCBA5E6C19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0F95B44-20D6-46ED-8834-343C1C0C210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97699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B5603C-0226-4CE1-B77B-4AAC970E9D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5B17047-8935-427B-A3E8-B74FBB601E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CB8F474-16A7-4CD9-93ED-339630EDEA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CD83C83-F274-4B17-83D2-F4B825FF70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6378F3B-33A1-409B-ADEB-EB540221AA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DF300E2-1A0A-4815-AA02-755C9F5291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5949318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A6AFB3-CD37-49CC-9777-C2B40BA1C8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F675789-3CB9-4E89-AE5B-39F7A7A66AB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A3739B3-7DC2-46BD-91B9-E8D5693EDBA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7B78FD-C45D-4A6D-9603-170D0935D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521AF21-216D-4D5C-A8D1-0C0602608C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F0F4E82-1A63-4DD0-82B3-924E3A3C3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5019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FA14D88-741E-44EA-BAD2-FAB69ACFA14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D3EFC4-5B31-42FF-9C00-08A814806A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F7566E-3B30-4811-9343-F6F0D4467E4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C783C3-670C-4BC6-BA70-36202A20CE1F}" type="datetimeFigureOut">
              <a:rPr lang="en-GB" smtClean="0"/>
              <a:t>13/05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86BD52-7C44-43D8-A8F0-2DCB0465D0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BFC3DB-1A5A-4141-B8BC-0525D81E577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BB82873-A6A3-4625-8480-F87E64290D5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814394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g"/><Relationship Id="rId2" Type="http://schemas.openxmlformats.org/officeDocument/2006/relationships/image" Target="../media/image5.jpg"/><Relationship Id="rId1" Type="http://schemas.openxmlformats.org/officeDocument/2006/relationships/slideLayout" Target="../slideLayouts/slideLayout7.xml"/><Relationship Id="rId6" Type="http://schemas.microsoft.com/office/2007/relationships/hdphoto" Target="../media/hdphoto1.wdp"/><Relationship Id="rId5" Type="http://schemas.openxmlformats.org/officeDocument/2006/relationships/image" Target="../media/image7.png"/><Relationship Id="rId4" Type="http://schemas.openxmlformats.org/officeDocument/2006/relationships/image" Target="../media/image3.jp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image" Target="../media/image8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jpg"/><Relationship Id="rId5" Type="http://schemas.openxmlformats.org/officeDocument/2006/relationships/image" Target="../media/image11.jpg"/><Relationship Id="rId4" Type="http://schemas.openxmlformats.org/officeDocument/2006/relationships/image" Target="../media/image10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2DCB1B3-6E4D-48C1-A927-1E9001AF81BC}"/>
              </a:ext>
            </a:extLst>
          </p:cNvPr>
          <p:cNvSpPr txBox="1"/>
          <p:nvPr/>
        </p:nvSpPr>
        <p:spPr>
          <a:xfrm>
            <a:off x="265087" y="1435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31D6F89-6135-4467-B44F-79EEE80AEE6D}"/>
              </a:ext>
            </a:extLst>
          </p:cNvPr>
          <p:cNvSpPr txBox="1"/>
          <p:nvPr/>
        </p:nvSpPr>
        <p:spPr>
          <a:xfrm>
            <a:off x="279350" y="935861"/>
            <a:ext cx="31159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B769342-1227-4779-8DE8-E33A18DD7CE7}"/>
              </a:ext>
            </a:extLst>
          </p:cNvPr>
          <p:cNvSpPr txBox="1"/>
          <p:nvPr/>
        </p:nvSpPr>
        <p:spPr>
          <a:xfrm>
            <a:off x="3919390" y="1376797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9F73E32-8397-4455-B875-C71C50F20DF1}"/>
              </a:ext>
            </a:extLst>
          </p:cNvPr>
          <p:cNvSpPr txBox="1"/>
          <p:nvPr/>
        </p:nvSpPr>
        <p:spPr>
          <a:xfrm>
            <a:off x="3919390" y="1694022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7509851-C412-4B0B-ADD4-710D51E1776F}"/>
              </a:ext>
            </a:extLst>
          </p:cNvPr>
          <p:cNvSpPr txBox="1"/>
          <p:nvPr/>
        </p:nvSpPr>
        <p:spPr>
          <a:xfrm>
            <a:off x="3919390" y="2011246"/>
            <a:ext cx="33808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D585416-F1D5-4C20-B27C-FB9106482BD8}"/>
              </a:ext>
            </a:extLst>
          </p:cNvPr>
          <p:cNvSpPr txBox="1"/>
          <p:nvPr/>
        </p:nvSpPr>
        <p:spPr>
          <a:xfrm>
            <a:off x="3919390" y="2328472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39AD1AB-58E8-4810-A633-AB7ABABD23B8}"/>
              </a:ext>
            </a:extLst>
          </p:cNvPr>
          <p:cNvSpPr txBox="1"/>
          <p:nvPr/>
        </p:nvSpPr>
        <p:spPr>
          <a:xfrm>
            <a:off x="333667" y="1317695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4DD1A2-1BFC-4C19-8438-AB0B7BA08B32}"/>
              </a:ext>
            </a:extLst>
          </p:cNvPr>
          <p:cNvSpPr txBox="1"/>
          <p:nvPr/>
        </p:nvSpPr>
        <p:spPr>
          <a:xfrm>
            <a:off x="333667" y="1618045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E3B608D-B7EC-4AFC-9643-960484573B00}"/>
              </a:ext>
            </a:extLst>
          </p:cNvPr>
          <p:cNvSpPr txBox="1"/>
          <p:nvPr/>
        </p:nvSpPr>
        <p:spPr>
          <a:xfrm>
            <a:off x="333667" y="2031929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737AEE3-E957-44AB-9464-EB2B89DEFFFA}"/>
              </a:ext>
            </a:extLst>
          </p:cNvPr>
          <p:cNvSpPr txBox="1"/>
          <p:nvPr/>
        </p:nvSpPr>
        <p:spPr>
          <a:xfrm>
            <a:off x="333667" y="2310388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DE19C26-AAA7-49F6-BD89-BFA60C002214}"/>
              </a:ext>
            </a:extLst>
          </p:cNvPr>
          <p:cNvSpPr txBox="1"/>
          <p:nvPr/>
        </p:nvSpPr>
        <p:spPr>
          <a:xfrm>
            <a:off x="3919390" y="1055737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8F6730F-D09D-459A-BB00-13E805139004}"/>
              </a:ext>
            </a:extLst>
          </p:cNvPr>
          <p:cNvSpPr txBox="1"/>
          <p:nvPr/>
        </p:nvSpPr>
        <p:spPr>
          <a:xfrm>
            <a:off x="266650" y="775742"/>
            <a:ext cx="32219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4879CFB-F10B-4C40-AD5F-57BC5945B82C}"/>
              </a:ext>
            </a:extLst>
          </p:cNvPr>
          <p:cNvSpPr txBox="1"/>
          <p:nvPr/>
        </p:nvSpPr>
        <p:spPr>
          <a:xfrm>
            <a:off x="3936883" y="803147"/>
            <a:ext cx="783219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63C93F3-01F4-4602-8B21-0A1B3C3BEDBB}"/>
              </a:ext>
            </a:extLst>
          </p:cNvPr>
          <p:cNvSpPr txBox="1"/>
          <p:nvPr/>
        </p:nvSpPr>
        <p:spPr>
          <a:xfrm>
            <a:off x="3936883" y="646696"/>
            <a:ext cx="8980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gRN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4B240096-08B3-475F-8467-040A0425C86B}"/>
              </a:ext>
            </a:extLst>
          </p:cNvPr>
          <p:cNvSpPr txBox="1"/>
          <p:nvPr/>
        </p:nvSpPr>
        <p:spPr>
          <a:xfrm>
            <a:off x="605181" y="2554184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A91E18C-7FB9-4329-AFC6-3D14264C5700}"/>
              </a:ext>
            </a:extLst>
          </p:cNvPr>
          <p:cNvSpPr txBox="1"/>
          <p:nvPr/>
        </p:nvSpPr>
        <p:spPr>
          <a:xfrm>
            <a:off x="1731689" y="2564050"/>
            <a:ext cx="7168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549 cells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9E4480B9-9C9B-4573-9313-27C1A43F70CA}"/>
              </a:ext>
            </a:extLst>
          </p:cNvPr>
          <p:cNvSpPr txBox="1"/>
          <p:nvPr/>
        </p:nvSpPr>
        <p:spPr>
          <a:xfrm>
            <a:off x="2836651" y="2564052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MCF7 cells</a:t>
            </a:r>
          </a:p>
        </p:txBody>
      </p: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03B0C85A-C53C-4669-AAF9-F284DB0EBEAB}"/>
              </a:ext>
            </a:extLst>
          </p:cNvPr>
          <p:cNvCxnSpPr/>
          <p:nvPr/>
        </p:nvCxnSpPr>
        <p:spPr>
          <a:xfrm>
            <a:off x="578242" y="104956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DB15818A-AC49-4916-8D6D-646A22AADB13}"/>
              </a:ext>
            </a:extLst>
          </p:cNvPr>
          <p:cNvCxnSpPr/>
          <p:nvPr/>
        </p:nvCxnSpPr>
        <p:spPr>
          <a:xfrm>
            <a:off x="578242" y="142883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CCC6CF95-127E-4A01-B765-CCFE65FC936F}"/>
              </a:ext>
            </a:extLst>
          </p:cNvPr>
          <p:cNvCxnSpPr/>
          <p:nvPr/>
        </p:nvCxnSpPr>
        <p:spPr>
          <a:xfrm>
            <a:off x="578242" y="172255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F0D458D8-4BA0-436A-A4BD-0C6315EBFADE}"/>
              </a:ext>
            </a:extLst>
          </p:cNvPr>
          <p:cNvCxnSpPr/>
          <p:nvPr/>
        </p:nvCxnSpPr>
        <p:spPr>
          <a:xfrm>
            <a:off x="578242" y="214800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1DB01C9C-7F5A-492D-8C9F-40AE97BBCC08}"/>
              </a:ext>
            </a:extLst>
          </p:cNvPr>
          <p:cNvCxnSpPr/>
          <p:nvPr/>
        </p:nvCxnSpPr>
        <p:spPr>
          <a:xfrm>
            <a:off x="578242" y="242422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35" name="Group 34">
            <a:extLst>
              <a:ext uri="{FF2B5EF4-FFF2-40B4-BE49-F238E27FC236}">
                <a16:creationId xmlns:a16="http://schemas.microsoft.com/office/drawing/2014/main" id="{212EB5A2-7FAB-4573-ACE0-A5E162619484}"/>
              </a:ext>
            </a:extLst>
          </p:cNvPr>
          <p:cNvGrpSpPr/>
          <p:nvPr/>
        </p:nvGrpSpPr>
        <p:grpSpPr>
          <a:xfrm>
            <a:off x="1715509" y="390092"/>
            <a:ext cx="1086651" cy="576739"/>
            <a:chOff x="4695532" y="1568463"/>
            <a:chExt cx="1086651" cy="576739"/>
          </a:xfrm>
        </p:grpSpPr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9BECF44D-F2C6-46E9-A4DC-34905BFE9E5D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7" name="Straight Connector 36">
              <a:extLst>
                <a:ext uri="{FF2B5EF4-FFF2-40B4-BE49-F238E27FC236}">
                  <a16:creationId xmlns:a16="http://schemas.microsoft.com/office/drawing/2014/main" id="{71076520-EDA3-4C77-BB47-CE8902F95D5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B2C31A6-B705-48D5-94C0-C7E063D43DF1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C10F400E-767D-45DA-A0DD-581729D456AF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79270578-90CB-47E0-9E20-D6374F046DF9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39AF21B0-975E-424F-A435-1CB02642E89A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FF84BC29-6F6B-4D05-9F11-1854A008932E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A9621777-5B5C-4A03-85F8-63D38510B3FD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0328DCE-B783-49A3-BE52-53D7C0176BEE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1761E2E7-A58E-4521-8EB7-58D2D16BDFB4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24B3909-398A-4568-B96A-B230F2724ED6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04C8C1F-0A61-4708-8D86-B8A0D55E3D45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9B1DDD0B-5578-4F6C-AAFA-EEAA789EB0F1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546F8FC-3F26-4BA5-911B-37F602C36D0D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0" name="TextBox 49">
              <a:extLst>
                <a:ext uri="{FF2B5EF4-FFF2-40B4-BE49-F238E27FC236}">
                  <a16:creationId xmlns:a16="http://schemas.microsoft.com/office/drawing/2014/main" id="{F4FE6ABB-D847-4F0D-A891-95C53BF8DF97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51" name="Straight Connector 50">
              <a:extLst>
                <a:ext uri="{FF2B5EF4-FFF2-40B4-BE49-F238E27FC236}">
                  <a16:creationId xmlns:a16="http://schemas.microsoft.com/office/drawing/2014/main" id="{58C1DFB6-BC9D-43AD-82E8-80FF0086337A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Group 51">
            <a:extLst>
              <a:ext uri="{FF2B5EF4-FFF2-40B4-BE49-F238E27FC236}">
                <a16:creationId xmlns:a16="http://schemas.microsoft.com/office/drawing/2014/main" id="{608846B8-AFAB-4143-B272-6FEC5B930FE1}"/>
              </a:ext>
            </a:extLst>
          </p:cNvPr>
          <p:cNvGrpSpPr/>
          <p:nvPr/>
        </p:nvGrpSpPr>
        <p:grpSpPr>
          <a:xfrm>
            <a:off x="2793468" y="390092"/>
            <a:ext cx="1086651" cy="576739"/>
            <a:chOff x="4695532" y="1568463"/>
            <a:chExt cx="1086651" cy="576739"/>
          </a:xfrm>
        </p:grpSpPr>
        <p:sp>
          <p:nvSpPr>
            <p:cNvPr id="53" name="TextBox 52">
              <a:extLst>
                <a:ext uri="{FF2B5EF4-FFF2-40B4-BE49-F238E27FC236}">
                  <a16:creationId xmlns:a16="http://schemas.microsoft.com/office/drawing/2014/main" id="{1814C32E-1A51-4CDD-99D2-7D43043C73F4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ADB08487-A764-4676-A888-9E120E507279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>
              <a:extLst>
                <a:ext uri="{FF2B5EF4-FFF2-40B4-BE49-F238E27FC236}">
                  <a16:creationId xmlns:a16="http://schemas.microsoft.com/office/drawing/2014/main" id="{37AE9954-C40A-4FBE-9FB2-508937CE20F6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TextBox 55">
              <a:extLst>
                <a:ext uri="{FF2B5EF4-FFF2-40B4-BE49-F238E27FC236}">
                  <a16:creationId xmlns:a16="http://schemas.microsoft.com/office/drawing/2014/main" id="{EBE8A8B6-57D7-49FA-9800-10A80B2EE966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7" name="TextBox 56">
              <a:extLst>
                <a:ext uri="{FF2B5EF4-FFF2-40B4-BE49-F238E27FC236}">
                  <a16:creationId xmlns:a16="http://schemas.microsoft.com/office/drawing/2014/main" id="{BF17E246-0F0A-4577-B416-EFEF77102510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06B8E9E9-460D-441A-AC3A-AD59533933D9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942DED86-70B3-4E90-BF85-DB31CF1FF91B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479FE730-BF85-4806-BAD9-FBCB1133EEA0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7556736F-4075-4AB8-A1B4-3DA1E825C11E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87E1893A-4DAD-4357-8EC5-24690CCF1C6C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C1CEE75D-5C84-489B-88C4-123F9AC4FF91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4" name="TextBox 63">
              <a:extLst>
                <a:ext uri="{FF2B5EF4-FFF2-40B4-BE49-F238E27FC236}">
                  <a16:creationId xmlns:a16="http://schemas.microsoft.com/office/drawing/2014/main" id="{698C9AFA-110B-45A0-A4EB-C47C567EF50E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5AEDA3E-17E0-4D46-BC93-C058E4C13B87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6" name="TextBox 65">
              <a:extLst>
                <a:ext uri="{FF2B5EF4-FFF2-40B4-BE49-F238E27FC236}">
                  <a16:creationId xmlns:a16="http://schemas.microsoft.com/office/drawing/2014/main" id="{2EC943B4-4A26-418A-97B8-E11F7D944675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439B0EE5-FD20-467B-A278-9007B3014CDB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68" name="Straight Connector 67">
              <a:extLst>
                <a:ext uri="{FF2B5EF4-FFF2-40B4-BE49-F238E27FC236}">
                  <a16:creationId xmlns:a16="http://schemas.microsoft.com/office/drawing/2014/main" id="{2CEE4C9D-D8F9-4841-88B2-A07C6C64A56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oup 68">
            <a:extLst>
              <a:ext uri="{FF2B5EF4-FFF2-40B4-BE49-F238E27FC236}">
                <a16:creationId xmlns:a16="http://schemas.microsoft.com/office/drawing/2014/main" id="{55F9F550-A376-4454-B3EF-C34AF0D275F0}"/>
              </a:ext>
            </a:extLst>
          </p:cNvPr>
          <p:cNvGrpSpPr/>
          <p:nvPr/>
        </p:nvGrpSpPr>
        <p:grpSpPr>
          <a:xfrm>
            <a:off x="612797" y="390092"/>
            <a:ext cx="1086651" cy="576739"/>
            <a:chOff x="4695532" y="1568463"/>
            <a:chExt cx="1086651" cy="576739"/>
          </a:xfrm>
        </p:grpSpPr>
        <p:sp>
          <p:nvSpPr>
            <p:cNvPr id="70" name="TextBox 69">
              <a:extLst>
                <a:ext uri="{FF2B5EF4-FFF2-40B4-BE49-F238E27FC236}">
                  <a16:creationId xmlns:a16="http://schemas.microsoft.com/office/drawing/2014/main" id="{6C47267E-43A5-47E5-8BE2-8C0D0FEB7C92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1" name="Straight Connector 70">
              <a:extLst>
                <a:ext uri="{FF2B5EF4-FFF2-40B4-BE49-F238E27FC236}">
                  <a16:creationId xmlns:a16="http://schemas.microsoft.com/office/drawing/2014/main" id="{49D60C0D-029B-41E1-9155-E7D35789A3F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2" name="TextBox 71">
              <a:extLst>
                <a:ext uri="{FF2B5EF4-FFF2-40B4-BE49-F238E27FC236}">
                  <a16:creationId xmlns:a16="http://schemas.microsoft.com/office/drawing/2014/main" id="{47CAFA57-CC34-4250-9572-F42438FD99CF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3" name="TextBox 72">
              <a:extLst>
                <a:ext uri="{FF2B5EF4-FFF2-40B4-BE49-F238E27FC236}">
                  <a16:creationId xmlns:a16="http://schemas.microsoft.com/office/drawing/2014/main" id="{CCF98B12-6B40-45EA-B9E1-7A2E1BB2DA2B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4" name="TextBox 73">
              <a:extLst>
                <a:ext uri="{FF2B5EF4-FFF2-40B4-BE49-F238E27FC236}">
                  <a16:creationId xmlns:a16="http://schemas.microsoft.com/office/drawing/2014/main" id="{079F2CCA-524C-4FEB-882C-00A04DFC8D0C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0D25B4B2-399D-4AC5-BAB4-D5DFC78F05ED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6" name="TextBox 75">
              <a:extLst>
                <a:ext uri="{FF2B5EF4-FFF2-40B4-BE49-F238E27FC236}">
                  <a16:creationId xmlns:a16="http://schemas.microsoft.com/office/drawing/2014/main" id="{9CC3EF5B-69C5-468F-9495-C8B070B51AB6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7" name="TextBox 76">
              <a:extLst>
                <a:ext uri="{FF2B5EF4-FFF2-40B4-BE49-F238E27FC236}">
                  <a16:creationId xmlns:a16="http://schemas.microsoft.com/office/drawing/2014/main" id="{AB070778-6CDF-4C78-8A37-CCB91CB0CBF1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C2C2034B-F61D-4C3B-92C6-671647D283AC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9" name="TextBox 78">
              <a:extLst>
                <a:ext uri="{FF2B5EF4-FFF2-40B4-BE49-F238E27FC236}">
                  <a16:creationId xmlns:a16="http://schemas.microsoft.com/office/drawing/2014/main" id="{767551D7-ABC0-4114-A9EC-42D8F59EF084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0" name="TextBox 79">
              <a:extLst>
                <a:ext uri="{FF2B5EF4-FFF2-40B4-BE49-F238E27FC236}">
                  <a16:creationId xmlns:a16="http://schemas.microsoft.com/office/drawing/2014/main" id="{7ED6D175-ED38-4019-8B80-296F9AF55119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1" name="TextBox 80">
              <a:extLst>
                <a:ext uri="{FF2B5EF4-FFF2-40B4-BE49-F238E27FC236}">
                  <a16:creationId xmlns:a16="http://schemas.microsoft.com/office/drawing/2014/main" id="{D5F99011-F4D3-4EB4-972F-08118A33C05E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82" name="TextBox 81">
              <a:extLst>
                <a:ext uri="{FF2B5EF4-FFF2-40B4-BE49-F238E27FC236}">
                  <a16:creationId xmlns:a16="http://schemas.microsoft.com/office/drawing/2014/main" id="{5352AF6C-9F3A-4F3F-85C8-D6C48C9CF1D5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3" name="TextBox 82">
              <a:extLst>
                <a:ext uri="{FF2B5EF4-FFF2-40B4-BE49-F238E27FC236}">
                  <a16:creationId xmlns:a16="http://schemas.microsoft.com/office/drawing/2014/main" id="{84D245EB-4C9C-4C1E-AE24-84F4B85540D1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84" name="TextBox 83">
              <a:extLst>
                <a:ext uri="{FF2B5EF4-FFF2-40B4-BE49-F238E27FC236}">
                  <a16:creationId xmlns:a16="http://schemas.microsoft.com/office/drawing/2014/main" id="{CA38E4CC-E1F1-47D3-8A27-55532C06F974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85" name="Straight Connector 84">
              <a:extLst>
                <a:ext uri="{FF2B5EF4-FFF2-40B4-BE49-F238E27FC236}">
                  <a16:creationId xmlns:a16="http://schemas.microsoft.com/office/drawing/2014/main" id="{6929F09E-A95C-4168-B0F2-EF77F9E2FF7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86" name="Picture 85">
            <a:extLst>
              <a:ext uri="{FF2B5EF4-FFF2-40B4-BE49-F238E27FC236}">
                <a16:creationId xmlns:a16="http://schemas.microsoft.com/office/drawing/2014/main" id="{B2773DC2-6B89-47CD-9BFE-7E180B364A7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4305" t="60702" r="28959" b="19085"/>
          <a:stretch/>
        </p:blipFill>
        <p:spPr>
          <a:xfrm rot="5400000">
            <a:off x="1051411" y="1563020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7" name="Picture 86">
            <a:extLst>
              <a:ext uri="{FF2B5EF4-FFF2-40B4-BE49-F238E27FC236}">
                <a16:creationId xmlns:a16="http://schemas.microsoft.com/office/drawing/2014/main" id="{940676F5-35B9-4719-B57D-90A17C4A2F1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193" t="21143" r="27071" b="58644"/>
          <a:stretch/>
        </p:blipFill>
        <p:spPr>
          <a:xfrm rot="5400000">
            <a:off x="1051411" y="1877097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8" name="Picture 87">
            <a:extLst>
              <a:ext uri="{FF2B5EF4-FFF2-40B4-BE49-F238E27FC236}">
                <a16:creationId xmlns:a16="http://schemas.microsoft.com/office/drawing/2014/main" id="{33F7633B-53E3-41BB-A64C-8F54A49A683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125" t="21838" r="37726" b="58803"/>
          <a:stretch/>
        </p:blipFill>
        <p:spPr>
          <a:xfrm rot="5400000">
            <a:off x="1051411" y="1237798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9" name="Picture 88">
            <a:extLst>
              <a:ext uri="{FF2B5EF4-FFF2-40B4-BE49-F238E27FC236}">
                <a16:creationId xmlns:a16="http://schemas.microsoft.com/office/drawing/2014/main" id="{90425941-49DB-4EEE-940D-4F35E5FDC33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225" t="68643" r="37956" b="9652"/>
          <a:stretch/>
        </p:blipFill>
        <p:spPr>
          <a:xfrm rot="5400000">
            <a:off x="1051411" y="596748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Picture 89">
            <a:extLst>
              <a:ext uri="{FF2B5EF4-FFF2-40B4-BE49-F238E27FC236}">
                <a16:creationId xmlns:a16="http://schemas.microsoft.com/office/drawing/2014/main" id="{BC850500-67FA-49E3-88F6-B7E61FA9098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6" t="535" r="17" b="823"/>
          <a:stretch/>
        </p:blipFill>
        <p:spPr>
          <a:xfrm rot="5400000">
            <a:off x="5368488" y="130024"/>
            <a:ext cx="2463732" cy="27243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1" name="Picture 90">
            <a:extLst>
              <a:ext uri="{FF2B5EF4-FFF2-40B4-BE49-F238E27FC236}">
                <a16:creationId xmlns:a16="http://schemas.microsoft.com/office/drawing/2014/main" id="{BC190922-6D44-4FA9-8AB9-D25AED83891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795" t="867" r="-391" b="-460"/>
          <a:stretch/>
        </p:blipFill>
        <p:spPr>
          <a:xfrm rot="5400000">
            <a:off x="8406817" y="30021"/>
            <a:ext cx="2775508" cy="308397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2" name="Picture 91">
            <a:extLst>
              <a:ext uri="{FF2B5EF4-FFF2-40B4-BE49-F238E27FC236}">
                <a16:creationId xmlns:a16="http://schemas.microsoft.com/office/drawing/2014/main" id="{BDB12D72-EFC6-4521-9604-6B94F5A8328E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655" t="525" r="191" b="-364"/>
          <a:stretch/>
        </p:blipFill>
        <p:spPr>
          <a:xfrm rot="5400000">
            <a:off x="8409237" y="2983171"/>
            <a:ext cx="3043823" cy="358281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93" name="Rectangle 92">
            <a:extLst>
              <a:ext uri="{FF2B5EF4-FFF2-40B4-BE49-F238E27FC236}">
                <a16:creationId xmlns:a16="http://schemas.microsoft.com/office/drawing/2014/main" id="{52F6027E-D806-45EE-B376-81F59C488A97}"/>
              </a:ext>
            </a:extLst>
          </p:cNvPr>
          <p:cNvSpPr/>
          <p:nvPr/>
        </p:nvSpPr>
        <p:spPr>
          <a:xfrm>
            <a:off x="5450172" y="1511294"/>
            <a:ext cx="782590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4" name="Rectangle 93">
            <a:extLst>
              <a:ext uri="{FF2B5EF4-FFF2-40B4-BE49-F238E27FC236}">
                <a16:creationId xmlns:a16="http://schemas.microsoft.com/office/drawing/2014/main" id="{30737DFF-94BA-423F-A2CD-92E57A1961E7}"/>
              </a:ext>
            </a:extLst>
          </p:cNvPr>
          <p:cNvSpPr/>
          <p:nvPr/>
        </p:nvSpPr>
        <p:spPr>
          <a:xfrm>
            <a:off x="9931618" y="1660054"/>
            <a:ext cx="782590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5" name="Rectangle 94">
            <a:extLst>
              <a:ext uri="{FF2B5EF4-FFF2-40B4-BE49-F238E27FC236}">
                <a16:creationId xmlns:a16="http://schemas.microsoft.com/office/drawing/2014/main" id="{9C52EBCD-664B-4049-A8DC-7C92C37903EE}"/>
              </a:ext>
            </a:extLst>
          </p:cNvPr>
          <p:cNvSpPr/>
          <p:nvPr/>
        </p:nvSpPr>
        <p:spPr>
          <a:xfrm>
            <a:off x="8817193" y="5155729"/>
            <a:ext cx="782590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6" name="Rectangle 95">
            <a:extLst>
              <a:ext uri="{FF2B5EF4-FFF2-40B4-BE49-F238E27FC236}">
                <a16:creationId xmlns:a16="http://schemas.microsoft.com/office/drawing/2014/main" id="{CD42F4C9-9A02-4FFD-9CE0-20CE57498118}"/>
              </a:ext>
            </a:extLst>
          </p:cNvPr>
          <p:cNvSpPr/>
          <p:nvPr/>
        </p:nvSpPr>
        <p:spPr>
          <a:xfrm>
            <a:off x="10269874" y="5219700"/>
            <a:ext cx="782590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7" name="TextBox 96">
            <a:extLst>
              <a:ext uri="{FF2B5EF4-FFF2-40B4-BE49-F238E27FC236}">
                <a16:creationId xmlns:a16="http://schemas.microsoft.com/office/drawing/2014/main" id="{25DA4199-7333-4EE6-88EA-E02BED3404AA}"/>
              </a:ext>
            </a:extLst>
          </p:cNvPr>
          <p:cNvSpPr txBox="1"/>
          <p:nvPr/>
        </p:nvSpPr>
        <p:spPr>
          <a:xfrm>
            <a:off x="6232762" y="1571626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38C7C87D-C5BF-4E36-B89C-87C28A35153F}"/>
              </a:ext>
            </a:extLst>
          </p:cNvPr>
          <p:cNvSpPr txBox="1"/>
          <p:nvPr/>
        </p:nvSpPr>
        <p:spPr>
          <a:xfrm>
            <a:off x="10714208" y="1694282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TextBox 98">
            <a:extLst>
              <a:ext uri="{FF2B5EF4-FFF2-40B4-BE49-F238E27FC236}">
                <a16:creationId xmlns:a16="http://schemas.microsoft.com/office/drawing/2014/main" id="{85D63A3A-62AA-438E-B332-4FCA6511ADF7}"/>
              </a:ext>
            </a:extLst>
          </p:cNvPr>
          <p:cNvSpPr txBox="1"/>
          <p:nvPr/>
        </p:nvSpPr>
        <p:spPr>
          <a:xfrm>
            <a:off x="9625527" y="5209104"/>
            <a:ext cx="33808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100" name="TextBox 99">
            <a:extLst>
              <a:ext uri="{FF2B5EF4-FFF2-40B4-BE49-F238E27FC236}">
                <a16:creationId xmlns:a16="http://schemas.microsoft.com/office/drawing/2014/main" id="{42C82D4D-E448-4BB7-963C-8E2D881A4C0B}"/>
              </a:ext>
            </a:extLst>
          </p:cNvPr>
          <p:cNvSpPr txBox="1"/>
          <p:nvPr/>
        </p:nvSpPr>
        <p:spPr>
          <a:xfrm>
            <a:off x="11061881" y="5273075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101" name="Picture 100">
            <a:extLst>
              <a:ext uri="{FF2B5EF4-FFF2-40B4-BE49-F238E27FC236}">
                <a16:creationId xmlns:a16="http://schemas.microsoft.com/office/drawing/2014/main" id="{AD249E6A-8F33-4078-B208-6335C80E56C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1830" t="30623" r="39784" b="34128"/>
          <a:stretch/>
        </p:blipFill>
        <p:spPr>
          <a:xfrm rot="16200000">
            <a:off x="1050753" y="915995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5" name="Picture 104">
            <a:extLst>
              <a:ext uri="{FF2B5EF4-FFF2-40B4-BE49-F238E27FC236}">
                <a16:creationId xmlns:a16="http://schemas.microsoft.com/office/drawing/2014/main" id="{D38E85B9-2D30-4E71-A07F-84EB6C1DAF96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4" t="505" r="-110" b="-235"/>
          <a:stretch/>
        </p:blipFill>
        <p:spPr>
          <a:xfrm rot="16200000">
            <a:off x="5400039" y="3246965"/>
            <a:ext cx="2423549" cy="205225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8" name="Rectangle 107">
            <a:extLst>
              <a:ext uri="{FF2B5EF4-FFF2-40B4-BE49-F238E27FC236}">
                <a16:creationId xmlns:a16="http://schemas.microsoft.com/office/drawing/2014/main" id="{18711570-1303-4F67-8F18-7E9E35B451D4}"/>
              </a:ext>
            </a:extLst>
          </p:cNvPr>
          <p:cNvSpPr/>
          <p:nvPr/>
        </p:nvSpPr>
        <p:spPr>
          <a:xfrm>
            <a:off x="6209059" y="3972192"/>
            <a:ext cx="782590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F75BF2C0-9E46-4CC5-AD1C-EB81C14CF432}"/>
              </a:ext>
            </a:extLst>
          </p:cNvPr>
          <p:cNvSpPr txBox="1"/>
          <p:nvPr/>
        </p:nvSpPr>
        <p:spPr>
          <a:xfrm>
            <a:off x="6361584" y="4268986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194008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62">
            <a:extLst>
              <a:ext uri="{FF2B5EF4-FFF2-40B4-BE49-F238E27FC236}">
                <a16:creationId xmlns:a16="http://schemas.microsoft.com/office/drawing/2014/main" id="{D76E7BF6-331A-4F6D-8BC0-41C1BE3B0311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99" t="642" r="188" b="851"/>
          <a:stretch/>
        </p:blipFill>
        <p:spPr>
          <a:xfrm rot="5400000">
            <a:off x="8477792" y="-196006"/>
            <a:ext cx="2537002" cy="34230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4" name="Rectangle 63">
            <a:extLst>
              <a:ext uri="{FF2B5EF4-FFF2-40B4-BE49-F238E27FC236}">
                <a16:creationId xmlns:a16="http://schemas.microsoft.com/office/drawing/2014/main" id="{F9AB6185-7E1A-442A-BCAE-9605A5111F47}"/>
              </a:ext>
            </a:extLst>
          </p:cNvPr>
          <p:cNvSpPr/>
          <p:nvPr/>
        </p:nvSpPr>
        <p:spPr>
          <a:xfrm>
            <a:off x="9707793" y="693752"/>
            <a:ext cx="782590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B4DF6402-2FB6-4E51-9AA9-DE52CCF11A10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" t="317" r="2542" b="418"/>
          <a:stretch/>
        </p:blipFill>
        <p:spPr>
          <a:xfrm rot="5400000">
            <a:off x="4898108" y="2764784"/>
            <a:ext cx="2556978" cy="349746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3" name="Rectangle 72">
            <a:extLst>
              <a:ext uri="{FF2B5EF4-FFF2-40B4-BE49-F238E27FC236}">
                <a16:creationId xmlns:a16="http://schemas.microsoft.com/office/drawing/2014/main" id="{6AAE9091-9917-41A8-ACE0-0C5E2483DCD8}"/>
              </a:ext>
            </a:extLst>
          </p:cNvPr>
          <p:cNvSpPr/>
          <p:nvPr/>
        </p:nvSpPr>
        <p:spPr>
          <a:xfrm>
            <a:off x="6161805" y="3789981"/>
            <a:ext cx="768322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2AC09647-52A9-4311-817A-E4A35C7EE11A}"/>
              </a:ext>
            </a:extLst>
          </p:cNvPr>
          <p:cNvSpPr/>
          <p:nvPr/>
        </p:nvSpPr>
        <p:spPr>
          <a:xfrm>
            <a:off x="6125240" y="5045171"/>
            <a:ext cx="768322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5" name="Picture 74">
            <a:extLst>
              <a:ext uri="{FF2B5EF4-FFF2-40B4-BE49-F238E27FC236}">
                <a16:creationId xmlns:a16="http://schemas.microsoft.com/office/drawing/2014/main" id="{70F545F1-78F3-48D9-A5AC-06ECA86DA775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65" t="599" r="1813" b="151"/>
          <a:stretch/>
        </p:blipFill>
        <p:spPr>
          <a:xfrm rot="5400000">
            <a:off x="8950767" y="2613110"/>
            <a:ext cx="2476089" cy="37232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6" name="Rectangle 75">
            <a:extLst>
              <a:ext uri="{FF2B5EF4-FFF2-40B4-BE49-F238E27FC236}">
                <a16:creationId xmlns:a16="http://schemas.microsoft.com/office/drawing/2014/main" id="{37B28B41-3363-4217-AB7D-F59EFB9818E3}"/>
              </a:ext>
            </a:extLst>
          </p:cNvPr>
          <p:cNvSpPr/>
          <p:nvPr/>
        </p:nvSpPr>
        <p:spPr>
          <a:xfrm>
            <a:off x="10161622" y="4089263"/>
            <a:ext cx="807105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59BDB607-1735-4AC8-A459-3EE3D9E7CF39}"/>
              </a:ext>
            </a:extLst>
          </p:cNvPr>
          <p:cNvSpPr txBox="1"/>
          <p:nvPr/>
        </p:nvSpPr>
        <p:spPr>
          <a:xfrm>
            <a:off x="10057576" y="1003506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18520CFF-922B-466C-8E81-529FAA2AD4BB}"/>
              </a:ext>
            </a:extLst>
          </p:cNvPr>
          <p:cNvSpPr txBox="1"/>
          <p:nvPr/>
        </p:nvSpPr>
        <p:spPr>
          <a:xfrm>
            <a:off x="6483406" y="3605805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23CB231D-6C43-4EE2-A4E9-E0925CEF70D7}"/>
              </a:ext>
            </a:extLst>
          </p:cNvPr>
          <p:cNvSpPr txBox="1"/>
          <p:nvPr/>
        </p:nvSpPr>
        <p:spPr>
          <a:xfrm>
            <a:off x="6515643" y="5376579"/>
            <a:ext cx="33808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3424E654-9BA6-4E41-A0DF-AA65177B1CD9}"/>
              </a:ext>
            </a:extLst>
          </p:cNvPr>
          <p:cNvSpPr txBox="1"/>
          <p:nvPr/>
        </p:nvSpPr>
        <p:spPr>
          <a:xfrm>
            <a:off x="10545495" y="3843356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B92CE58-E0C6-47F4-A063-8794A059727B}"/>
              </a:ext>
            </a:extLst>
          </p:cNvPr>
          <p:cNvSpPr txBox="1"/>
          <p:nvPr/>
        </p:nvSpPr>
        <p:spPr>
          <a:xfrm>
            <a:off x="265087" y="1435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F47E9C17-D4CA-463C-83CC-8260B926D948}"/>
              </a:ext>
            </a:extLst>
          </p:cNvPr>
          <p:cNvSpPr txBox="1"/>
          <p:nvPr/>
        </p:nvSpPr>
        <p:spPr>
          <a:xfrm>
            <a:off x="279350" y="935861"/>
            <a:ext cx="31159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7E5AE668-A84F-4183-AA92-D6CE68F79048}"/>
              </a:ext>
            </a:extLst>
          </p:cNvPr>
          <p:cNvSpPr txBox="1"/>
          <p:nvPr/>
        </p:nvSpPr>
        <p:spPr>
          <a:xfrm>
            <a:off x="3919390" y="1376797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6FBAC426-8C08-4B1A-938C-48360627C6E4}"/>
              </a:ext>
            </a:extLst>
          </p:cNvPr>
          <p:cNvSpPr txBox="1"/>
          <p:nvPr/>
        </p:nvSpPr>
        <p:spPr>
          <a:xfrm>
            <a:off x="3919390" y="1694022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E6D7AC98-52A7-4681-B9E4-CD4588E1A368}"/>
              </a:ext>
            </a:extLst>
          </p:cNvPr>
          <p:cNvSpPr txBox="1"/>
          <p:nvPr/>
        </p:nvSpPr>
        <p:spPr>
          <a:xfrm>
            <a:off x="3919390" y="2011246"/>
            <a:ext cx="33808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A2A5E580-5D79-4C00-A861-C650027143C5}"/>
              </a:ext>
            </a:extLst>
          </p:cNvPr>
          <p:cNvSpPr txBox="1"/>
          <p:nvPr/>
        </p:nvSpPr>
        <p:spPr>
          <a:xfrm>
            <a:off x="3919390" y="2328472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5C42D441-53BC-4E1D-99FC-019F26FB27A9}"/>
              </a:ext>
            </a:extLst>
          </p:cNvPr>
          <p:cNvSpPr txBox="1"/>
          <p:nvPr/>
        </p:nvSpPr>
        <p:spPr>
          <a:xfrm>
            <a:off x="333667" y="1317695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FE192DE3-BB69-4313-A268-2DB4D0CAEC87}"/>
              </a:ext>
            </a:extLst>
          </p:cNvPr>
          <p:cNvSpPr txBox="1"/>
          <p:nvPr/>
        </p:nvSpPr>
        <p:spPr>
          <a:xfrm>
            <a:off x="333667" y="1618045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F486ADA9-DD31-4F10-9783-756B9BA06BDF}"/>
              </a:ext>
            </a:extLst>
          </p:cNvPr>
          <p:cNvSpPr txBox="1"/>
          <p:nvPr/>
        </p:nvSpPr>
        <p:spPr>
          <a:xfrm>
            <a:off x="333667" y="2031929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3C9DBABE-38A7-43EC-9117-9F3077E9DED1}"/>
              </a:ext>
            </a:extLst>
          </p:cNvPr>
          <p:cNvSpPr txBox="1"/>
          <p:nvPr/>
        </p:nvSpPr>
        <p:spPr>
          <a:xfrm>
            <a:off x="333667" y="2310388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EEEBCC49-302D-4CA1-AFA9-D152D439B294}"/>
              </a:ext>
            </a:extLst>
          </p:cNvPr>
          <p:cNvSpPr txBox="1"/>
          <p:nvPr/>
        </p:nvSpPr>
        <p:spPr>
          <a:xfrm>
            <a:off x="3919390" y="1055737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37" name="TextBox 236">
            <a:extLst>
              <a:ext uri="{FF2B5EF4-FFF2-40B4-BE49-F238E27FC236}">
                <a16:creationId xmlns:a16="http://schemas.microsoft.com/office/drawing/2014/main" id="{CEC988A2-F0C9-46E7-9FE6-B109E983EEEE}"/>
              </a:ext>
            </a:extLst>
          </p:cNvPr>
          <p:cNvSpPr txBox="1"/>
          <p:nvPr/>
        </p:nvSpPr>
        <p:spPr>
          <a:xfrm>
            <a:off x="266650" y="775742"/>
            <a:ext cx="32219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8" name="TextBox 237">
            <a:extLst>
              <a:ext uri="{FF2B5EF4-FFF2-40B4-BE49-F238E27FC236}">
                <a16:creationId xmlns:a16="http://schemas.microsoft.com/office/drawing/2014/main" id="{93E60EA1-CC87-4575-8FE7-47969883DD2E}"/>
              </a:ext>
            </a:extLst>
          </p:cNvPr>
          <p:cNvSpPr txBox="1"/>
          <p:nvPr/>
        </p:nvSpPr>
        <p:spPr>
          <a:xfrm>
            <a:off x="3936883" y="803147"/>
            <a:ext cx="783219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</a:p>
        </p:txBody>
      </p:sp>
      <p:sp>
        <p:nvSpPr>
          <p:cNvPr id="239" name="TextBox 238">
            <a:extLst>
              <a:ext uri="{FF2B5EF4-FFF2-40B4-BE49-F238E27FC236}">
                <a16:creationId xmlns:a16="http://schemas.microsoft.com/office/drawing/2014/main" id="{4C4B2595-3CEF-4C54-B113-A48458671C4D}"/>
              </a:ext>
            </a:extLst>
          </p:cNvPr>
          <p:cNvSpPr txBox="1"/>
          <p:nvPr/>
        </p:nvSpPr>
        <p:spPr>
          <a:xfrm>
            <a:off x="3936883" y="646696"/>
            <a:ext cx="8980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gRNA</a:t>
            </a:r>
          </a:p>
        </p:txBody>
      </p:sp>
      <p:sp>
        <p:nvSpPr>
          <p:cNvPr id="240" name="TextBox 239">
            <a:extLst>
              <a:ext uri="{FF2B5EF4-FFF2-40B4-BE49-F238E27FC236}">
                <a16:creationId xmlns:a16="http://schemas.microsoft.com/office/drawing/2014/main" id="{49CC1105-A63E-4904-A2B7-3C3EC006E309}"/>
              </a:ext>
            </a:extLst>
          </p:cNvPr>
          <p:cNvSpPr txBox="1"/>
          <p:nvPr/>
        </p:nvSpPr>
        <p:spPr>
          <a:xfrm>
            <a:off x="605181" y="2554184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241" name="Picture 240">
            <a:extLst>
              <a:ext uri="{FF2B5EF4-FFF2-40B4-BE49-F238E27FC236}">
                <a16:creationId xmlns:a16="http://schemas.microsoft.com/office/drawing/2014/main" id="{CA1D2322-7D50-4454-A069-1FDE739EB99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561" t="28891" r="69693" b="50521"/>
          <a:stretch/>
        </p:blipFill>
        <p:spPr>
          <a:xfrm rot="5400000">
            <a:off x="2164131" y="1237786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2" name="Picture 241">
            <a:extLst>
              <a:ext uri="{FF2B5EF4-FFF2-40B4-BE49-F238E27FC236}">
                <a16:creationId xmlns:a16="http://schemas.microsoft.com/office/drawing/2014/main" id="{8339340C-2568-4BE2-A5A7-4C25D7CC7CF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9696" t="28891" r="22558" b="50521"/>
          <a:stretch/>
        </p:blipFill>
        <p:spPr>
          <a:xfrm rot="5400000">
            <a:off x="2164131" y="1557441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3" name="Picture 242">
            <a:extLst>
              <a:ext uri="{FF2B5EF4-FFF2-40B4-BE49-F238E27FC236}">
                <a16:creationId xmlns:a16="http://schemas.microsoft.com/office/drawing/2014/main" id="{1590D5E5-49C1-4B24-A024-1FA446B2F627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072" t="29345" r="56848" b="49584"/>
          <a:stretch/>
        </p:blipFill>
        <p:spPr>
          <a:xfrm rot="5400000">
            <a:off x="2164131" y="1877097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4" name="Picture 243">
            <a:extLst>
              <a:ext uri="{FF2B5EF4-FFF2-40B4-BE49-F238E27FC236}">
                <a16:creationId xmlns:a16="http://schemas.microsoft.com/office/drawing/2014/main" id="{416B7126-103E-4041-A456-3D95C480D13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809" t="29576" r="74172" b="49548"/>
          <a:stretch/>
        </p:blipFill>
        <p:spPr>
          <a:xfrm rot="5400000">
            <a:off x="2164131" y="596748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9" name="TextBox 248">
            <a:extLst>
              <a:ext uri="{FF2B5EF4-FFF2-40B4-BE49-F238E27FC236}">
                <a16:creationId xmlns:a16="http://schemas.microsoft.com/office/drawing/2014/main" id="{11AC7B94-1FB7-4F1F-9727-91147E4EF6F2}"/>
              </a:ext>
            </a:extLst>
          </p:cNvPr>
          <p:cNvSpPr txBox="1"/>
          <p:nvPr/>
        </p:nvSpPr>
        <p:spPr>
          <a:xfrm>
            <a:off x="1731689" y="2564050"/>
            <a:ext cx="7168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549 cells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84AF3B23-393B-42EC-8789-8C0704B97731}"/>
              </a:ext>
            </a:extLst>
          </p:cNvPr>
          <p:cNvSpPr txBox="1"/>
          <p:nvPr/>
        </p:nvSpPr>
        <p:spPr>
          <a:xfrm>
            <a:off x="2836651" y="2564052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MCF7 cells</a:t>
            </a:r>
          </a:p>
        </p:txBody>
      </p: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F893AAAA-BC40-4B1F-B2D2-60C0AA97ED73}"/>
              </a:ext>
            </a:extLst>
          </p:cNvPr>
          <p:cNvCxnSpPr/>
          <p:nvPr/>
        </p:nvCxnSpPr>
        <p:spPr>
          <a:xfrm>
            <a:off x="578242" y="104956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2" name="Straight Connector 251">
            <a:extLst>
              <a:ext uri="{FF2B5EF4-FFF2-40B4-BE49-F238E27FC236}">
                <a16:creationId xmlns:a16="http://schemas.microsoft.com/office/drawing/2014/main" id="{1E182F2C-B064-4527-B2E8-94C2AAEC6154}"/>
              </a:ext>
            </a:extLst>
          </p:cNvPr>
          <p:cNvCxnSpPr/>
          <p:nvPr/>
        </p:nvCxnSpPr>
        <p:spPr>
          <a:xfrm>
            <a:off x="578242" y="142883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3" name="Straight Connector 252">
            <a:extLst>
              <a:ext uri="{FF2B5EF4-FFF2-40B4-BE49-F238E27FC236}">
                <a16:creationId xmlns:a16="http://schemas.microsoft.com/office/drawing/2014/main" id="{BFC96CB0-0488-476B-9121-EC7E984C9578}"/>
              </a:ext>
            </a:extLst>
          </p:cNvPr>
          <p:cNvCxnSpPr/>
          <p:nvPr/>
        </p:nvCxnSpPr>
        <p:spPr>
          <a:xfrm>
            <a:off x="578242" y="172255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4" name="Straight Connector 253">
            <a:extLst>
              <a:ext uri="{FF2B5EF4-FFF2-40B4-BE49-F238E27FC236}">
                <a16:creationId xmlns:a16="http://schemas.microsoft.com/office/drawing/2014/main" id="{F6D1D5B0-8A7E-431C-9B77-2B2EB1A25D40}"/>
              </a:ext>
            </a:extLst>
          </p:cNvPr>
          <p:cNvCxnSpPr/>
          <p:nvPr/>
        </p:nvCxnSpPr>
        <p:spPr>
          <a:xfrm>
            <a:off x="578242" y="214800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5" name="Straight Connector 254">
            <a:extLst>
              <a:ext uri="{FF2B5EF4-FFF2-40B4-BE49-F238E27FC236}">
                <a16:creationId xmlns:a16="http://schemas.microsoft.com/office/drawing/2014/main" id="{18D4BF53-AD0B-4342-B4B1-B3D1679C4699}"/>
              </a:ext>
            </a:extLst>
          </p:cNvPr>
          <p:cNvCxnSpPr/>
          <p:nvPr/>
        </p:nvCxnSpPr>
        <p:spPr>
          <a:xfrm>
            <a:off x="578242" y="242422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grpSp>
        <p:nvGrpSpPr>
          <p:cNvPr id="257" name="Group 256">
            <a:extLst>
              <a:ext uri="{FF2B5EF4-FFF2-40B4-BE49-F238E27FC236}">
                <a16:creationId xmlns:a16="http://schemas.microsoft.com/office/drawing/2014/main" id="{B91EFC04-65F5-442F-8ED6-ECB85AE32099}"/>
              </a:ext>
            </a:extLst>
          </p:cNvPr>
          <p:cNvGrpSpPr/>
          <p:nvPr/>
        </p:nvGrpSpPr>
        <p:grpSpPr>
          <a:xfrm>
            <a:off x="1715509" y="390092"/>
            <a:ext cx="1086651" cy="576739"/>
            <a:chOff x="4695532" y="1568463"/>
            <a:chExt cx="1086651" cy="576739"/>
          </a:xfrm>
        </p:grpSpPr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17A6B613-2FA7-4CB3-B17C-0D7DB65143BE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9" name="Straight Connector 258">
              <a:extLst>
                <a:ext uri="{FF2B5EF4-FFF2-40B4-BE49-F238E27FC236}">
                  <a16:creationId xmlns:a16="http://schemas.microsoft.com/office/drawing/2014/main" id="{C8F12FF1-8035-48BF-B023-D05F60C9547F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DE49705E-D66E-491D-8D3C-D9637EF6E8FE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E5A96FC2-F600-49E0-86EF-9FDAC6CEF2C6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F2962C2C-246C-42AD-84BA-A6B87CE1BC5C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6C41003B-F069-4612-AA40-B9F0C0FA872E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A4E0477B-E945-4505-B6C1-67F861415B8C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E19897AA-F960-48DD-85EE-D1EF5D2E47F2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121F7A38-DD3F-40D9-86B1-268C421275FA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C2BC514B-B5CE-49DB-B357-9E05433DE930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AD9EDE5F-D4C0-4B1C-B599-6FD03493C869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9" name="TextBox 268">
              <a:extLst>
                <a:ext uri="{FF2B5EF4-FFF2-40B4-BE49-F238E27FC236}">
                  <a16:creationId xmlns:a16="http://schemas.microsoft.com/office/drawing/2014/main" id="{3BADC30F-A0C4-4A9B-94F1-627F9608D6BC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0" name="TextBox 269">
              <a:extLst>
                <a:ext uri="{FF2B5EF4-FFF2-40B4-BE49-F238E27FC236}">
                  <a16:creationId xmlns:a16="http://schemas.microsoft.com/office/drawing/2014/main" id="{22A4E805-431A-4212-8352-D89EBDD5756B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CCC6776D-64BD-43F3-93DA-96D9AB63D8E6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2" name="TextBox 271">
              <a:extLst>
                <a:ext uri="{FF2B5EF4-FFF2-40B4-BE49-F238E27FC236}">
                  <a16:creationId xmlns:a16="http://schemas.microsoft.com/office/drawing/2014/main" id="{DD97C88C-2354-4CE0-9CBA-4C5010B76CB5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73" name="Straight Connector 272">
              <a:extLst>
                <a:ext uri="{FF2B5EF4-FFF2-40B4-BE49-F238E27FC236}">
                  <a16:creationId xmlns:a16="http://schemas.microsoft.com/office/drawing/2014/main" id="{BDB1B9A1-7802-4103-B8BE-2668CD887CD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4" name="Group 273">
            <a:extLst>
              <a:ext uri="{FF2B5EF4-FFF2-40B4-BE49-F238E27FC236}">
                <a16:creationId xmlns:a16="http://schemas.microsoft.com/office/drawing/2014/main" id="{C603A296-BA6A-4DBA-B94F-E029A2064D84}"/>
              </a:ext>
            </a:extLst>
          </p:cNvPr>
          <p:cNvGrpSpPr/>
          <p:nvPr/>
        </p:nvGrpSpPr>
        <p:grpSpPr>
          <a:xfrm>
            <a:off x="2793468" y="390092"/>
            <a:ext cx="1086651" cy="576739"/>
            <a:chOff x="4695532" y="1568463"/>
            <a:chExt cx="1086651" cy="576739"/>
          </a:xfrm>
        </p:grpSpPr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3AA1B615-DD6D-43CE-B7FE-AACF226971F5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6" name="Straight Connector 275">
              <a:extLst>
                <a:ext uri="{FF2B5EF4-FFF2-40B4-BE49-F238E27FC236}">
                  <a16:creationId xmlns:a16="http://schemas.microsoft.com/office/drawing/2014/main" id="{697502E2-BFB6-40CD-A8A1-4C78B1BF87F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D8E7A20A-6129-4382-8196-396446406E1D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32A13FBA-ACB9-4CB7-8550-49688D5C9461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8C870079-14E3-4C63-BFBE-6A5DAAB71956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E4059C2F-1E1E-4C79-BE25-286B00CF6E4B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EAAB3D7E-8036-401D-9523-80890FC3BC04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30852BFD-3F4E-45AA-A3B2-4A7DD150C84F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A326DB40-2A82-4737-8D88-02F8870B19D2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E5F7AA4D-B456-4EF7-946A-26AFEEE68011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4607A279-CEF7-4890-A43C-5F9CF8BFD569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6" name="TextBox 285">
              <a:extLst>
                <a:ext uri="{FF2B5EF4-FFF2-40B4-BE49-F238E27FC236}">
                  <a16:creationId xmlns:a16="http://schemas.microsoft.com/office/drawing/2014/main" id="{0942B84F-50AB-445E-BE02-1D6374A8C04E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7" name="TextBox 286">
              <a:extLst>
                <a:ext uri="{FF2B5EF4-FFF2-40B4-BE49-F238E27FC236}">
                  <a16:creationId xmlns:a16="http://schemas.microsoft.com/office/drawing/2014/main" id="{66E1751E-C20C-49FE-BCF3-57D10657D8D4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2E2DCA63-B718-4663-8982-24E3DAFDCDF3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9" name="TextBox 288">
              <a:extLst>
                <a:ext uri="{FF2B5EF4-FFF2-40B4-BE49-F238E27FC236}">
                  <a16:creationId xmlns:a16="http://schemas.microsoft.com/office/drawing/2014/main" id="{2CFEA4C2-EAD2-4B9D-8F11-AB6158FBB469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90" name="Straight Connector 289">
              <a:extLst>
                <a:ext uri="{FF2B5EF4-FFF2-40B4-BE49-F238E27FC236}">
                  <a16:creationId xmlns:a16="http://schemas.microsoft.com/office/drawing/2014/main" id="{9C64C033-807E-4BBF-8C34-B9C07E750E2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91" name="Group 290">
            <a:extLst>
              <a:ext uri="{FF2B5EF4-FFF2-40B4-BE49-F238E27FC236}">
                <a16:creationId xmlns:a16="http://schemas.microsoft.com/office/drawing/2014/main" id="{49F49CC6-6C82-4F93-85EE-A93B9ACE69A8}"/>
              </a:ext>
            </a:extLst>
          </p:cNvPr>
          <p:cNvGrpSpPr/>
          <p:nvPr/>
        </p:nvGrpSpPr>
        <p:grpSpPr>
          <a:xfrm>
            <a:off x="612797" y="390092"/>
            <a:ext cx="1086651" cy="576739"/>
            <a:chOff x="4695532" y="1568463"/>
            <a:chExt cx="1086651" cy="576739"/>
          </a:xfrm>
        </p:grpSpPr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136A4A3B-828F-414B-B966-1A6BAFEC1B24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3" name="Straight Connector 292">
              <a:extLst>
                <a:ext uri="{FF2B5EF4-FFF2-40B4-BE49-F238E27FC236}">
                  <a16:creationId xmlns:a16="http://schemas.microsoft.com/office/drawing/2014/main" id="{8612C654-6BAB-4DD6-A738-CF10D058B17C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829506BC-0120-41BF-9F3F-3D68811833DD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26E5F626-2883-4D25-99A8-7DC5948962CB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9F5C28C3-228F-4B78-ABFB-77BEB19AEBEA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E8F4C1DA-7359-42DA-B6D3-6D6D638A3450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6A73B27E-40EF-4EC3-A7D0-83EECC4C9E10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02A06E58-31C4-42AC-BE74-D3971E78646C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2D343734-E60E-4C39-A5DB-026080EB2325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91038A29-1076-48DD-804A-889472924FB1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id="{520226D5-9BB8-4532-992D-B0A608966693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3" name="TextBox 302">
              <a:extLst>
                <a:ext uri="{FF2B5EF4-FFF2-40B4-BE49-F238E27FC236}">
                  <a16:creationId xmlns:a16="http://schemas.microsoft.com/office/drawing/2014/main" id="{F67F7BBC-DDF0-46F9-9564-6CCDBED5D434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04" name="TextBox 303">
              <a:extLst>
                <a:ext uri="{FF2B5EF4-FFF2-40B4-BE49-F238E27FC236}">
                  <a16:creationId xmlns:a16="http://schemas.microsoft.com/office/drawing/2014/main" id="{4FFC95BA-4884-4AE3-9DE9-1E191BFB5647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5" name="TextBox 304">
              <a:extLst>
                <a:ext uri="{FF2B5EF4-FFF2-40B4-BE49-F238E27FC236}">
                  <a16:creationId xmlns:a16="http://schemas.microsoft.com/office/drawing/2014/main" id="{89C25FF8-85F7-4917-86F8-A66B3DFADF7D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6" name="TextBox 305">
              <a:extLst>
                <a:ext uri="{FF2B5EF4-FFF2-40B4-BE49-F238E27FC236}">
                  <a16:creationId xmlns:a16="http://schemas.microsoft.com/office/drawing/2014/main" id="{9E992237-AFA7-4D0B-887C-DE9A750A193E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307" name="Straight Connector 306">
              <a:extLst>
                <a:ext uri="{FF2B5EF4-FFF2-40B4-BE49-F238E27FC236}">
                  <a16:creationId xmlns:a16="http://schemas.microsoft.com/office/drawing/2014/main" id="{376039A6-7668-46E7-8D1C-249C3DA20CB7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13" name="Picture 312">
            <a:extLst>
              <a:ext uri="{FF2B5EF4-FFF2-40B4-BE49-F238E27FC236}">
                <a16:creationId xmlns:a16="http://schemas.microsoft.com/office/drawing/2014/main" id="{815EC4A8-BCE7-4F7A-A000-C30933AF8AC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7140" t="21065" r="77003" b="59171"/>
          <a:stretch/>
        </p:blipFill>
        <p:spPr>
          <a:xfrm rot="5400000">
            <a:off x="2163648" y="915994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14" name="Picture 313">
            <a:extLst>
              <a:ext uri="{FF2B5EF4-FFF2-40B4-BE49-F238E27FC236}">
                <a16:creationId xmlns:a16="http://schemas.microsoft.com/office/drawing/2014/main" id="{AAB4141B-B8DB-49D6-BC62-E644FFD2DD93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445" t="343" r="804" b="902"/>
          <a:stretch/>
        </p:blipFill>
        <p:spPr>
          <a:xfrm rot="5400000">
            <a:off x="879094" y="3209239"/>
            <a:ext cx="2898165" cy="29954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5" name="Rectangle 314">
            <a:extLst>
              <a:ext uri="{FF2B5EF4-FFF2-40B4-BE49-F238E27FC236}">
                <a16:creationId xmlns:a16="http://schemas.microsoft.com/office/drawing/2014/main" id="{2885EB47-BF58-4D12-813E-6414C35A7A48}"/>
              </a:ext>
            </a:extLst>
          </p:cNvPr>
          <p:cNvSpPr/>
          <p:nvPr/>
        </p:nvSpPr>
        <p:spPr>
          <a:xfrm>
            <a:off x="2504905" y="3673985"/>
            <a:ext cx="768322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16" name="TextBox 315">
            <a:extLst>
              <a:ext uri="{FF2B5EF4-FFF2-40B4-BE49-F238E27FC236}">
                <a16:creationId xmlns:a16="http://schemas.microsoft.com/office/drawing/2014/main" id="{1ACA3EC8-9C27-4FEA-8E6F-42E98CEF902E}"/>
              </a:ext>
            </a:extLst>
          </p:cNvPr>
          <p:cNvSpPr txBox="1"/>
          <p:nvPr/>
        </p:nvSpPr>
        <p:spPr>
          <a:xfrm>
            <a:off x="3265787" y="3699833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016894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Picture 61">
            <a:extLst>
              <a:ext uri="{FF2B5EF4-FFF2-40B4-BE49-F238E27FC236}">
                <a16:creationId xmlns:a16="http://schemas.microsoft.com/office/drawing/2014/main" id="{2410C96C-A2BC-4818-BEF7-F275E224F9F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4" t="-36" r="777" b="-590"/>
          <a:stretch/>
        </p:blipFill>
        <p:spPr>
          <a:xfrm rot="16200000">
            <a:off x="6594246" y="201356"/>
            <a:ext cx="2491785" cy="382860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3" name="Rectangle 62">
            <a:extLst>
              <a:ext uri="{FF2B5EF4-FFF2-40B4-BE49-F238E27FC236}">
                <a16:creationId xmlns:a16="http://schemas.microsoft.com/office/drawing/2014/main" id="{8D160325-BB2C-4560-87C6-08EBF4EF3555}"/>
              </a:ext>
            </a:extLst>
          </p:cNvPr>
          <p:cNvSpPr/>
          <p:nvPr/>
        </p:nvSpPr>
        <p:spPr>
          <a:xfrm>
            <a:off x="6496110" y="1290803"/>
            <a:ext cx="827146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4" name="Picture 63">
            <a:extLst>
              <a:ext uri="{FF2B5EF4-FFF2-40B4-BE49-F238E27FC236}">
                <a16:creationId xmlns:a16="http://schemas.microsoft.com/office/drawing/2014/main" id="{89C90F31-EB23-431A-8DF9-F48F5770FDB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59" t="589" r="440" b="292"/>
          <a:stretch/>
        </p:blipFill>
        <p:spPr>
          <a:xfrm rot="16200000">
            <a:off x="816188" y="3161094"/>
            <a:ext cx="2461438" cy="355992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Rectangle 64">
            <a:extLst>
              <a:ext uri="{FF2B5EF4-FFF2-40B4-BE49-F238E27FC236}">
                <a16:creationId xmlns:a16="http://schemas.microsoft.com/office/drawing/2014/main" id="{DA32AF73-5BF4-456B-A0A4-A60CC3A3FBF7}"/>
              </a:ext>
            </a:extLst>
          </p:cNvPr>
          <p:cNvSpPr/>
          <p:nvPr/>
        </p:nvSpPr>
        <p:spPr>
          <a:xfrm>
            <a:off x="858416" y="4147492"/>
            <a:ext cx="827361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6" name="Picture 65">
            <a:extLst>
              <a:ext uri="{FF2B5EF4-FFF2-40B4-BE49-F238E27FC236}">
                <a16:creationId xmlns:a16="http://schemas.microsoft.com/office/drawing/2014/main" id="{D27ACD38-F5E7-4563-A5DA-040AC821DC7C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6" t="-114" r="455" b="454"/>
          <a:stretch/>
        </p:blipFill>
        <p:spPr>
          <a:xfrm rot="16200000">
            <a:off x="4843554" y="3070903"/>
            <a:ext cx="2504891" cy="375769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7" name="Rectangle 66">
            <a:extLst>
              <a:ext uri="{FF2B5EF4-FFF2-40B4-BE49-F238E27FC236}">
                <a16:creationId xmlns:a16="http://schemas.microsoft.com/office/drawing/2014/main" id="{77BF5882-C2D4-4A71-A568-470587656CA1}"/>
              </a:ext>
            </a:extLst>
          </p:cNvPr>
          <p:cNvSpPr/>
          <p:nvPr/>
        </p:nvSpPr>
        <p:spPr>
          <a:xfrm>
            <a:off x="4920342" y="5140637"/>
            <a:ext cx="795641" cy="2458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68" name="Picture 67">
            <a:extLst>
              <a:ext uri="{FF2B5EF4-FFF2-40B4-BE49-F238E27FC236}">
                <a16:creationId xmlns:a16="http://schemas.microsoft.com/office/drawing/2014/main" id="{A0C01521-EF6E-42BB-B1F4-F709E0AC52B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9" t="-166" r="-249" b="587"/>
          <a:stretch/>
        </p:blipFill>
        <p:spPr>
          <a:xfrm rot="16200000">
            <a:off x="8876027" y="3018110"/>
            <a:ext cx="2503396" cy="386178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9" name="Rectangle 68">
            <a:extLst>
              <a:ext uri="{FF2B5EF4-FFF2-40B4-BE49-F238E27FC236}">
                <a16:creationId xmlns:a16="http://schemas.microsoft.com/office/drawing/2014/main" id="{981C9096-FF6D-4812-AEAF-B6C5B088DE7F}"/>
              </a:ext>
            </a:extLst>
          </p:cNvPr>
          <p:cNvSpPr/>
          <p:nvPr/>
        </p:nvSpPr>
        <p:spPr>
          <a:xfrm>
            <a:off x="8783216" y="4561517"/>
            <a:ext cx="818968" cy="245885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09C8AE47-28B4-4C32-B6E4-17D2661D8267}"/>
              </a:ext>
            </a:extLst>
          </p:cNvPr>
          <p:cNvSpPr txBox="1"/>
          <p:nvPr/>
        </p:nvSpPr>
        <p:spPr>
          <a:xfrm>
            <a:off x="6866630" y="1565002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ACEAC6CD-B5BA-40BB-97FC-1423D0039675}"/>
              </a:ext>
            </a:extLst>
          </p:cNvPr>
          <p:cNvSpPr txBox="1"/>
          <p:nvPr/>
        </p:nvSpPr>
        <p:spPr>
          <a:xfrm>
            <a:off x="1239056" y="4453157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E3922D4D-C940-4B56-B37F-100354D0984E}"/>
              </a:ext>
            </a:extLst>
          </p:cNvPr>
          <p:cNvSpPr txBox="1"/>
          <p:nvPr/>
        </p:nvSpPr>
        <p:spPr>
          <a:xfrm>
            <a:off x="5301030" y="5495670"/>
            <a:ext cx="33808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73" name="TextBox 72">
            <a:extLst>
              <a:ext uri="{FF2B5EF4-FFF2-40B4-BE49-F238E27FC236}">
                <a16:creationId xmlns:a16="http://schemas.microsoft.com/office/drawing/2014/main" id="{8B6BB798-A8E3-4910-A32F-E5DB308B3D98}"/>
              </a:ext>
            </a:extLst>
          </p:cNvPr>
          <p:cNvSpPr txBox="1"/>
          <p:nvPr/>
        </p:nvSpPr>
        <p:spPr>
          <a:xfrm>
            <a:off x="9151488" y="4853616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pic>
        <p:nvPicPr>
          <p:cNvPr id="136" name="Picture 135">
            <a:extLst>
              <a:ext uri="{FF2B5EF4-FFF2-40B4-BE49-F238E27FC236}">
                <a16:creationId xmlns:a16="http://schemas.microsoft.com/office/drawing/2014/main" id="{2C5A8715-2CA1-4843-AED4-FD708EAF11E4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2" t="410" r="-331" b="754"/>
          <a:stretch/>
        </p:blipFill>
        <p:spPr>
          <a:xfrm rot="5400000">
            <a:off x="9821061" y="1091546"/>
            <a:ext cx="2399449" cy="201339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7" name="Rectangle 136">
            <a:extLst>
              <a:ext uri="{FF2B5EF4-FFF2-40B4-BE49-F238E27FC236}">
                <a16:creationId xmlns:a16="http://schemas.microsoft.com/office/drawing/2014/main" id="{EE7931CA-E2AE-4FCB-AE0E-2C7337063594}"/>
              </a:ext>
            </a:extLst>
          </p:cNvPr>
          <p:cNvSpPr/>
          <p:nvPr/>
        </p:nvSpPr>
        <p:spPr>
          <a:xfrm>
            <a:off x="10529611" y="1754212"/>
            <a:ext cx="800161" cy="29752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C08CE126-42A0-4ED0-ACE5-CD808E75F928}"/>
              </a:ext>
            </a:extLst>
          </p:cNvPr>
          <p:cNvSpPr txBox="1"/>
          <p:nvPr/>
        </p:nvSpPr>
        <p:spPr>
          <a:xfrm>
            <a:off x="10875653" y="1529710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BCC5B19A-A3A9-4DBA-8960-BFA7BCD1AE6B}"/>
              </a:ext>
            </a:extLst>
          </p:cNvPr>
          <p:cNvSpPr txBox="1"/>
          <p:nvPr/>
        </p:nvSpPr>
        <p:spPr>
          <a:xfrm>
            <a:off x="265087" y="1435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23" name="TextBox 222">
            <a:extLst>
              <a:ext uri="{FF2B5EF4-FFF2-40B4-BE49-F238E27FC236}">
                <a16:creationId xmlns:a16="http://schemas.microsoft.com/office/drawing/2014/main" id="{C3992B62-6A5F-4F07-B9CA-5E7FEEE6E173}"/>
              </a:ext>
            </a:extLst>
          </p:cNvPr>
          <p:cNvSpPr txBox="1"/>
          <p:nvPr/>
        </p:nvSpPr>
        <p:spPr>
          <a:xfrm>
            <a:off x="279350" y="935861"/>
            <a:ext cx="311592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sp>
        <p:nvSpPr>
          <p:cNvPr id="224" name="TextBox 223">
            <a:extLst>
              <a:ext uri="{FF2B5EF4-FFF2-40B4-BE49-F238E27FC236}">
                <a16:creationId xmlns:a16="http://schemas.microsoft.com/office/drawing/2014/main" id="{C0FD1C55-43FA-45C2-B5E1-B4C49ADF5185}"/>
              </a:ext>
            </a:extLst>
          </p:cNvPr>
          <p:cNvSpPr txBox="1"/>
          <p:nvPr/>
        </p:nvSpPr>
        <p:spPr>
          <a:xfrm>
            <a:off x="3919390" y="1376797"/>
            <a:ext cx="50045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5" name="TextBox 224">
            <a:extLst>
              <a:ext uri="{FF2B5EF4-FFF2-40B4-BE49-F238E27FC236}">
                <a16:creationId xmlns:a16="http://schemas.microsoft.com/office/drawing/2014/main" id="{F3A13860-210E-49DF-90ED-1518A828A436}"/>
              </a:ext>
            </a:extLst>
          </p:cNvPr>
          <p:cNvSpPr txBox="1"/>
          <p:nvPr/>
        </p:nvSpPr>
        <p:spPr>
          <a:xfrm>
            <a:off x="3919390" y="1694022"/>
            <a:ext cx="446721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-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6" name="TextBox 225">
            <a:extLst>
              <a:ext uri="{FF2B5EF4-FFF2-40B4-BE49-F238E27FC236}">
                <a16:creationId xmlns:a16="http://schemas.microsoft.com/office/drawing/2014/main" id="{9C7E5E34-32B8-496C-9203-CB33A34EA8A2}"/>
              </a:ext>
            </a:extLst>
          </p:cNvPr>
          <p:cNvSpPr txBox="1"/>
          <p:nvPr/>
        </p:nvSpPr>
        <p:spPr>
          <a:xfrm>
            <a:off x="3919390" y="2011246"/>
            <a:ext cx="338088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</a:p>
        </p:txBody>
      </p:sp>
      <p:sp>
        <p:nvSpPr>
          <p:cNvPr id="227" name="TextBox 226">
            <a:extLst>
              <a:ext uri="{FF2B5EF4-FFF2-40B4-BE49-F238E27FC236}">
                <a16:creationId xmlns:a16="http://schemas.microsoft.com/office/drawing/2014/main" id="{C3A040E5-8FC4-404B-A50B-487031B3827F}"/>
              </a:ext>
            </a:extLst>
          </p:cNvPr>
          <p:cNvSpPr txBox="1"/>
          <p:nvPr/>
        </p:nvSpPr>
        <p:spPr>
          <a:xfrm>
            <a:off x="3919390" y="2328472"/>
            <a:ext cx="450696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Actin</a:t>
            </a:r>
          </a:p>
        </p:txBody>
      </p:sp>
      <p:sp>
        <p:nvSpPr>
          <p:cNvPr id="228" name="TextBox 227">
            <a:extLst>
              <a:ext uri="{FF2B5EF4-FFF2-40B4-BE49-F238E27FC236}">
                <a16:creationId xmlns:a16="http://schemas.microsoft.com/office/drawing/2014/main" id="{10AA22CF-C02E-4940-9A2A-65459613C14F}"/>
              </a:ext>
            </a:extLst>
          </p:cNvPr>
          <p:cNvSpPr txBox="1"/>
          <p:nvPr/>
        </p:nvSpPr>
        <p:spPr>
          <a:xfrm>
            <a:off x="333667" y="1317695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29" name="TextBox 228">
            <a:extLst>
              <a:ext uri="{FF2B5EF4-FFF2-40B4-BE49-F238E27FC236}">
                <a16:creationId xmlns:a16="http://schemas.microsoft.com/office/drawing/2014/main" id="{810B3DD6-1F1B-4B29-9579-E25E2ABF27AB}"/>
              </a:ext>
            </a:extLst>
          </p:cNvPr>
          <p:cNvSpPr txBox="1"/>
          <p:nvPr/>
        </p:nvSpPr>
        <p:spPr>
          <a:xfrm>
            <a:off x="333667" y="1618045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98</a:t>
            </a:r>
          </a:p>
        </p:txBody>
      </p:sp>
      <p:sp>
        <p:nvSpPr>
          <p:cNvPr id="230" name="TextBox 229">
            <a:extLst>
              <a:ext uri="{FF2B5EF4-FFF2-40B4-BE49-F238E27FC236}">
                <a16:creationId xmlns:a16="http://schemas.microsoft.com/office/drawing/2014/main" id="{0F022014-DC5F-4DCD-9D37-D8B6FB2E3040}"/>
              </a:ext>
            </a:extLst>
          </p:cNvPr>
          <p:cNvSpPr txBox="1"/>
          <p:nvPr/>
        </p:nvSpPr>
        <p:spPr>
          <a:xfrm>
            <a:off x="333667" y="2031929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50</a:t>
            </a:r>
          </a:p>
        </p:txBody>
      </p:sp>
      <p:sp>
        <p:nvSpPr>
          <p:cNvPr id="231" name="TextBox 230">
            <a:extLst>
              <a:ext uri="{FF2B5EF4-FFF2-40B4-BE49-F238E27FC236}">
                <a16:creationId xmlns:a16="http://schemas.microsoft.com/office/drawing/2014/main" id="{E26CBD2D-3065-4C3B-B9D7-9C80DF66101F}"/>
              </a:ext>
            </a:extLst>
          </p:cNvPr>
          <p:cNvSpPr txBox="1"/>
          <p:nvPr/>
        </p:nvSpPr>
        <p:spPr>
          <a:xfrm>
            <a:off x="333667" y="2310388"/>
            <a:ext cx="25860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232" name="TextBox 231">
            <a:extLst>
              <a:ext uri="{FF2B5EF4-FFF2-40B4-BE49-F238E27FC236}">
                <a16:creationId xmlns:a16="http://schemas.microsoft.com/office/drawing/2014/main" id="{875F88B8-F20C-4796-9D55-8CE3389A4FAB}"/>
              </a:ext>
            </a:extLst>
          </p:cNvPr>
          <p:cNvSpPr txBox="1"/>
          <p:nvPr/>
        </p:nvSpPr>
        <p:spPr>
          <a:xfrm>
            <a:off x="3919390" y="1055737"/>
            <a:ext cx="45467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233" name="TextBox 232">
            <a:extLst>
              <a:ext uri="{FF2B5EF4-FFF2-40B4-BE49-F238E27FC236}">
                <a16:creationId xmlns:a16="http://schemas.microsoft.com/office/drawing/2014/main" id="{DD4AF3F0-13CC-4ADB-A7FB-29AE1390DB1E}"/>
              </a:ext>
            </a:extLst>
          </p:cNvPr>
          <p:cNvSpPr txBox="1"/>
          <p:nvPr/>
        </p:nvSpPr>
        <p:spPr>
          <a:xfrm>
            <a:off x="266650" y="775742"/>
            <a:ext cx="322190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4" name="TextBox 233">
            <a:extLst>
              <a:ext uri="{FF2B5EF4-FFF2-40B4-BE49-F238E27FC236}">
                <a16:creationId xmlns:a16="http://schemas.microsoft.com/office/drawing/2014/main" id="{FD8F5F82-7C20-4A6A-8187-0DF09FB7150F}"/>
              </a:ext>
            </a:extLst>
          </p:cNvPr>
          <p:cNvSpPr txBox="1"/>
          <p:nvPr/>
        </p:nvSpPr>
        <p:spPr>
          <a:xfrm>
            <a:off x="3936883" y="803147"/>
            <a:ext cx="783219" cy="1907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sgRNA</a:t>
            </a:r>
          </a:p>
        </p:txBody>
      </p:sp>
      <p:sp>
        <p:nvSpPr>
          <p:cNvPr id="235" name="TextBox 234">
            <a:extLst>
              <a:ext uri="{FF2B5EF4-FFF2-40B4-BE49-F238E27FC236}">
                <a16:creationId xmlns:a16="http://schemas.microsoft.com/office/drawing/2014/main" id="{860A08B9-B128-405D-B815-3A7D458A8DC6}"/>
              </a:ext>
            </a:extLst>
          </p:cNvPr>
          <p:cNvSpPr txBox="1"/>
          <p:nvPr/>
        </p:nvSpPr>
        <p:spPr>
          <a:xfrm>
            <a:off x="3936883" y="646696"/>
            <a:ext cx="8980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IF1</a:t>
            </a:r>
            <a:r>
              <a:rPr lang="el-GR" sz="900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sgRNA</a:t>
            </a:r>
          </a:p>
        </p:txBody>
      </p:sp>
      <p:sp>
        <p:nvSpPr>
          <p:cNvPr id="236" name="TextBox 235">
            <a:extLst>
              <a:ext uri="{FF2B5EF4-FFF2-40B4-BE49-F238E27FC236}">
                <a16:creationId xmlns:a16="http://schemas.microsoft.com/office/drawing/2014/main" id="{FC346D24-BD5C-43B1-8BAD-46EBC822E3D0}"/>
              </a:ext>
            </a:extLst>
          </p:cNvPr>
          <p:cNvSpPr txBox="1"/>
          <p:nvPr/>
        </p:nvSpPr>
        <p:spPr>
          <a:xfrm>
            <a:off x="605181" y="2554184"/>
            <a:ext cx="72327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La cells</a:t>
            </a:r>
          </a:p>
        </p:txBody>
      </p:sp>
      <p:pic>
        <p:nvPicPr>
          <p:cNvPr id="241" name="Picture 240">
            <a:extLst>
              <a:ext uri="{FF2B5EF4-FFF2-40B4-BE49-F238E27FC236}">
                <a16:creationId xmlns:a16="http://schemas.microsoft.com/office/drawing/2014/main" id="{AD7C8C3A-F72B-41D1-81A7-C1781D14050B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315" t="19555" r="59665" b="60068"/>
          <a:stretch/>
        </p:blipFill>
        <p:spPr>
          <a:xfrm rot="16200000">
            <a:off x="3270666" y="1557010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2" name="Picture 241">
            <a:extLst>
              <a:ext uri="{FF2B5EF4-FFF2-40B4-BE49-F238E27FC236}">
                <a16:creationId xmlns:a16="http://schemas.microsoft.com/office/drawing/2014/main" id="{0FED5FBC-D473-4B9E-B266-30161C05BC49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715" t="18114" r="19219" b="60494"/>
          <a:stretch/>
        </p:blipFill>
        <p:spPr>
          <a:xfrm rot="16200000">
            <a:off x="3270666" y="1236923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3" name="Picture 242">
            <a:extLst>
              <a:ext uri="{FF2B5EF4-FFF2-40B4-BE49-F238E27FC236}">
                <a16:creationId xmlns:a16="http://schemas.microsoft.com/office/drawing/2014/main" id="{C8E988D0-0049-4C16-864C-F6138CCA341F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2647" t="15836" r="19242" b="63628"/>
          <a:stretch/>
        </p:blipFill>
        <p:spPr>
          <a:xfrm rot="16200000">
            <a:off x="3270666" y="596749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4" name="Picture 243">
            <a:extLst>
              <a:ext uri="{FF2B5EF4-FFF2-40B4-BE49-F238E27FC236}">
                <a16:creationId xmlns:a16="http://schemas.microsoft.com/office/drawing/2014/main" id="{1D5CF157-D796-4892-AD33-CB6B22F8C39A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835" t="15002" r="33085" b="63845"/>
          <a:stretch/>
        </p:blipFill>
        <p:spPr>
          <a:xfrm rot="16200000">
            <a:off x="3270666" y="1877098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5" name="TextBox 244">
            <a:extLst>
              <a:ext uri="{FF2B5EF4-FFF2-40B4-BE49-F238E27FC236}">
                <a16:creationId xmlns:a16="http://schemas.microsoft.com/office/drawing/2014/main" id="{185BD777-EB96-4ED1-B7CC-5156BB70BD8A}"/>
              </a:ext>
            </a:extLst>
          </p:cNvPr>
          <p:cNvSpPr txBox="1"/>
          <p:nvPr/>
        </p:nvSpPr>
        <p:spPr>
          <a:xfrm>
            <a:off x="1731689" y="2564050"/>
            <a:ext cx="71686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A549 cells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D8D62EE1-AFCC-4011-A435-C3324BFEF0A2}"/>
              </a:ext>
            </a:extLst>
          </p:cNvPr>
          <p:cNvSpPr txBox="1"/>
          <p:nvPr/>
        </p:nvSpPr>
        <p:spPr>
          <a:xfrm>
            <a:off x="2836651" y="2564052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MCF7 cells</a:t>
            </a:r>
          </a:p>
        </p:txBody>
      </p:sp>
      <p:cxnSp>
        <p:nvCxnSpPr>
          <p:cNvPr id="247" name="Straight Connector 246">
            <a:extLst>
              <a:ext uri="{FF2B5EF4-FFF2-40B4-BE49-F238E27FC236}">
                <a16:creationId xmlns:a16="http://schemas.microsoft.com/office/drawing/2014/main" id="{E1937D9A-00A3-450A-8D49-24F80F0144EB}"/>
              </a:ext>
            </a:extLst>
          </p:cNvPr>
          <p:cNvCxnSpPr/>
          <p:nvPr/>
        </p:nvCxnSpPr>
        <p:spPr>
          <a:xfrm>
            <a:off x="578242" y="104956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8" name="Straight Connector 247">
            <a:extLst>
              <a:ext uri="{FF2B5EF4-FFF2-40B4-BE49-F238E27FC236}">
                <a16:creationId xmlns:a16="http://schemas.microsoft.com/office/drawing/2014/main" id="{EC568E1E-F3F8-4B89-B343-73BA40BBDDBA}"/>
              </a:ext>
            </a:extLst>
          </p:cNvPr>
          <p:cNvCxnSpPr/>
          <p:nvPr/>
        </p:nvCxnSpPr>
        <p:spPr>
          <a:xfrm>
            <a:off x="578242" y="142883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49" name="Straight Connector 248">
            <a:extLst>
              <a:ext uri="{FF2B5EF4-FFF2-40B4-BE49-F238E27FC236}">
                <a16:creationId xmlns:a16="http://schemas.microsoft.com/office/drawing/2014/main" id="{C2717A98-A91C-46B9-9AE4-440EE544589A}"/>
              </a:ext>
            </a:extLst>
          </p:cNvPr>
          <p:cNvCxnSpPr/>
          <p:nvPr/>
        </p:nvCxnSpPr>
        <p:spPr>
          <a:xfrm>
            <a:off x="578242" y="172255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0" name="Straight Connector 249">
            <a:extLst>
              <a:ext uri="{FF2B5EF4-FFF2-40B4-BE49-F238E27FC236}">
                <a16:creationId xmlns:a16="http://schemas.microsoft.com/office/drawing/2014/main" id="{3E4E18AD-3E7B-4D90-B1D8-8AFDB21BDA2B}"/>
              </a:ext>
            </a:extLst>
          </p:cNvPr>
          <p:cNvCxnSpPr/>
          <p:nvPr/>
        </p:nvCxnSpPr>
        <p:spPr>
          <a:xfrm>
            <a:off x="578242" y="214800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1" name="Straight Connector 250">
            <a:extLst>
              <a:ext uri="{FF2B5EF4-FFF2-40B4-BE49-F238E27FC236}">
                <a16:creationId xmlns:a16="http://schemas.microsoft.com/office/drawing/2014/main" id="{3E28EE00-E217-492E-8253-0E69675A990F}"/>
              </a:ext>
            </a:extLst>
          </p:cNvPr>
          <p:cNvCxnSpPr/>
          <p:nvPr/>
        </p:nvCxnSpPr>
        <p:spPr>
          <a:xfrm>
            <a:off x="578242" y="242422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252" name="Picture 251">
            <a:extLst>
              <a:ext uri="{FF2B5EF4-FFF2-40B4-BE49-F238E27FC236}">
                <a16:creationId xmlns:a16="http://schemas.microsoft.com/office/drawing/2014/main" id="{A23E2037-B7F4-4CCE-AF90-EEFDF2785EA8}"/>
              </a:ext>
            </a:extLst>
          </p:cNvPr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948" t="34726" r="53522" b="27620"/>
          <a:stretch/>
        </p:blipFill>
        <p:spPr>
          <a:xfrm rot="5400000">
            <a:off x="3270666" y="916836"/>
            <a:ext cx="298800" cy="1062000"/>
          </a:xfrm>
          <a:prstGeom prst="rect">
            <a:avLst/>
          </a:prstGeom>
          <a:ln>
            <a:solidFill>
              <a:schemeClr val="tx1"/>
            </a:solidFill>
          </a:ln>
        </p:spPr>
      </p:pic>
      <p:grpSp>
        <p:nvGrpSpPr>
          <p:cNvPr id="253" name="Group 252">
            <a:extLst>
              <a:ext uri="{FF2B5EF4-FFF2-40B4-BE49-F238E27FC236}">
                <a16:creationId xmlns:a16="http://schemas.microsoft.com/office/drawing/2014/main" id="{74CBDDAD-6BA2-4DE0-87F6-34D38704BCFB}"/>
              </a:ext>
            </a:extLst>
          </p:cNvPr>
          <p:cNvGrpSpPr/>
          <p:nvPr/>
        </p:nvGrpSpPr>
        <p:grpSpPr>
          <a:xfrm>
            <a:off x="1715509" y="390092"/>
            <a:ext cx="1086651" cy="576739"/>
            <a:chOff x="4695532" y="1568463"/>
            <a:chExt cx="1086651" cy="576739"/>
          </a:xfrm>
        </p:grpSpPr>
        <p:sp>
          <p:nvSpPr>
            <p:cNvPr id="254" name="TextBox 253">
              <a:extLst>
                <a:ext uri="{FF2B5EF4-FFF2-40B4-BE49-F238E27FC236}">
                  <a16:creationId xmlns:a16="http://schemas.microsoft.com/office/drawing/2014/main" id="{75E8C863-67D2-49DA-87A5-E013012EB70C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55" name="Straight Connector 254">
              <a:extLst>
                <a:ext uri="{FF2B5EF4-FFF2-40B4-BE49-F238E27FC236}">
                  <a16:creationId xmlns:a16="http://schemas.microsoft.com/office/drawing/2014/main" id="{FF408597-6061-486B-BBD8-F9636B26237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6" name="TextBox 255">
              <a:extLst>
                <a:ext uri="{FF2B5EF4-FFF2-40B4-BE49-F238E27FC236}">
                  <a16:creationId xmlns:a16="http://schemas.microsoft.com/office/drawing/2014/main" id="{D2146942-54AC-48CB-B4AC-F10F5F7752E5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7" name="TextBox 256">
              <a:extLst>
                <a:ext uri="{FF2B5EF4-FFF2-40B4-BE49-F238E27FC236}">
                  <a16:creationId xmlns:a16="http://schemas.microsoft.com/office/drawing/2014/main" id="{4E3CF6E8-B72E-4803-8A32-B32BBA5E5044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58" name="TextBox 257">
              <a:extLst>
                <a:ext uri="{FF2B5EF4-FFF2-40B4-BE49-F238E27FC236}">
                  <a16:creationId xmlns:a16="http://schemas.microsoft.com/office/drawing/2014/main" id="{03463E2A-B313-49E0-B0DC-DD20AE2C852D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59" name="TextBox 258">
              <a:extLst>
                <a:ext uri="{FF2B5EF4-FFF2-40B4-BE49-F238E27FC236}">
                  <a16:creationId xmlns:a16="http://schemas.microsoft.com/office/drawing/2014/main" id="{BE42B2F5-241D-4B87-9FFD-FE710F671607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0" name="TextBox 259">
              <a:extLst>
                <a:ext uri="{FF2B5EF4-FFF2-40B4-BE49-F238E27FC236}">
                  <a16:creationId xmlns:a16="http://schemas.microsoft.com/office/drawing/2014/main" id="{11E2FBAF-1A2C-4996-847E-35BF03225BC3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1" name="TextBox 260">
              <a:extLst>
                <a:ext uri="{FF2B5EF4-FFF2-40B4-BE49-F238E27FC236}">
                  <a16:creationId xmlns:a16="http://schemas.microsoft.com/office/drawing/2014/main" id="{A2DE7A7B-58B6-4040-A6D3-FC6045BC5E70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62" name="TextBox 261">
              <a:extLst>
                <a:ext uri="{FF2B5EF4-FFF2-40B4-BE49-F238E27FC236}">
                  <a16:creationId xmlns:a16="http://schemas.microsoft.com/office/drawing/2014/main" id="{CCE5A14E-5F01-4B07-83E5-B15730513FC1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3" name="TextBox 262">
              <a:extLst>
                <a:ext uri="{FF2B5EF4-FFF2-40B4-BE49-F238E27FC236}">
                  <a16:creationId xmlns:a16="http://schemas.microsoft.com/office/drawing/2014/main" id="{C158ACB5-05B6-4EA5-98B8-622713317413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4" name="TextBox 263">
              <a:extLst>
                <a:ext uri="{FF2B5EF4-FFF2-40B4-BE49-F238E27FC236}">
                  <a16:creationId xmlns:a16="http://schemas.microsoft.com/office/drawing/2014/main" id="{34338B15-7A16-43B9-BA20-60A6ED197A58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5" name="TextBox 264">
              <a:extLst>
                <a:ext uri="{FF2B5EF4-FFF2-40B4-BE49-F238E27FC236}">
                  <a16:creationId xmlns:a16="http://schemas.microsoft.com/office/drawing/2014/main" id="{D6ADBA40-D061-457A-A760-9354FE102627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66" name="TextBox 265">
              <a:extLst>
                <a:ext uri="{FF2B5EF4-FFF2-40B4-BE49-F238E27FC236}">
                  <a16:creationId xmlns:a16="http://schemas.microsoft.com/office/drawing/2014/main" id="{643F8964-9B75-4302-96E2-B8D83BC4689A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7" name="TextBox 266">
              <a:extLst>
                <a:ext uri="{FF2B5EF4-FFF2-40B4-BE49-F238E27FC236}">
                  <a16:creationId xmlns:a16="http://schemas.microsoft.com/office/drawing/2014/main" id="{5F49E196-8E2F-434A-BA58-8AE52CA75E8D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68" name="TextBox 267">
              <a:extLst>
                <a:ext uri="{FF2B5EF4-FFF2-40B4-BE49-F238E27FC236}">
                  <a16:creationId xmlns:a16="http://schemas.microsoft.com/office/drawing/2014/main" id="{52ACA5F2-1354-4CE8-80CF-9CC884455B5A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69" name="Straight Connector 268">
              <a:extLst>
                <a:ext uri="{FF2B5EF4-FFF2-40B4-BE49-F238E27FC236}">
                  <a16:creationId xmlns:a16="http://schemas.microsoft.com/office/drawing/2014/main" id="{B880FEB2-9FF1-452D-96A0-D5BE6527B835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0" name="Group 269">
            <a:extLst>
              <a:ext uri="{FF2B5EF4-FFF2-40B4-BE49-F238E27FC236}">
                <a16:creationId xmlns:a16="http://schemas.microsoft.com/office/drawing/2014/main" id="{208B72F9-D9B4-4FED-ACE2-6E2CDC836167}"/>
              </a:ext>
            </a:extLst>
          </p:cNvPr>
          <p:cNvGrpSpPr/>
          <p:nvPr/>
        </p:nvGrpSpPr>
        <p:grpSpPr>
          <a:xfrm>
            <a:off x="2793468" y="390092"/>
            <a:ext cx="1086651" cy="576739"/>
            <a:chOff x="4695532" y="1568463"/>
            <a:chExt cx="1086651" cy="576739"/>
          </a:xfrm>
        </p:grpSpPr>
        <p:sp>
          <p:nvSpPr>
            <p:cNvPr id="271" name="TextBox 270">
              <a:extLst>
                <a:ext uri="{FF2B5EF4-FFF2-40B4-BE49-F238E27FC236}">
                  <a16:creationId xmlns:a16="http://schemas.microsoft.com/office/drawing/2014/main" id="{F6F0D9BF-4FA6-475D-B921-6184834C22AC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72" name="Straight Connector 271">
              <a:extLst>
                <a:ext uri="{FF2B5EF4-FFF2-40B4-BE49-F238E27FC236}">
                  <a16:creationId xmlns:a16="http://schemas.microsoft.com/office/drawing/2014/main" id="{293245EE-D297-4085-B615-9425DAB9BD40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3" name="TextBox 272">
              <a:extLst>
                <a:ext uri="{FF2B5EF4-FFF2-40B4-BE49-F238E27FC236}">
                  <a16:creationId xmlns:a16="http://schemas.microsoft.com/office/drawing/2014/main" id="{02B04772-5ED4-430E-B6CC-6FE14A9D4ED4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74" name="TextBox 273">
              <a:extLst>
                <a:ext uri="{FF2B5EF4-FFF2-40B4-BE49-F238E27FC236}">
                  <a16:creationId xmlns:a16="http://schemas.microsoft.com/office/drawing/2014/main" id="{58DDE49D-55D5-4869-A6DD-A0574CE14379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5" name="TextBox 274">
              <a:extLst>
                <a:ext uri="{FF2B5EF4-FFF2-40B4-BE49-F238E27FC236}">
                  <a16:creationId xmlns:a16="http://schemas.microsoft.com/office/drawing/2014/main" id="{AD2380AC-3DC5-4D69-AD82-396BC8412D18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6" name="TextBox 275">
              <a:extLst>
                <a:ext uri="{FF2B5EF4-FFF2-40B4-BE49-F238E27FC236}">
                  <a16:creationId xmlns:a16="http://schemas.microsoft.com/office/drawing/2014/main" id="{09D1C598-9786-49B2-93D0-92F5D23794C4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7" name="TextBox 276">
              <a:extLst>
                <a:ext uri="{FF2B5EF4-FFF2-40B4-BE49-F238E27FC236}">
                  <a16:creationId xmlns:a16="http://schemas.microsoft.com/office/drawing/2014/main" id="{78435925-DB3C-4810-854F-C0F520E5C8A2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78" name="TextBox 277">
              <a:extLst>
                <a:ext uri="{FF2B5EF4-FFF2-40B4-BE49-F238E27FC236}">
                  <a16:creationId xmlns:a16="http://schemas.microsoft.com/office/drawing/2014/main" id="{9A9E555F-FDA5-45AD-9F48-B5B8CFE096D6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79" name="TextBox 278">
              <a:extLst>
                <a:ext uri="{FF2B5EF4-FFF2-40B4-BE49-F238E27FC236}">
                  <a16:creationId xmlns:a16="http://schemas.microsoft.com/office/drawing/2014/main" id="{6FBAF9C9-78DB-4599-9DC7-B2B8DE076C91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0" name="TextBox 279">
              <a:extLst>
                <a:ext uri="{FF2B5EF4-FFF2-40B4-BE49-F238E27FC236}">
                  <a16:creationId xmlns:a16="http://schemas.microsoft.com/office/drawing/2014/main" id="{DF1F02E0-E300-490B-BC83-E6A75FA28BE4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1" name="TextBox 280">
              <a:extLst>
                <a:ext uri="{FF2B5EF4-FFF2-40B4-BE49-F238E27FC236}">
                  <a16:creationId xmlns:a16="http://schemas.microsoft.com/office/drawing/2014/main" id="{176A4CC9-4015-442B-AAE7-7A0A3D530181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2" name="TextBox 281">
              <a:extLst>
                <a:ext uri="{FF2B5EF4-FFF2-40B4-BE49-F238E27FC236}">
                  <a16:creationId xmlns:a16="http://schemas.microsoft.com/office/drawing/2014/main" id="{DFCB639B-D057-4699-9484-0FACB1CDBAFE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83" name="TextBox 282">
              <a:extLst>
                <a:ext uri="{FF2B5EF4-FFF2-40B4-BE49-F238E27FC236}">
                  <a16:creationId xmlns:a16="http://schemas.microsoft.com/office/drawing/2014/main" id="{C8D22E97-D768-4A10-9D12-FDB3B74CA4FC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4" name="TextBox 283">
              <a:extLst>
                <a:ext uri="{FF2B5EF4-FFF2-40B4-BE49-F238E27FC236}">
                  <a16:creationId xmlns:a16="http://schemas.microsoft.com/office/drawing/2014/main" id="{D6E2D8FE-E4B9-4167-A661-8EA51A568E18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85" name="TextBox 284">
              <a:extLst>
                <a:ext uri="{FF2B5EF4-FFF2-40B4-BE49-F238E27FC236}">
                  <a16:creationId xmlns:a16="http://schemas.microsoft.com/office/drawing/2014/main" id="{981FAFE0-C272-4E9E-B74B-A42DD4CC0D5D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286" name="Straight Connector 285">
              <a:extLst>
                <a:ext uri="{FF2B5EF4-FFF2-40B4-BE49-F238E27FC236}">
                  <a16:creationId xmlns:a16="http://schemas.microsoft.com/office/drawing/2014/main" id="{FA4E92A4-3B74-41B2-80BB-8804C51BEEB4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7" name="Group 286">
            <a:extLst>
              <a:ext uri="{FF2B5EF4-FFF2-40B4-BE49-F238E27FC236}">
                <a16:creationId xmlns:a16="http://schemas.microsoft.com/office/drawing/2014/main" id="{846D8B2D-F058-487C-B882-180327A987E6}"/>
              </a:ext>
            </a:extLst>
          </p:cNvPr>
          <p:cNvGrpSpPr/>
          <p:nvPr/>
        </p:nvGrpSpPr>
        <p:grpSpPr>
          <a:xfrm>
            <a:off x="612797" y="390092"/>
            <a:ext cx="1086651" cy="576739"/>
            <a:chOff x="4695532" y="1568463"/>
            <a:chExt cx="1086651" cy="576739"/>
          </a:xfrm>
        </p:grpSpPr>
        <p:sp>
          <p:nvSpPr>
            <p:cNvPr id="288" name="TextBox 287">
              <a:extLst>
                <a:ext uri="{FF2B5EF4-FFF2-40B4-BE49-F238E27FC236}">
                  <a16:creationId xmlns:a16="http://schemas.microsoft.com/office/drawing/2014/main" id="{EBB63DC2-CB5F-45C3-8C24-2AEF4FD8D5BB}"/>
                </a:ext>
              </a:extLst>
            </p:cNvPr>
            <p:cNvSpPr txBox="1"/>
            <p:nvPr/>
          </p:nvSpPr>
          <p:spPr>
            <a:xfrm>
              <a:off x="5252299" y="1568463"/>
              <a:ext cx="453345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89" name="Straight Connector 288">
              <a:extLst>
                <a:ext uri="{FF2B5EF4-FFF2-40B4-BE49-F238E27FC236}">
                  <a16:creationId xmlns:a16="http://schemas.microsoft.com/office/drawing/2014/main" id="{642093A9-8E56-4D56-9CB7-72051E7BB73D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5288392" y="1816035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0" name="TextBox 289">
              <a:extLst>
                <a:ext uri="{FF2B5EF4-FFF2-40B4-BE49-F238E27FC236}">
                  <a16:creationId xmlns:a16="http://schemas.microsoft.com/office/drawing/2014/main" id="{9F8BB77D-6C51-404C-AEB0-8B3D7414720B}"/>
                </a:ext>
              </a:extLst>
            </p:cNvPr>
            <p:cNvSpPr txBox="1"/>
            <p:nvPr/>
          </p:nvSpPr>
          <p:spPr>
            <a:xfrm>
              <a:off x="4695532" y="1571425"/>
              <a:ext cx="612668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21 % O</a:t>
              </a:r>
              <a:r>
                <a:rPr lang="en-GB" sz="900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GB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1" name="TextBox 290">
              <a:extLst>
                <a:ext uri="{FF2B5EF4-FFF2-40B4-BE49-F238E27FC236}">
                  <a16:creationId xmlns:a16="http://schemas.microsoft.com/office/drawing/2014/main" id="{89A4A6D7-C107-4B39-8901-04525E5B975A}"/>
                </a:ext>
              </a:extLst>
            </p:cNvPr>
            <p:cNvSpPr txBox="1"/>
            <p:nvPr/>
          </p:nvSpPr>
          <p:spPr>
            <a:xfrm>
              <a:off x="5251747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2" name="TextBox 291">
              <a:extLst>
                <a:ext uri="{FF2B5EF4-FFF2-40B4-BE49-F238E27FC236}">
                  <a16:creationId xmlns:a16="http://schemas.microsoft.com/office/drawing/2014/main" id="{7B797622-1B50-45D2-8D95-66E2688D6F70}"/>
                </a:ext>
              </a:extLst>
            </p:cNvPr>
            <p:cNvSpPr txBox="1"/>
            <p:nvPr/>
          </p:nvSpPr>
          <p:spPr>
            <a:xfrm>
              <a:off x="5410921" y="1814595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3" name="TextBox 292">
              <a:extLst>
                <a:ext uri="{FF2B5EF4-FFF2-40B4-BE49-F238E27FC236}">
                  <a16:creationId xmlns:a16="http://schemas.microsoft.com/office/drawing/2014/main" id="{5F6DC971-6476-4B1C-81B3-671595B45B50}"/>
                </a:ext>
              </a:extLst>
            </p:cNvPr>
            <p:cNvSpPr txBox="1"/>
            <p:nvPr/>
          </p:nvSpPr>
          <p:spPr>
            <a:xfrm>
              <a:off x="5591774" y="1814595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4" name="TextBox 293">
              <a:extLst>
                <a:ext uri="{FF2B5EF4-FFF2-40B4-BE49-F238E27FC236}">
                  <a16:creationId xmlns:a16="http://schemas.microsoft.com/office/drawing/2014/main" id="{4B842AA6-C138-42C4-A09E-08F8D0CD2809}"/>
                </a:ext>
              </a:extLst>
            </p:cNvPr>
            <p:cNvSpPr txBox="1"/>
            <p:nvPr/>
          </p:nvSpPr>
          <p:spPr>
            <a:xfrm>
              <a:off x="4752546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5" name="TextBox 294">
              <a:extLst>
                <a:ext uri="{FF2B5EF4-FFF2-40B4-BE49-F238E27FC236}">
                  <a16:creationId xmlns:a16="http://schemas.microsoft.com/office/drawing/2014/main" id="{5D6A316E-4AA0-47C1-8D40-DDF04863E798}"/>
                </a:ext>
              </a:extLst>
            </p:cNvPr>
            <p:cNvSpPr txBox="1"/>
            <p:nvPr/>
          </p:nvSpPr>
          <p:spPr>
            <a:xfrm>
              <a:off x="4911720" y="1817557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296" name="TextBox 295">
              <a:extLst>
                <a:ext uri="{FF2B5EF4-FFF2-40B4-BE49-F238E27FC236}">
                  <a16:creationId xmlns:a16="http://schemas.microsoft.com/office/drawing/2014/main" id="{C6787B59-3ECF-40D3-933C-3E203478AD0A}"/>
                </a:ext>
              </a:extLst>
            </p:cNvPr>
            <p:cNvSpPr txBox="1"/>
            <p:nvPr/>
          </p:nvSpPr>
          <p:spPr>
            <a:xfrm>
              <a:off x="5092573" y="1817557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7" name="TextBox 296">
              <a:extLst>
                <a:ext uri="{FF2B5EF4-FFF2-40B4-BE49-F238E27FC236}">
                  <a16:creationId xmlns:a16="http://schemas.microsoft.com/office/drawing/2014/main" id="{E3E97C58-4544-4B87-B282-48F8DA4CD8AE}"/>
                </a:ext>
              </a:extLst>
            </p:cNvPr>
            <p:cNvSpPr txBox="1"/>
            <p:nvPr/>
          </p:nvSpPr>
          <p:spPr>
            <a:xfrm>
              <a:off x="526583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8" name="TextBox 297">
              <a:extLst>
                <a:ext uri="{FF2B5EF4-FFF2-40B4-BE49-F238E27FC236}">
                  <a16:creationId xmlns:a16="http://schemas.microsoft.com/office/drawing/2014/main" id="{D42754EE-7043-4C7F-AA32-0812784CA313}"/>
                </a:ext>
              </a:extLst>
            </p:cNvPr>
            <p:cNvSpPr txBox="1"/>
            <p:nvPr/>
          </p:nvSpPr>
          <p:spPr>
            <a:xfrm>
              <a:off x="5429349" y="1951470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299" name="TextBox 298">
              <a:extLst>
                <a:ext uri="{FF2B5EF4-FFF2-40B4-BE49-F238E27FC236}">
                  <a16:creationId xmlns:a16="http://schemas.microsoft.com/office/drawing/2014/main" id="{611B5E1C-DABF-4E43-88B8-B111EE24120E}"/>
                </a:ext>
              </a:extLst>
            </p:cNvPr>
            <p:cNvSpPr txBox="1"/>
            <p:nvPr/>
          </p:nvSpPr>
          <p:spPr>
            <a:xfrm>
              <a:off x="5592857" y="1951470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300" name="TextBox 299">
              <a:extLst>
                <a:ext uri="{FF2B5EF4-FFF2-40B4-BE49-F238E27FC236}">
                  <a16:creationId xmlns:a16="http://schemas.microsoft.com/office/drawing/2014/main" id="{63D6B4D5-F072-4518-BAE0-0A62DE11F9B1}"/>
                </a:ext>
              </a:extLst>
            </p:cNvPr>
            <p:cNvSpPr txBox="1"/>
            <p:nvPr/>
          </p:nvSpPr>
          <p:spPr>
            <a:xfrm>
              <a:off x="475363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1" name="TextBox 300">
              <a:extLst>
                <a:ext uri="{FF2B5EF4-FFF2-40B4-BE49-F238E27FC236}">
                  <a16:creationId xmlns:a16="http://schemas.microsoft.com/office/drawing/2014/main" id="{8DC89D61-AE87-4309-9A76-F4C0CC4FD32F}"/>
                </a:ext>
              </a:extLst>
            </p:cNvPr>
            <p:cNvSpPr txBox="1"/>
            <p:nvPr/>
          </p:nvSpPr>
          <p:spPr>
            <a:xfrm>
              <a:off x="4917140" y="1954432"/>
              <a:ext cx="167647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302" name="TextBox 301">
              <a:extLst>
                <a:ext uri="{FF2B5EF4-FFF2-40B4-BE49-F238E27FC236}">
                  <a16:creationId xmlns:a16="http://schemas.microsoft.com/office/drawing/2014/main" id="{164D441B-EB77-4747-A604-C325422C3E70}"/>
                </a:ext>
              </a:extLst>
            </p:cNvPr>
            <p:cNvSpPr txBox="1"/>
            <p:nvPr/>
          </p:nvSpPr>
          <p:spPr>
            <a:xfrm>
              <a:off x="5080650" y="1954432"/>
              <a:ext cx="189326" cy="19077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900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cxnSp>
          <p:nvCxnSpPr>
            <p:cNvPr id="303" name="Straight Connector 302">
              <a:extLst>
                <a:ext uri="{FF2B5EF4-FFF2-40B4-BE49-F238E27FC236}">
                  <a16:creationId xmlns:a16="http://schemas.microsoft.com/office/drawing/2014/main" id="{54637F08-DF7C-45DF-857C-04358120FFB2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4756505" y="1818997"/>
              <a:ext cx="486156" cy="149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1660107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464</TotalTime>
  <Words>264</Words>
  <Application>Microsoft Office PowerPoint</Application>
  <PresentationFormat>Widescreen</PresentationFormat>
  <Paragraphs>192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9</cp:revision>
  <dcterms:created xsi:type="dcterms:W3CDTF">2024-03-26T10:59:33Z</dcterms:created>
  <dcterms:modified xsi:type="dcterms:W3CDTF">2024-05-13T09:08:26Z</dcterms:modified>
</cp:coreProperties>
</file>